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4" y="6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AU"/>
              <a:t>T_AgNP_Water</a:t>
            </a:r>
          </a:p>
        </c:rich>
      </c:tx>
      <c:layout>
        <c:manualLayout>
          <c:xMode val="edge"/>
          <c:yMode val="edge"/>
          <c:x val="0.35331577083363658"/>
          <c:y val="6.970237473631446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516099123973141"/>
          <c:y val="5.1400554097404488E-2"/>
          <c:w val="0.78808576200702185"/>
          <c:h val="0.743212598425196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K$2</c:f>
              <c:strCache>
                <c:ptCount val="1"/>
                <c:pt idx="0">
                  <c:v>&lt; 5 min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1!$J$3:$J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K$3:$K$303</c:f>
              <c:numCache>
                <c:formatCode>General</c:formatCode>
                <c:ptCount val="301"/>
                <c:pt idx="0">
                  <c:v>1.0835999999999999</c:v>
                </c:pt>
                <c:pt idx="1">
                  <c:v>0.79179999999999995</c:v>
                </c:pt>
                <c:pt idx="2">
                  <c:v>0.6452</c:v>
                </c:pt>
                <c:pt idx="3">
                  <c:v>0.57709999999999995</c:v>
                </c:pt>
                <c:pt idx="4">
                  <c:v>0.54379999999999995</c:v>
                </c:pt>
                <c:pt idx="5">
                  <c:v>0.52829999999999999</c:v>
                </c:pt>
                <c:pt idx="6">
                  <c:v>0.52439999999999998</c:v>
                </c:pt>
                <c:pt idx="7">
                  <c:v>0.52669999999999995</c:v>
                </c:pt>
                <c:pt idx="8">
                  <c:v>0.53410000000000002</c:v>
                </c:pt>
                <c:pt idx="9">
                  <c:v>0.54859999999999998</c:v>
                </c:pt>
                <c:pt idx="10">
                  <c:v>0.56710000000000005</c:v>
                </c:pt>
                <c:pt idx="11">
                  <c:v>0.57999999999999996</c:v>
                </c:pt>
                <c:pt idx="12">
                  <c:v>0.57820000000000005</c:v>
                </c:pt>
                <c:pt idx="13">
                  <c:v>0.55700000000000005</c:v>
                </c:pt>
                <c:pt idx="14">
                  <c:v>0.51639999999999997</c:v>
                </c:pt>
                <c:pt idx="15">
                  <c:v>0.45939999999999998</c:v>
                </c:pt>
                <c:pt idx="16">
                  <c:v>0.39739999999999998</c:v>
                </c:pt>
                <c:pt idx="17">
                  <c:v>0.3458</c:v>
                </c:pt>
                <c:pt idx="18">
                  <c:v>0.31140000000000001</c:v>
                </c:pt>
                <c:pt idx="19">
                  <c:v>0.2918</c:v>
                </c:pt>
                <c:pt idx="20">
                  <c:v>0.28120000000000001</c:v>
                </c:pt>
                <c:pt idx="21">
                  <c:v>0.27500000000000002</c:v>
                </c:pt>
                <c:pt idx="22">
                  <c:v>0.27060000000000001</c:v>
                </c:pt>
                <c:pt idx="23">
                  <c:v>0.26600000000000001</c:v>
                </c:pt>
                <c:pt idx="24">
                  <c:v>0.2616</c:v>
                </c:pt>
                <c:pt idx="25">
                  <c:v>0.25690000000000002</c:v>
                </c:pt>
                <c:pt idx="26">
                  <c:v>0.25219999999999998</c:v>
                </c:pt>
                <c:pt idx="27">
                  <c:v>0.24790000000000001</c:v>
                </c:pt>
                <c:pt idx="28">
                  <c:v>0.24460000000000001</c:v>
                </c:pt>
                <c:pt idx="29">
                  <c:v>0.24249999999999999</c:v>
                </c:pt>
                <c:pt idx="30">
                  <c:v>0.2417</c:v>
                </c:pt>
                <c:pt idx="31">
                  <c:v>0.2417</c:v>
                </c:pt>
                <c:pt idx="32">
                  <c:v>0.24260000000000001</c:v>
                </c:pt>
                <c:pt idx="33">
                  <c:v>0.2437</c:v>
                </c:pt>
                <c:pt idx="34">
                  <c:v>0.2447</c:v>
                </c:pt>
                <c:pt idx="35">
                  <c:v>0.245</c:v>
                </c:pt>
                <c:pt idx="36">
                  <c:v>0.24510000000000001</c:v>
                </c:pt>
                <c:pt idx="37">
                  <c:v>0.24379999999999999</c:v>
                </c:pt>
                <c:pt idx="38">
                  <c:v>0.2387</c:v>
                </c:pt>
                <c:pt idx="39">
                  <c:v>0.2303</c:v>
                </c:pt>
                <c:pt idx="40">
                  <c:v>0.22289999999999999</c:v>
                </c:pt>
                <c:pt idx="41">
                  <c:v>0.215</c:v>
                </c:pt>
                <c:pt idx="42">
                  <c:v>0.20030000000000001</c:v>
                </c:pt>
                <c:pt idx="43">
                  <c:v>0.1825</c:v>
                </c:pt>
                <c:pt idx="44">
                  <c:v>0.16739999999999999</c:v>
                </c:pt>
                <c:pt idx="45">
                  <c:v>0.15679999999999999</c:v>
                </c:pt>
                <c:pt idx="46">
                  <c:v>0.1484</c:v>
                </c:pt>
                <c:pt idx="47">
                  <c:v>0.14119999999999999</c:v>
                </c:pt>
                <c:pt idx="48">
                  <c:v>0.13400000000000001</c:v>
                </c:pt>
                <c:pt idx="49">
                  <c:v>0.12690000000000001</c:v>
                </c:pt>
                <c:pt idx="50">
                  <c:v>0.1193</c:v>
                </c:pt>
                <c:pt idx="51">
                  <c:v>0.1115</c:v>
                </c:pt>
                <c:pt idx="52">
                  <c:v>0.104</c:v>
                </c:pt>
                <c:pt idx="53">
                  <c:v>9.69E-2</c:v>
                </c:pt>
                <c:pt idx="54">
                  <c:v>9.0399999999999994E-2</c:v>
                </c:pt>
                <c:pt idx="55">
                  <c:v>8.4599999999999995E-2</c:v>
                </c:pt>
                <c:pt idx="56">
                  <c:v>7.9899999999999999E-2</c:v>
                </c:pt>
                <c:pt idx="57">
                  <c:v>7.6100000000000001E-2</c:v>
                </c:pt>
                <c:pt idx="58">
                  <c:v>7.3200000000000001E-2</c:v>
                </c:pt>
                <c:pt idx="59">
                  <c:v>7.0999999999999994E-2</c:v>
                </c:pt>
                <c:pt idx="60">
                  <c:v>6.9599999999999995E-2</c:v>
                </c:pt>
                <c:pt idx="61">
                  <c:v>6.9199999999999998E-2</c:v>
                </c:pt>
                <c:pt idx="62">
                  <c:v>6.93E-2</c:v>
                </c:pt>
                <c:pt idx="63">
                  <c:v>7.0199999999999999E-2</c:v>
                </c:pt>
                <c:pt idx="64">
                  <c:v>7.1400000000000005E-2</c:v>
                </c:pt>
                <c:pt idx="65">
                  <c:v>7.3599999999999999E-2</c:v>
                </c:pt>
                <c:pt idx="66">
                  <c:v>7.7600000000000002E-2</c:v>
                </c:pt>
                <c:pt idx="67">
                  <c:v>8.1699999999999995E-2</c:v>
                </c:pt>
                <c:pt idx="68">
                  <c:v>8.7499999999999994E-2</c:v>
                </c:pt>
                <c:pt idx="69">
                  <c:v>9.4600000000000004E-2</c:v>
                </c:pt>
                <c:pt idx="70">
                  <c:v>0.10299999999999999</c:v>
                </c:pt>
                <c:pt idx="71">
                  <c:v>0.1129</c:v>
                </c:pt>
                <c:pt idx="72">
                  <c:v>0.1245</c:v>
                </c:pt>
                <c:pt idx="73">
                  <c:v>0.13730000000000001</c:v>
                </c:pt>
                <c:pt idx="74">
                  <c:v>0.1517</c:v>
                </c:pt>
                <c:pt idx="75">
                  <c:v>0.16719999999999999</c:v>
                </c:pt>
                <c:pt idx="76">
                  <c:v>0.18329999999999999</c:v>
                </c:pt>
                <c:pt idx="77">
                  <c:v>0.2</c:v>
                </c:pt>
                <c:pt idx="78">
                  <c:v>0.217</c:v>
                </c:pt>
                <c:pt idx="79">
                  <c:v>0.23499999999999999</c:v>
                </c:pt>
                <c:pt idx="80">
                  <c:v>0.25309999999999999</c:v>
                </c:pt>
                <c:pt idx="81">
                  <c:v>0.27250000000000002</c:v>
                </c:pt>
                <c:pt idx="82">
                  <c:v>0.29249999999999998</c:v>
                </c:pt>
                <c:pt idx="83">
                  <c:v>0.31309999999999999</c:v>
                </c:pt>
                <c:pt idx="84">
                  <c:v>0.33510000000000001</c:v>
                </c:pt>
                <c:pt idx="85">
                  <c:v>0.35780000000000001</c:v>
                </c:pt>
                <c:pt idx="86">
                  <c:v>0.38150000000000001</c:v>
                </c:pt>
                <c:pt idx="87">
                  <c:v>0.40589999999999998</c:v>
                </c:pt>
                <c:pt idx="88">
                  <c:v>0.43130000000000002</c:v>
                </c:pt>
                <c:pt idx="89">
                  <c:v>0.4577</c:v>
                </c:pt>
                <c:pt idx="90">
                  <c:v>0.48480000000000001</c:v>
                </c:pt>
                <c:pt idx="91">
                  <c:v>0.51270000000000004</c:v>
                </c:pt>
                <c:pt idx="92">
                  <c:v>0.54010000000000002</c:v>
                </c:pt>
                <c:pt idx="93">
                  <c:v>0.56950000000000001</c:v>
                </c:pt>
                <c:pt idx="94">
                  <c:v>0.59899999999999998</c:v>
                </c:pt>
                <c:pt idx="95">
                  <c:v>0.62780000000000002</c:v>
                </c:pt>
                <c:pt idx="96">
                  <c:v>0.65569999999999995</c:v>
                </c:pt>
                <c:pt idx="97">
                  <c:v>0.68230000000000002</c:v>
                </c:pt>
                <c:pt idx="98">
                  <c:v>0.70589999999999997</c:v>
                </c:pt>
                <c:pt idx="99">
                  <c:v>0.72689999999999999</c:v>
                </c:pt>
                <c:pt idx="100">
                  <c:v>0.74419999999999997</c:v>
                </c:pt>
                <c:pt idx="101">
                  <c:v>0.75739999999999996</c:v>
                </c:pt>
                <c:pt idx="102">
                  <c:v>0.76639999999999997</c:v>
                </c:pt>
                <c:pt idx="103">
                  <c:v>0.77049999999999996</c:v>
                </c:pt>
                <c:pt idx="104">
                  <c:v>0.76919999999999999</c:v>
                </c:pt>
                <c:pt idx="105">
                  <c:v>0.76359999999999995</c:v>
                </c:pt>
                <c:pt idx="106">
                  <c:v>0.75260000000000005</c:v>
                </c:pt>
                <c:pt idx="107">
                  <c:v>0.73670000000000002</c:v>
                </c:pt>
                <c:pt idx="108">
                  <c:v>0.71579999999999999</c:v>
                </c:pt>
                <c:pt idx="109">
                  <c:v>0.69010000000000005</c:v>
                </c:pt>
                <c:pt idx="110">
                  <c:v>0.65990000000000004</c:v>
                </c:pt>
                <c:pt idx="111">
                  <c:v>0.62590000000000001</c:v>
                </c:pt>
                <c:pt idx="112">
                  <c:v>0.58919999999999995</c:v>
                </c:pt>
                <c:pt idx="113">
                  <c:v>0.55059999999999998</c:v>
                </c:pt>
                <c:pt idx="114">
                  <c:v>0.51090000000000002</c:v>
                </c:pt>
                <c:pt idx="115">
                  <c:v>0.47110000000000002</c:v>
                </c:pt>
                <c:pt idx="116">
                  <c:v>0.43190000000000001</c:v>
                </c:pt>
                <c:pt idx="117">
                  <c:v>0.39410000000000001</c:v>
                </c:pt>
                <c:pt idx="118">
                  <c:v>0.3589</c:v>
                </c:pt>
                <c:pt idx="119">
                  <c:v>0.32600000000000001</c:v>
                </c:pt>
                <c:pt idx="120">
                  <c:v>0.29559999999999997</c:v>
                </c:pt>
                <c:pt idx="121">
                  <c:v>0.26779999999999998</c:v>
                </c:pt>
                <c:pt idx="122">
                  <c:v>0.24260000000000001</c:v>
                </c:pt>
                <c:pt idx="123">
                  <c:v>0.21990000000000001</c:v>
                </c:pt>
                <c:pt idx="124">
                  <c:v>0.19950000000000001</c:v>
                </c:pt>
                <c:pt idx="125">
                  <c:v>0.18140000000000001</c:v>
                </c:pt>
                <c:pt idx="126">
                  <c:v>0.16550000000000001</c:v>
                </c:pt>
                <c:pt idx="127">
                  <c:v>0.1515</c:v>
                </c:pt>
                <c:pt idx="128">
                  <c:v>0.13900000000000001</c:v>
                </c:pt>
                <c:pt idx="129">
                  <c:v>0.1278</c:v>
                </c:pt>
                <c:pt idx="130">
                  <c:v>0.1179</c:v>
                </c:pt>
                <c:pt idx="131">
                  <c:v>0.109</c:v>
                </c:pt>
                <c:pt idx="132">
                  <c:v>0.10100000000000001</c:v>
                </c:pt>
                <c:pt idx="133">
                  <c:v>9.3799999999999994E-2</c:v>
                </c:pt>
                <c:pt idx="134">
                  <c:v>8.7599999999999997E-2</c:v>
                </c:pt>
                <c:pt idx="135">
                  <c:v>8.1900000000000001E-2</c:v>
                </c:pt>
                <c:pt idx="136">
                  <c:v>7.6700000000000004E-2</c:v>
                </c:pt>
                <c:pt idx="137">
                  <c:v>7.2099999999999997E-2</c:v>
                </c:pt>
                <c:pt idx="138">
                  <c:v>6.8000000000000005E-2</c:v>
                </c:pt>
                <c:pt idx="139">
                  <c:v>6.4199999999999993E-2</c:v>
                </c:pt>
                <c:pt idx="140">
                  <c:v>6.08E-2</c:v>
                </c:pt>
                <c:pt idx="141">
                  <c:v>5.7599999999999998E-2</c:v>
                </c:pt>
                <c:pt idx="142">
                  <c:v>5.4600000000000003E-2</c:v>
                </c:pt>
                <c:pt idx="143">
                  <c:v>5.1999999999999998E-2</c:v>
                </c:pt>
                <c:pt idx="144">
                  <c:v>4.9500000000000002E-2</c:v>
                </c:pt>
                <c:pt idx="145">
                  <c:v>4.7199999999999999E-2</c:v>
                </c:pt>
                <c:pt idx="146">
                  <c:v>4.5199999999999997E-2</c:v>
                </c:pt>
                <c:pt idx="147">
                  <c:v>4.3200000000000002E-2</c:v>
                </c:pt>
                <c:pt idx="148">
                  <c:v>4.1399999999999999E-2</c:v>
                </c:pt>
                <c:pt idx="149">
                  <c:v>3.9899999999999998E-2</c:v>
                </c:pt>
                <c:pt idx="150">
                  <c:v>3.8199999999999998E-2</c:v>
                </c:pt>
                <c:pt idx="151">
                  <c:v>3.6799999999999999E-2</c:v>
                </c:pt>
                <c:pt idx="152">
                  <c:v>3.5400000000000001E-2</c:v>
                </c:pt>
                <c:pt idx="153">
                  <c:v>3.4099999999999998E-2</c:v>
                </c:pt>
                <c:pt idx="154">
                  <c:v>3.3000000000000002E-2</c:v>
                </c:pt>
                <c:pt idx="155">
                  <c:v>3.1699999999999999E-2</c:v>
                </c:pt>
                <c:pt idx="156">
                  <c:v>3.0700000000000002E-2</c:v>
                </c:pt>
                <c:pt idx="157">
                  <c:v>2.9700000000000001E-2</c:v>
                </c:pt>
                <c:pt idx="158">
                  <c:v>2.8799999999999999E-2</c:v>
                </c:pt>
                <c:pt idx="159">
                  <c:v>2.7699999999999999E-2</c:v>
                </c:pt>
                <c:pt idx="160">
                  <c:v>2.69E-2</c:v>
                </c:pt>
                <c:pt idx="161">
                  <c:v>2.6100000000000002E-2</c:v>
                </c:pt>
                <c:pt idx="162">
                  <c:v>2.5399999999999999E-2</c:v>
                </c:pt>
                <c:pt idx="163">
                  <c:v>2.4500000000000001E-2</c:v>
                </c:pt>
                <c:pt idx="164">
                  <c:v>2.3900000000000001E-2</c:v>
                </c:pt>
                <c:pt idx="165">
                  <c:v>2.3300000000000001E-2</c:v>
                </c:pt>
                <c:pt idx="166">
                  <c:v>2.2499999999999999E-2</c:v>
                </c:pt>
                <c:pt idx="167">
                  <c:v>2.1999999999999999E-2</c:v>
                </c:pt>
                <c:pt idx="168">
                  <c:v>2.1299999999999999E-2</c:v>
                </c:pt>
                <c:pt idx="169">
                  <c:v>2.0799999999999999E-2</c:v>
                </c:pt>
                <c:pt idx="170">
                  <c:v>2.0199999999999999E-2</c:v>
                </c:pt>
                <c:pt idx="171">
                  <c:v>1.9699999999999999E-2</c:v>
                </c:pt>
                <c:pt idx="172">
                  <c:v>1.9300000000000001E-2</c:v>
                </c:pt>
                <c:pt idx="173">
                  <c:v>1.8700000000000001E-2</c:v>
                </c:pt>
                <c:pt idx="174">
                  <c:v>1.8200000000000001E-2</c:v>
                </c:pt>
                <c:pt idx="175">
                  <c:v>1.78E-2</c:v>
                </c:pt>
                <c:pt idx="176">
                  <c:v>1.7299999999999999E-2</c:v>
                </c:pt>
                <c:pt idx="177">
                  <c:v>1.7000000000000001E-2</c:v>
                </c:pt>
                <c:pt idx="178">
                  <c:v>1.66E-2</c:v>
                </c:pt>
                <c:pt idx="179">
                  <c:v>1.6199999999999999E-2</c:v>
                </c:pt>
                <c:pt idx="180">
                  <c:v>1.5800000000000002E-2</c:v>
                </c:pt>
                <c:pt idx="181">
                  <c:v>1.5299999999999999E-2</c:v>
                </c:pt>
                <c:pt idx="182">
                  <c:v>1.4999999999999999E-2</c:v>
                </c:pt>
                <c:pt idx="183">
                  <c:v>1.47E-2</c:v>
                </c:pt>
                <c:pt idx="184">
                  <c:v>1.44E-2</c:v>
                </c:pt>
                <c:pt idx="185">
                  <c:v>1.41E-2</c:v>
                </c:pt>
                <c:pt idx="186">
                  <c:v>1.3599999999999999E-2</c:v>
                </c:pt>
                <c:pt idx="187">
                  <c:v>1.35E-2</c:v>
                </c:pt>
                <c:pt idx="188">
                  <c:v>1.3100000000000001E-2</c:v>
                </c:pt>
                <c:pt idx="189">
                  <c:v>1.2800000000000001E-2</c:v>
                </c:pt>
                <c:pt idx="190">
                  <c:v>1.2500000000000001E-2</c:v>
                </c:pt>
                <c:pt idx="191">
                  <c:v>1.23E-2</c:v>
                </c:pt>
                <c:pt idx="192">
                  <c:v>1.21E-2</c:v>
                </c:pt>
                <c:pt idx="193">
                  <c:v>1.18E-2</c:v>
                </c:pt>
                <c:pt idx="194">
                  <c:v>1.1599999999999999E-2</c:v>
                </c:pt>
                <c:pt idx="195">
                  <c:v>1.1299999999999999E-2</c:v>
                </c:pt>
                <c:pt idx="196">
                  <c:v>1.11E-2</c:v>
                </c:pt>
                <c:pt idx="197">
                  <c:v>1.09E-2</c:v>
                </c:pt>
                <c:pt idx="198">
                  <c:v>1.06E-2</c:v>
                </c:pt>
                <c:pt idx="199">
                  <c:v>1.0500000000000001E-2</c:v>
                </c:pt>
                <c:pt idx="200">
                  <c:v>1.0200000000000001E-2</c:v>
                </c:pt>
                <c:pt idx="201">
                  <c:v>0.01</c:v>
                </c:pt>
                <c:pt idx="202">
                  <c:v>9.7999999999999997E-3</c:v>
                </c:pt>
                <c:pt idx="203">
                  <c:v>9.5999999999999992E-3</c:v>
                </c:pt>
                <c:pt idx="204">
                  <c:v>9.4999999999999998E-3</c:v>
                </c:pt>
                <c:pt idx="205">
                  <c:v>9.2999999999999992E-3</c:v>
                </c:pt>
                <c:pt idx="206">
                  <c:v>9.1000000000000004E-3</c:v>
                </c:pt>
                <c:pt idx="207">
                  <c:v>8.8999999999999999E-3</c:v>
                </c:pt>
                <c:pt idx="208">
                  <c:v>8.8000000000000005E-3</c:v>
                </c:pt>
                <c:pt idx="209">
                  <c:v>8.6999999999999994E-3</c:v>
                </c:pt>
                <c:pt idx="210">
                  <c:v>8.5000000000000006E-3</c:v>
                </c:pt>
                <c:pt idx="211">
                  <c:v>8.3000000000000001E-3</c:v>
                </c:pt>
                <c:pt idx="212">
                  <c:v>8.2000000000000007E-3</c:v>
                </c:pt>
                <c:pt idx="213">
                  <c:v>8.0000000000000002E-3</c:v>
                </c:pt>
                <c:pt idx="214">
                  <c:v>7.9000000000000008E-3</c:v>
                </c:pt>
                <c:pt idx="215">
                  <c:v>7.7999999999999996E-3</c:v>
                </c:pt>
                <c:pt idx="216">
                  <c:v>7.6E-3</c:v>
                </c:pt>
                <c:pt idx="217">
                  <c:v>7.4000000000000003E-3</c:v>
                </c:pt>
                <c:pt idx="218">
                  <c:v>7.3000000000000001E-3</c:v>
                </c:pt>
                <c:pt idx="219">
                  <c:v>7.1999999999999998E-3</c:v>
                </c:pt>
                <c:pt idx="220">
                  <c:v>7.1000000000000004E-3</c:v>
                </c:pt>
                <c:pt idx="221">
                  <c:v>7.0000000000000001E-3</c:v>
                </c:pt>
                <c:pt idx="222">
                  <c:v>6.8999999999999999E-3</c:v>
                </c:pt>
                <c:pt idx="223">
                  <c:v>6.7999999999999996E-3</c:v>
                </c:pt>
                <c:pt idx="224">
                  <c:v>6.7000000000000002E-3</c:v>
                </c:pt>
                <c:pt idx="225">
                  <c:v>6.4999999999999997E-3</c:v>
                </c:pt>
                <c:pt idx="226">
                  <c:v>6.4000000000000003E-3</c:v>
                </c:pt>
                <c:pt idx="227">
                  <c:v>6.3E-3</c:v>
                </c:pt>
                <c:pt idx="228">
                  <c:v>6.1999999999999998E-3</c:v>
                </c:pt>
                <c:pt idx="229">
                  <c:v>6.0000000000000001E-3</c:v>
                </c:pt>
                <c:pt idx="230">
                  <c:v>6.0000000000000001E-3</c:v>
                </c:pt>
                <c:pt idx="231">
                  <c:v>5.8999999999999999E-3</c:v>
                </c:pt>
                <c:pt idx="232">
                  <c:v>5.7999999999999996E-3</c:v>
                </c:pt>
                <c:pt idx="233">
                  <c:v>5.7999999999999996E-3</c:v>
                </c:pt>
                <c:pt idx="234">
                  <c:v>5.5999999999999999E-3</c:v>
                </c:pt>
                <c:pt idx="235">
                  <c:v>5.4999999999999997E-3</c:v>
                </c:pt>
                <c:pt idx="236">
                  <c:v>5.4000000000000003E-3</c:v>
                </c:pt>
                <c:pt idx="237">
                  <c:v>5.3E-3</c:v>
                </c:pt>
                <c:pt idx="238">
                  <c:v>5.4000000000000003E-3</c:v>
                </c:pt>
                <c:pt idx="239">
                  <c:v>5.1999999999999998E-3</c:v>
                </c:pt>
                <c:pt idx="240">
                  <c:v>5.1000000000000004E-3</c:v>
                </c:pt>
                <c:pt idx="241">
                  <c:v>5.1000000000000004E-3</c:v>
                </c:pt>
                <c:pt idx="242">
                  <c:v>4.8999999999999998E-3</c:v>
                </c:pt>
                <c:pt idx="243">
                  <c:v>4.8999999999999998E-3</c:v>
                </c:pt>
                <c:pt idx="244">
                  <c:v>4.8999999999999998E-3</c:v>
                </c:pt>
                <c:pt idx="245">
                  <c:v>4.7999999999999996E-3</c:v>
                </c:pt>
                <c:pt idx="246">
                  <c:v>4.7000000000000002E-3</c:v>
                </c:pt>
                <c:pt idx="247">
                  <c:v>4.5999999999999999E-3</c:v>
                </c:pt>
                <c:pt idx="248">
                  <c:v>4.7000000000000002E-3</c:v>
                </c:pt>
                <c:pt idx="249">
                  <c:v>4.5999999999999999E-3</c:v>
                </c:pt>
                <c:pt idx="250">
                  <c:v>4.4999999999999997E-3</c:v>
                </c:pt>
                <c:pt idx="251">
                  <c:v>4.4000000000000003E-3</c:v>
                </c:pt>
                <c:pt idx="252">
                  <c:v>4.4000000000000003E-3</c:v>
                </c:pt>
                <c:pt idx="253">
                  <c:v>4.3E-3</c:v>
                </c:pt>
                <c:pt idx="254">
                  <c:v>4.3E-3</c:v>
                </c:pt>
                <c:pt idx="255">
                  <c:v>4.1999999999999997E-3</c:v>
                </c:pt>
                <c:pt idx="256">
                  <c:v>4.1000000000000003E-3</c:v>
                </c:pt>
                <c:pt idx="257">
                  <c:v>4.1000000000000003E-3</c:v>
                </c:pt>
                <c:pt idx="258">
                  <c:v>4.0000000000000001E-3</c:v>
                </c:pt>
                <c:pt idx="259">
                  <c:v>4.0000000000000001E-3</c:v>
                </c:pt>
                <c:pt idx="260">
                  <c:v>4.0000000000000001E-3</c:v>
                </c:pt>
                <c:pt idx="261">
                  <c:v>3.8E-3</c:v>
                </c:pt>
                <c:pt idx="262">
                  <c:v>3.8999999999999998E-3</c:v>
                </c:pt>
                <c:pt idx="263">
                  <c:v>3.8E-3</c:v>
                </c:pt>
                <c:pt idx="264">
                  <c:v>3.8E-3</c:v>
                </c:pt>
                <c:pt idx="265">
                  <c:v>3.7000000000000002E-3</c:v>
                </c:pt>
                <c:pt idx="266">
                  <c:v>3.5999999999999999E-3</c:v>
                </c:pt>
                <c:pt idx="267">
                  <c:v>3.5999999999999999E-3</c:v>
                </c:pt>
                <c:pt idx="268">
                  <c:v>3.5999999999999999E-3</c:v>
                </c:pt>
                <c:pt idx="269">
                  <c:v>3.5000000000000001E-3</c:v>
                </c:pt>
                <c:pt idx="270">
                  <c:v>3.3999999999999998E-3</c:v>
                </c:pt>
                <c:pt idx="271">
                  <c:v>3.5000000000000001E-3</c:v>
                </c:pt>
                <c:pt idx="272">
                  <c:v>3.3999999999999998E-3</c:v>
                </c:pt>
                <c:pt idx="273">
                  <c:v>3.3E-3</c:v>
                </c:pt>
                <c:pt idx="274">
                  <c:v>3.3E-3</c:v>
                </c:pt>
                <c:pt idx="275">
                  <c:v>3.2000000000000002E-3</c:v>
                </c:pt>
                <c:pt idx="276">
                  <c:v>3.2000000000000002E-3</c:v>
                </c:pt>
                <c:pt idx="277">
                  <c:v>3.2000000000000002E-3</c:v>
                </c:pt>
                <c:pt idx="278">
                  <c:v>3.0999999999999999E-3</c:v>
                </c:pt>
                <c:pt idx="279">
                  <c:v>3.0000000000000001E-3</c:v>
                </c:pt>
                <c:pt idx="280">
                  <c:v>3.0999999999999999E-3</c:v>
                </c:pt>
                <c:pt idx="281">
                  <c:v>2.8999999999999998E-3</c:v>
                </c:pt>
                <c:pt idx="282">
                  <c:v>3.0000000000000001E-3</c:v>
                </c:pt>
                <c:pt idx="283">
                  <c:v>2.8999999999999998E-3</c:v>
                </c:pt>
                <c:pt idx="284">
                  <c:v>2.8999999999999998E-3</c:v>
                </c:pt>
                <c:pt idx="285">
                  <c:v>3.0999999999999999E-3</c:v>
                </c:pt>
                <c:pt idx="286">
                  <c:v>2.8999999999999998E-3</c:v>
                </c:pt>
                <c:pt idx="287">
                  <c:v>2.8999999999999998E-3</c:v>
                </c:pt>
                <c:pt idx="288">
                  <c:v>2.8999999999999998E-3</c:v>
                </c:pt>
                <c:pt idx="289">
                  <c:v>2.8E-3</c:v>
                </c:pt>
                <c:pt idx="290">
                  <c:v>3.0000000000000001E-3</c:v>
                </c:pt>
                <c:pt idx="291">
                  <c:v>2.8E-3</c:v>
                </c:pt>
                <c:pt idx="292">
                  <c:v>2.8E-3</c:v>
                </c:pt>
                <c:pt idx="293">
                  <c:v>2.8E-3</c:v>
                </c:pt>
                <c:pt idx="294">
                  <c:v>2.5999999999999999E-3</c:v>
                </c:pt>
                <c:pt idx="295">
                  <c:v>2.8E-3</c:v>
                </c:pt>
                <c:pt idx="296">
                  <c:v>2.7000000000000001E-3</c:v>
                </c:pt>
                <c:pt idx="297">
                  <c:v>2.7000000000000001E-3</c:v>
                </c:pt>
                <c:pt idx="298">
                  <c:v>2.5999999999999999E-3</c:v>
                </c:pt>
                <c:pt idx="299">
                  <c:v>2.5000000000000001E-3</c:v>
                </c:pt>
                <c:pt idx="300">
                  <c:v>2.5999999999999999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60A-469C-B401-C15EA219125E}"/>
            </c:ext>
          </c:extLst>
        </c:ser>
        <c:ser>
          <c:idx val="1"/>
          <c:order val="1"/>
          <c:tx>
            <c:strRef>
              <c:f>Sheet1!$L$2</c:f>
              <c:strCache>
                <c:ptCount val="1"/>
                <c:pt idx="0">
                  <c:v>24 h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J$3:$J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L$3:$L$303</c:f>
              <c:numCache>
                <c:formatCode>General</c:formatCode>
                <c:ptCount val="301"/>
                <c:pt idx="0">
                  <c:v>1.107</c:v>
                </c:pt>
                <c:pt idx="1">
                  <c:v>0.78269999999999995</c:v>
                </c:pt>
                <c:pt idx="2">
                  <c:v>0.62619999999999998</c:v>
                </c:pt>
                <c:pt idx="3">
                  <c:v>0.56059999999999999</c:v>
                </c:pt>
                <c:pt idx="4">
                  <c:v>0.53390000000000004</c:v>
                </c:pt>
                <c:pt idx="5">
                  <c:v>0.52500000000000002</c:v>
                </c:pt>
                <c:pt idx="6">
                  <c:v>0.52500000000000002</c:v>
                </c:pt>
                <c:pt idx="7">
                  <c:v>0.52969999999999995</c:v>
                </c:pt>
                <c:pt idx="8">
                  <c:v>0.53869999999999996</c:v>
                </c:pt>
                <c:pt idx="9">
                  <c:v>0.55430000000000001</c:v>
                </c:pt>
                <c:pt idx="10">
                  <c:v>0.57399999999999995</c:v>
                </c:pt>
                <c:pt idx="11">
                  <c:v>0.58819999999999995</c:v>
                </c:pt>
                <c:pt idx="12">
                  <c:v>0.58650000000000002</c:v>
                </c:pt>
                <c:pt idx="13">
                  <c:v>0.56420000000000003</c:v>
                </c:pt>
                <c:pt idx="14">
                  <c:v>0.52100000000000002</c:v>
                </c:pt>
                <c:pt idx="15">
                  <c:v>0.4592</c:v>
                </c:pt>
                <c:pt idx="16">
                  <c:v>0.39169999999999999</c:v>
                </c:pt>
                <c:pt idx="17">
                  <c:v>0.33439999999999998</c:v>
                </c:pt>
                <c:pt idx="18">
                  <c:v>0.2954</c:v>
                </c:pt>
                <c:pt idx="19">
                  <c:v>0.27300000000000002</c:v>
                </c:pt>
                <c:pt idx="20">
                  <c:v>0.26069999999999999</c:v>
                </c:pt>
                <c:pt idx="21">
                  <c:v>0.254</c:v>
                </c:pt>
                <c:pt idx="22">
                  <c:v>0.2495</c:v>
                </c:pt>
                <c:pt idx="23">
                  <c:v>0.246</c:v>
                </c:pt>
                <c:pt idx="24">
                  <c:v>0.24310000000000001</c:v>
                </c:pt>
                <c:pt idx="25">
                  <c:v>0.24049999999999999</c:v>
                </c:pt>
                <c:pt idx="26">
                  <c:v>0.2382</c:v>
                </c:pt>
                <c:pt idx="27">
                  <c:v>0.23619999999999999</c:v>
                </c:pt>
                <c:pt idx="28">
                  <c:v>0.23480000000000001</c:v>
                </c:pt>
                <c:pt idx="29">
                  <c:v>0.2346</c:v>
                </c:pt>
                <c:pt idx="30">
                  <c:v>0.23469999999999999</c:v>
                </c:pt>
                <c:pt idx="31">
                  <c:v>0.23549999999999999</c:v>
                </c:pt>
                <c:pt idx="32">
                  <c:v>0.23649999999999999</c:v>
                </c:pt>
                <c:pt idx="33">
                  <c:v>0.23860000000000001</c:v>
                </c:pt>
                <c:pt idx="34">
                  <c:v>0.2399</c:v>
                </c:pt>
                <c:pt idx="35">
                  <c:v>0.24030000000000001</c:v>
                </c:pt>
                <c:pt idx="36">
                  <c:v>0.24060000000000001</c:v>
                </c:pt>
                <c:pt idx="37">
                  <c:v>0.2394</c:v>
                </c:pt>
                <c:pt idx="38">
                  <c:v>0.2344</c:v>
                </c:pt>
                <c:pt idx="39">
                  <c:v>0.22559999999999999</c:v>
                </c:pt>
                <c:pt idx="40">
                  <c:v>0.21809999999999999</c:v>
                </c:pt>
                <c:pt idx="41">
                  <c:v>0.20960000000000001</c:v>
                </c:pt>
                <c:pt idx="42">
                  <c:v>0.19489999999999999</c:v>
                </c:pt>
                <c:pt idx="43">
                  <c:v>0.1757</c:v>
                </c:pt>
                <c:pt idx="44">
                  <c:v>0.16009999999999999</c:v>
                </c:pt>
                <c:pt idx="45">
                  <c:v>0.14910000000000001</c:v>
                </c:pt>
                <c:pt idx="46">
                  <c:v>0.1409</c:v>
                </c:pt>
                <c:pt idx="47">
                  <c:v>0.1336</c:v>
                </c:pt>
                <c:pt idx="48">
                  <c:v>0.12690000000000001</c:v>
                </c:pt>
                <c:pt idx="49">
                  <c:v>0.1197</c:v>
                </c:pt>
                <c:pt idx="50">
                  <c:v>0.11269999999999999</c:v>
                </c:pt>
                <c:pt idx="51">
                  <c:v>0.1052</c:v>
                </c:pt>
                <c:pt idx="52">
                  <c:v>9.8100000000000007E-2</c:v>
                </c:pt>
                <c:pt idx="53">
                  <c:v>9.1600000000000001E-2</c:v>
                </c:pt>
                <c:pt idx="54">
                  <c:v>8.5400000000000004E-2</c:v>
                </c:pt>
                <c:pt idx="55">
                  <c:v>8.0199999999999994E-2</c:v>
                </c:pt>
                <c:pt idx="56">
                  <c:v>7.5700000000000003E-2</c:v>
                </c:pt>
                <c:pt idx="57">
                  <c:v>7.2099999999999997E-2</c:v>
                </c:pt>
                <c:pt idx="58">
                  <c:v>6.88E-2</c:v>
                </c:pt>
                <c:pt idx="59">
                  <c:v>6.6500000000000004E-2</c:v>
                </c:pt>
                <c:pt idx="60">
                  <c:v>6.5199999999999994E-2</c:v>
                </c:pt>
                <c:pt idx="61">
                  <c:v>6.4699999999999994E-2</c:v>
                </c:pt>
                <c:pt idx="62">
                  <c:v>6.4699999999999994E-2</c:v>
                </c:pt>
                <c:pt idx="63">
                  <c:v>6.5500000000000003E-2</c:v>
                </c:pt>
                <c:pt idx="64">
                  <c:v>6.7100000000000007E-2</c:v>
                </c:pt>
                <c:pt idx="65">
                  <c:v>6.9800000000000001E-2</c:v>
                </c:pt>
                <c:pt idx="66">
                  <c:v>7.3400000000000007E-2</c:v>
                </c:pt>
                <c:pt idx="67">
                  <c:v>7.7700000000000005E-2</c:v>
                </c:pt>
                <c:pt idx="68">
                  <c:v>8.3500000000000005E-2</c:v>
                </c:pt>
                <c:pt idx="69">
                  <c:v>9.0300000000000005E-2</c:v>
                </c:pt>
                <c:pt idx="70">
                  <c:v>9.8599999999999993E-2</c:v>
                </c:pt>
                <c:pt idx="71">
                  <c:v>0.1082</c:v>
                </c:pt>
                <c:pt idx="72">
                  <c:v>0.1196</c:v>
                </c:pt>
                <c:pt idx="73">
                  <c:v>0.13250000000000001</c:v>
                </c:pt>
                <c:pt idx="74">
                  <c:v>0.14660000000000001</c:v>
                </c:pt>
                <c:pt idx="75">
                  <c:v>0.16200000000000001</c:v>
                </c:pt>
                <c:pt idx="76">
                  <c:v>0.17810000000000001</c:v>
                </c:pt>
                <c:pt idx="77">
                  <c:v>0.1951</c:v>
                </c:pt>
                <c:pt idx="78">
                  <c:v>0.21240000000000001</c:v>
                </c:pt>
                <c:pt idx="79">
                  <c:v>0.2303</c:v>
                </c:pt>
                <c:pt idx="80">
                  <c:v>0.24879999999999999</c:v>
                </c:pt>
                <c:pt idx="81">
                  <c:v>0.26819999999999999</c:v>
                </c:pt>
                <c:pt idx="82">
                  <c:v>0.28860000000000002</c:v>
                </c:pt>
                <c:pt idx="83">
                  <c:v>0.30959999999999999</c:v>
                </c:pt>
                <c:pt idx="84">
                  <c:v>0.33119999999999999</c:v>
                </c:pt>
                <c:pt idx="85">
                  <c:v>0.35389999999999999</c:v>
                </c:pt>
                <c:pt idx="86">
                  <c:v>0.37730000000000002</c:v>
                </c:pt>
                <c:pt idx="87">
                  <c:v>0.40160000000000001</c:v>
                </c:pt>
                <c:pt idx="88">
                  <c:v>0.42599999999999999</c:v>
                </c:pt>
                <c:pt idx="89">
                  <c:v>0.45140000000000002</c:v>
                </c:pt>
                <c:pt idx="90">
                  <c:v>0.4773</c:v>
                </c:pt>
                <c:pt idx="91">
                  <c:v>0.50449999999999995</c:v>
                </c:pt>
                <c:pt idx="92">
                  <c:v>0.53200000000000003</c:v>
                </c:pt>
                <c:pt idx="93">
                  <c:v>0.56010000000000004</c:v>
                </c:pt>
                <c:pt idx="94">
                  <c:v>0.58860000000000001</c:v>
                </c:pt>
                <c:pt idx="95">
                  <c:v>0.61670000000000003</c:v>
                </c:pt>
                <c:pt idx="96">
                  <c:v>0.64359999999999995</c:v>
                </c:pt>
                <c:pt idx="97">
                  <c:v>0.66910000000000003</c:v>
                </c:pt>
                <c:pt idx="98">
                  <c:v>0.69240000000000002</c:v>
                </c:pt>
                <c:pt idx="99">
                  <c:v>0.71289999999999998</c:v>
                </c:pt>
                <c:pt idx="100">
                  <c:v>0.73050000000000004</c:v>
                </c:pt>
                <c:pt idx="101">
                  <c:v>0.74409999999999998</c:v>
                </c:pt>
                <c:pt idx="102">
                  <c:v>0.75349999999999995</c:v>
                </c:pt>
                <c:pt idx="103">
                  <c:v>0.75860000000000005</c:v>
                </c:pt>
                <c:pt idx="104">
                  <c:v>0.75849999999999995</c:v>
                </c:pt>
                <c:pt idx="105">
                  <c:v>0.754</c:v>
                </c:pt>
                <c:pt idx="106">
                  <c:v>0.74460000000000004</c:v>
                </c:pt>
                <c:pt idx="107">
                  <c:v>0.73050000000000004</c:v>
                </c:pt>
                <c:pt idx="108">
                  <c:v>0.71130000000000004</c:v>
                </c:pt>
                <c:pt idx="109">
                  <c:v>0.68730000000000002</c:v>
                </c:pt>
                <c:pt idx="110">
                  <c:v>0.65890000000000004</c:v>
                </c:pt>
                <c:pt idx="111">
                  <c:v>0.627</c:v>
                </c:pt>
                <c:pt idx="112">
                  <c:v>0.59140000000000004</c:v>
                </c:pt>
                <c:pt idx="113">
                  <c:v>0.55410000000000004</c:v>
                </c:pt>
                <c:pt idx="114">
                  <c:v>0.51529999999999998</c:v>
                </c:pt>
                <c:pt idx="115">
                  <c:v>0.47639999999999999</c:v>
                </c:pt>
                <c:pt idx="116">
                  <c:v>0.43759999999999999</c:v>
                </c:pt>
                <c:pt idx="117">
                  <c:v>0.4002</c:v>
                </c:pt>
                <c:pt idx="118">
                  <c:v>0.36459999999999998</c:v>
                </c:pt>
                <c:pt idx="119">
                  <c:v>0.33169999999999999</c:v>
                </c:pt>
                <c:pt idx="120">
                  <c:v>0.30130000000000001</c:v>
                </c:pt>
                <c:pt idx="121">
                  <c:v>0.27329999999999999</c:v>
                </c:pt>
                <c:pt idx="122">
                  <c:v>0.24779999999999999</c:v>
                </c:pt>
                <c:pt idx="123">
                  <c:v>0.22450000000000001</c:v>
                </c:pt>
                <c:pt idx="124">
                  <c:v>0.20399999999999999</c:v>
                </c:pt>
                <c:pt idx="125">
                  <c:v>0.1852</c:v>
                </c:pt>
                <c:pt idx="126">
                  <c:v>0.16889999999999999</c:v>
                </c:pt>
                <c:pt idx="127">
                  <c:v>0.15440000000000001</c:v>
                </c:pt>
                <c:pt idx="128">
                  <c:v>0.1416</c:v>
                </c:pt>
                <c:pt idx="129">
                  <c:v>0.1303</c:v>
                </c:pt>
                <c:pt idx="130">
                  <c:v>0.12</c:v>
                </c:pt>
                <c:pt idx="131">
                  <c:v>0.1109</c:v>
                </c:pt>
                <c:pt idx="132">
                  <c:v>0.1027</c:v>
                </c:pt>
                <c:pt idx="133">
                  <c:v>9.5100000000000004E-2</c:v>
                </c:pt>
                <c:pt idx="134">
                  <c:v>8.8800000000000004E-2</c:v>
                </c:pt>
                <c:pt idx="135">
                  <c:v>8.3000000000000004E-2</c:v>
                </c:pt>
                <c:pt idx="136">
                  <c:v>7.7700000000000005E-2</c:v>
                </c:pt>
                <c:pt idx="137">
                  <c:v>7.2999999999999995E-2</c:v>
                </c:pt>
                <c:pt idx="138">
                  <c:v>6.8699999999999997E-2</c:v>
                </c:pt>
                <c:pt idx="139">
                  <c:v>6.4699999999999994E-2</c:v>
                </c:pt>
                <c:pt idx="140">
                  <c:v>6.13E-2</c:v>
                </c:pt>
                <c:pt idx="141">
                  <c:v>5.79E-2</c:v>
                </c:pt>
                <c:pt idx="142">
                  <c:v>5.4899999999999997E-2</c:v>
                </c:pt>
                <c:pt idx="143">
                  <c:v>5.2200000000000003E-2</c:v>
                </c:pt>
                <c:pt idx="144">
                  <c:v>4.9700000000000001E-2</c:v>
                </c:pt>
                <c:pt idx="145">
                  <c:v>4.7500000000000001E-2</c:v>
                </c:pt>
                <c:pt idx="146">
                  <c:v>4.53E-2</c:v>
                </c:pt>
                <c:pt idx="147">
                  <c:v>4.3299999999999998E-2</c:v>
                </c:pt>
                <c:pt idx="148">
                  <c:v>4.1500000000000002E-2</c:v>
                </c:pt>
                <c:pt idx="149">
                  <c:v>3.9800000000000002E-2</c:v>
                </c:pt>
                <c:pt idx="150">
                  <c:v>3.8199999999999998E-2</c:v>
                </c:pt>
                <c:pt idx="151">
                  <c:v>3.6700000000000003E-2</c:v>
                </c:pt>
                <c:pt idx="152">
                  <c:v>3.5400000000000001E-2</c:v>
                </c:pt>
                <c:pt idx="153">
                  <c:v>3.4000000000000002E-2</c:v>
                </c:pt>
                <c:pt idx="154">
                  <c:v>3.2800000000000003E-2</c:v>
                </c:pt>
                <c:pt idx="155">
                  <c:v>3.1600000000000003E-2</c:v>
                </c:pt>
                <c:pt idx="156">
                  <c:v>3.04E-2</c:v>
                </c:pt>
                <c:pt idx="157">
                  <c:v>2.9499999999999998E-2</c:v>
                </c:pt>
                <c:pt idx="158">
                  <c:v>2.8500000000000001E-2</c:v>
                </c:pt>
                <c:pt idx="159">
                  <c:v>2.76E-2</c:v>
                </c:pt>
                <c:pt idx="160">
                  <c:v>2.6700000000000002E-2</c:v>
                </c:pt>
                <c:pt idx="161">
                  <c:v>2.5899999999999999E-2</c:v>
                </c:pt>
                <c:pt idx="162">
                  <c:v>2.5100000000000001E-2</c:v>
                </c:pt>
                <c:pt idx="163">
                  <c:v>2.4299999999999999E-2</c:v>
                </c:pt>
                <c:pt idx="164">
                  <c:v>2.3599999999999999E-2</c:v>
                </c:pt>
                <c:pt idx="165">
                  <c:v>2.29E-2</c:v>
                </c:pt>
                <c:pt idx="166">
                  <c:v>2.23E-2</c:v>
                </c:pt>
                <c:pt idx="167">
                  <c:v>2.1600000000000001E-2</c:v>
                </c:pt>
                <c:pt idx="168">
                  <c:v>2.1100000000000001E-2</c:v>
                </c:pt>
                <c:pt idx="169">
                  <c:v>2.0500000000000001E-2</c:v>
                </c:pt>
                <c:pt idx="170">
                  <c:v>1.9900000000000001E-2</c:v>
                </c:pt>
                <c:pt idx="171">
                  <c:v>1.9300000000000001E-2</c:v>
                </c:pt>
                <c:pt idx="172">
                  <c:v>1.89E-2</c:v>
                </c:pt>
                <c:pt idx="173">
                  <c:v>1.84E-2</c:v>
                </c:pt>
                <c:pt idx="174">
                  <c:v>1.78E-2</c:v>
                </c:pt>
                <c:pt idx="175">
                  <c:v>1.7500000000000002E-2</c:v>
                </c:pt>
                <c:pt idx="176">
                  <c:v>1.7000000000000001E-2</c:v>
                </c:pt>
                <c:pt idx="177">
                  <c:v>1.6500000000000001E-2</c:v>
                </c:pt>
                <c:pt idx="178">
                  <c:v>1.6E-2</c:v>
                </c:pt>
                <c:pt idx="179">
                  <c:v>1.5800000000000002E-2</c:v>
                </c:pt>
                <c:pt idx="180">
                  <c:v>1.55E-2</c:v>
                </c:pt>
                <c:pt idx="181">
                  <c:v>1.5100000000000001E-2</c:v>
                </c:pt>
                <c:pt idx="182">
                  <c:v>1.46E-2</c:v>
                </c:pt>
                <c:pt idx="183">
                  <c:v>1.43E-2</c:v>
                </c:pt>
                <c:pt idx="184">
                  <c:v>1.3899999999999999E-2</c:v>
                </c:pt>
                <c:pt idx="185">
                  <c:v>1.37E-2</c:v>
                </c:pt>
                <c:pt idx="186">
                  <c:v>1.32E-2</c:v>
                </c:pt>
                <c:pt idx="187">
                  <c:v>1.2999999999999999E-2</c:v>
                </c:pt>
                <c:pt idx="188">
                  <c:v>1.2800000000000001E-2</c:v>
                </c:pt>
                <c:pt idx="189">
                  <c:v>1.2500000000000001E-2</c:v>
                </c:pt>
                <c:pt idx="190">
                  <c:v>1.23E-2</c:v>
                </c:pt>
                <c:pt idx="191">
                  <c:v>1.1900000000000001E-2</c:v>
                </c:pt>
                <c:pt idx="192">
                  <c:v>1.17E-2</c:v>
                </c:pt>
                <c:pt idx="193">
                  <c:v>1.14E-2</c:v>
                </c:pt>
                <c:pt idx="194">
                  <c:v>1.11E-2</c:v>
                </c:pt>
                <c:pt idx="195">
                  <c:v>1.09E-2</c:v>
                </c:pt>
                <c:pt idx="196">
                  <c:v>1.06E-2</c:v>
                </c:pt>
                <c:pt idx="197">
                  <c:v>1.0500000000000001E-2</c:v>
                </c:pt>
                <c:pt idx="198">
                  <c:v>1.01E-2</c:v>
                </c:pt>
                <c:pt idx="199">
                  <c:v>0.01</c:v>
                </c:pt>
                <c:pt idx="200">
                  <c:v>9.7999999999999997E-3</c:v>
                </c:pt>
                <c:pt idx="201">
                  <c:v>9.5999999999999992E-3</c:v>
                </c:pt>
                <c:pt idx="202">
                  <c:v>9.4000000000000004E-3</c:v>
                </c:pt>
                <c:pt idx="203">
                  <c:v>9.1999999999999998E-3</c:v>
                </c:pt>
                <c:pt idx="204">
                  <c:v>9.1000000000000004E-3</c:v>
                </c:pt>
                <c:pt idx="205">
                  <c:v>8.8000000000000005E-3</c:v>
                </c:pt>
                <c:pt idx="206">
                  <c:v>8.8000000000000005E-3</c:v>
                </c:pt>
                <c:pt idx="207">
                  <c:v>8.5000000000000006E-3</c:v>
                </c:pt>
                <c:pt idx="208">
                  <c:v>8.3000000000000001E-3</c:v>
                </c:pt>
                <c:pt idx="209">
                  <c:v>8.2000000000000007E-3</c:v>
                </c:pt>
                <c:pt idx="210">
                  <c:v>8.0000000000000002E-3</c:v>
                </c:pt>
                <c:pt idx="211">
                  <c:v>7.9000000000000008E-3</c:v>
                </c:pt>
                <c:pt idx="212">
                  <c:v>7.7000000000000002E-3</c:v>
                </c:pt>
                <c:pt idx="213">
                  <c:v>7.6E-3</c:v>
                </c:pt>
                <c:pt idx="214">
                  <c:v>7.4000000000000003E-3</c:v>
                </c:pt>
                <c:pt idx="215">
                  <c:v>7.3000000000000001E-3</c:v>
                </c:pt>
                <c:pt idx="216">
                  <c:v>7.1000000000000004E-3</c:v>
                </c:pt>
                <c:pt idx="217">
                  <c:v>7.1000000000000004E-3</c:v>
                </c:pt>
                <c:pt idx="218">
                  <c:v>6.8999999999999999E-3</c:v>
                </c:pt>
                <c:pt idx="219">
                  <c:v>6.7999999999999996E-3</c:v>
                </c:pt>
                <c:pt idx="220">
                  <c:v>6.7000000000000002E-3</c:v>
                </c:pt>
                <c:pt idx="221">
                  <c:v>6.4999999999999997E-3</c:v>
                </c:pt>
                <c:pt idx="222">
                  <c:v>6.4000000000000003E-3</c:v>
                </c:pt>
                <c:pt idx="223">
                  <c:v>6.3E-3</c:v>
                </c:pt>
                <c:pt idx="224">
                  <c:v>6.1000000000000004E-3</c:v>
                </c:pt>
                <c:pt idx="225">
                  <c:v>6.1000000000000004E-3</c:v>
                </c:pt>
                <c:pt idx="226">
                  <c:v>6.0000000000000001E-3</c:v>
                </c:pt>
                <c:pt idx="227">
                  <c:v>5.7999999999999996E-3</c:v>
                </c:pt>
                <c:pt idx="228">
                  <c:v>5.7000000000000002E-3</c:v>
                </c:pt>
                <c:pt idx="229">
                  <c:v>5.4999999999999997E-3</c:v>
                </c:pt>
                <c:pt idx="230">
                  <c:v>5.5999999999999999E-3</c:v>
                </c:pt>
                <c:pt idx="231">
                  <c:v>5.4999999999999997E-3</c:v>
                </c:pt>
                <c:pt idx="232">
                  <c:v>5.3E-3</c:v>
                </c:pt>
                <c:pt idx="233">
                  <c:v>5.4000000000000003E-3</c:v>
                </c:pt>
                <c:pt idx="234">
                  <c:v>5.1999999999999998E-3</c:v>
                </c:pt>
                <c:pt idx="235">
                  <c:v>5.0000000000000001E-3</c:v>
                </c:pt>
                <c:pt idx="236">
                  <c:v>5.0000000000000001E-3</c:v>
                </c:pt>
                <c:pt idx="237">
                  <c:v>5.0000000000000001E-3</c:v>
                </c:pt>
                <c:pt idx="238">
                  <c:v>4.7000000000000002E-3</c:v>
                </c:pt>
                <c:pt idx="239">
                  <c:v>4.5999999999999999E-3</c:v>
                </c:pt>
                <c:pt idx="240">
                  <c:v>4.5999999999999999E-3</c:v>
                </c:pt>
                <c:pt idx="241">
                  <c:v>4.5999999999999999E-3</c:v>
                </c:pt>
                <c:pt idx="242">
                  <c:v>4.4000000000000003E-3</c:v>
                </c:pt>
                <c:pt idx="243">
                  <c:v>4.4000000000000003E-3</c:v>
                </c:pt>
                <c:pt idx="244">
                  <c:v>4.4000000000000003E-3</c:v>
                </c:pt>
                <c:pt idx="245">
                  <c:v>4.3E-3</c:v>
                </c:pt>
                <c:pt idx="246">
                  <c:v>4.1000000000000003E-3</c:v>
                </c:pt>
                <c:pt idx="247">
                  <c:v>4.1000000000000003E-3</c:v>
                </c:pt>
                <c:pt idx="248">
                  <c:v>4.0000000000000001E-3</c:v>
                </c:pt>
                <c:pt idx="249">
                  <c:v>4.0000000000000001E-3</c:v>
                </c:pt>
                <c:pt idx="250">
                  <c:v>4.0000000000000001E-3</c:v>
                </c:pt>
                <c:pt idx="251">
                  <c:v>3.8999999999999998E-3</c:v>
                </c:pt>
                <c:pt idx="252">
                  <c:v>3.8E-3</c:v>
                </c:pt>
                <c:pt idx="253">
                  <c:v>3.7000000000000002E-3</c:v>
                </c:pt>
                <c:pt idx="254">
                  <c:v>3.7000000000000002E-3</c:v>
                </c:pt>
                <c:pt idx="255">
                  <c:v>3.7000000000000002E-3</c:v>
                </c:pt>
                <c:pt idx="256">
                  <c:v>3.5000000000000001E-3</c:v>
                </c:pt>
                <c:pt idx="257">
                  <c:v>3.5000000000000001E-3</c:v>
                </c:pt>
                <c:pt idx="258">
                  <c:v>3.3999999999999998E-3</c:v>
                </c:pt>
                <c:pt idx="259">
                  <c:v>3.5000000000000001E-3</c:v>
                </c:pt>
                <c:pt idx="260">
                  <c:v>3.3E-3</c:v>
                </c:pt>
                <c:pt idx="261">
                  <c:v>3.3999999999999998E-3</c:v>
                </c:pt>
                <c:pt idx="262">
                  <c:v>3.3E-3</c:v>
                </c:pt>
                <c:pt idx="263">
                  <c:v>3.0999999999999999E-3</c:v>
                </c:pt>
                <c:pt idx="264">
                  <c:v>3.0999999999999999E-3</c:v>
                </c:pt>
                <c:pt idx="265">
                  <c:v>3.2000000000000002E-3</c:v>
                </c:pt>
                <c:pt idx="266">
                  <c:v>3.0999999999999999E-3</c:v>
                </c:pt>
                <c:pt idx="267">
                  <c:v>3.0000000000000001E-3</c:v>
                </c:pt>
                <c:pt idx="268">
                  <c:v>2.8999999999999998E-3</c:v>
                </c:pt>
                <c:pt idx="269">
                  <c:v>2.8999999999999998E-3</c:v>
                </c:pt>
                <c:pt idx="270">
                  <c:v>2.8E-3</c:v>
                </c:pt>
                <c:pt idx="271">
                  <c:v>2.8E-3</c:v>
                </c:pt>
                <c:pt idx="272">
                  <c:v>2.8E-3</c:v>
                </c:pt>
                <c:pt idx="273">
                  <c:v>2.7000000000000001E-3</c:v>
                </c:pt>
                <c:pt idx="274">
                  <c:v>2.7000000000000001E-3</c:v>
                </c:pt>
                <c:pt idx="275">
                  <c:v>2.7000000000000001E-3</c:v>
                </c:pt>
                <c:pt idx="276">
                  <c:v>2.5999999999999999E-3</c:v>
                </c:pt>
                <c:pt idx="277">
                  <c:v>2.5000000000000001E-3</c:v>
                </c:pt>
                <c:pt idx="278">
                  <c:v>2.5999999999999999E-3</c:v>
                </c:pt>
                <c:pt idx="279">
                  <c:v>2.5000000000000001E-3</c:v>
                </c:pt>
                <c:pt idx="280">
                  <c:v>2.5000000000000001E-3</c:v>
                </c:pt>
                <c:pt idx="281">
                  <c:v>2.5000000000000001E-3</c:v>
                </c:pt>
                <c:pt idx="282">
                  <c:v>2.3999999999999998E-3</c:v>
                </c:pt>
                <c:pt idx="283">
                  <c:v>2.3E-3</c:v>
                </c:pt>
                <c:pt idx="284">
                  <c:v>2.3E-3</c:v>
                </c:pt>
                <c:pt idx="285">
                  <c:v>2.3999999999999998E-3</c:v>
                </c:pt>
                <c:pt idx="286">
                  <c:v>2.2000000000000001E-3</c:v>
                </c:pt>
                <c:pt idx="287">
                  <c:v>2.2000000000000001E-3</c:v>
                </c:pt>
                <c:pt idx="288">
                  <c:v>2.3E-3</c:v>
                </c:pt>
                <c:pt idx="289">
                  <c:v>2.2000000000000001E-3</c:v>
                </c:pt>
                <c:pt idx="290">
                  <c:v>2.2000000000000001E-3</c:v>
                </c:pt>
                <c:pt idx="291">
                  <c:v>2.2000000000000001E-3</c:v>
                </c:pt>
                <c:pt idx="292">
                  <c:v>1.9E-3</c:v>
                </c:pt>
                <c:pt idx="293">
                  <c:v>2.0999999999999999E-3</c:v>
                </c:pt>
                <c:pt idx="294">
                  <c:v>2E-3</c:v>
                </c:pt>
                <c:pt idx="295">
                  <c:v>2.0999999999999999E-3</c:v>
                </c:pt>
                <c:pt idx="296">
                  <c:v>2E-3</c:v>
                </c:pt>
                <c:pt idx="297">
                  <c:v>2E-3</c:v>
                </c:pt>
                <c:pt idx="298">
                  <c:v>2E-3</c:v>
                </c:pt>
                <c:pt idx="299">
                  <c:v>1.8E-3</c:v>
                </c:pt>
                <c:pt idx="300">
                  <c:v>1.8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60A-469C-B401-C15EA21912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4867584"/>
        <c:axId val="134890240"/>
      </c:scatterChart>
      <c:valAx>
        <c:axId val="134867584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Wavelength (n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4890240"/>
        <c:crosses val="autoZero"/>
        <c:crossBetween val="midCat"/>
      </c:valAx>
      <c:valAx>
        <c:axId val="134890240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Absorbance</a:t>
                </a:r>
              </a:p>
            </c:rich>
          </c:tx>
          <c:layout>
            <c:manualLayout>
              <c:xMode val="edge"/>
              <c:yMode val="edge"/>
              <c:x val="1.9285134812693869E-2"/>
              <c:y val="0.275387701537307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4867584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59388958916517975"/>
          <c:y val="5.3822272215973015E-2"/>
          <c:w val="0.35274417970480965"/>
          <c:h val="0.19863442069741277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AU"/>
              <a:t>E_AgNP_Water</a:t>
            </a:r>
          </a:p>
        </c:rich>
      </c:tx>
      <c:layout>
        <c:manualLayout>
          <c:xMode val="edge"/>
          <c:yMode val="edge"/>
          <c:x val="0.35331577083363658"/>
          <c:y val="6.970237473631446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516099123973141"/>
          <c:y val="5.1400554097404488E-2"/>
          <c:w val="0.78808576200702185"/>
          <c:h val="0.743212598425196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B$2</c:f>
              <c:strCache>
                <c:ptCount val="1"/>
                <c:pt idx="0">
                  <c:v>0 h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1!$AA$3:$AA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AB$3:$AB$303</c:f>
              <c:numCache>
                <c:formatCode>General</c:formatCode>
                <c:ptCount val="301"/>
                <c:pt idx="0">
                  <c:v>0.90969999999999995</c:v>
                </c:pt>
                <c:pt idx="1">
                  <c:v>0.89319999999999999</c:v>
                </c:pt>
                <c:pt idx="2">
                  <c:v>0.87929999999999997</c:v>
                </c:pt>
                <c:pt idx="3">
                  <c:v>0.86650000000000005</c:v>
                </c:pt>
                <c:pt idx="4">
                  <c:v>0.85340000000000005</c:v>
                </c:pt>
                <c:pt idx="5">
                  <c:v>0.83979999999999999</c:v>
                </c:pt>
                <c:pt idx="6">
                  <c:v>0.82640000000000002</c:v>
                </c:pt>
                <c:pt idx="7">
                  <c:v>0.81269999999999998</c:v>
                </c:pt>
                <c:pt idx="8">
                  <c:v>0.79900000000000004</c:v>
                </c:pt>
                <c:pt idx="9">
                  <c:v>0.7853</c:v>
                </c:pt>
                <c:pt idx="10">
                  <c:v>0.77149999999999996</c:v>
                </c:pt>
                <c:pt idx="11">
                  <c:v>0.75719999999999998</c:v>
                </c:pt>
                <c:pt idx="12">
                  <c:v>0.74239999999999995</c:v>
                </c:pt>
                <c:pt idx="13">
                  <c:v>0.72770000000000001</c:v>
                </c:pt>
                <c:pt idx="14">
                  <c:v>0.71319999999999995</c:v>
                </c:pt>
                <c:pt idx="15">
                  <c:v>0.69940000000000002</c:v>
                </c:pt>
                <c:pt idx="16">
                  <c:v>0.68669999999999998</c:v>
                </c:pt>
                <c:pt idx="17">
                  <c:v>0.6764</c:v>
                </c:pt>
                <c:pt idx="18">
                  <c:v>0.66869999999999996</c:v>
                </c:pt>
                <c:pt idx="19">
                  <c:v>0.66369999999999996</c:v>
                </c:pt>
                <c:pt idx="20">
                  <c:v>0.66169999999999995</c:v>
                </c:pt>
                <c:pt idx="21">
                  <c:v>0.66259999999999997</c:v>
                </c:pt>
                <c:pt idx="22">
                  <c:v>0.66639999999999999</c:v>
                </c:pt>
                <c:pt idx="23">
                  <c:v>0.67300000000000004</c:v>
                </c:pt>
                <c:pt idx="24">
                  <c:v>0.68289999999999995</c:v>
                </c:pt>
                <c:pt idx="25">
                  <c:v>0.69499999999999995</c:v>
                </c:pt>
                <c:pt idx="26">
                  <c:v>0.70960000000000001</c:v>
                </c:pt>
                <c:pt idx="27">
                  <c:v>0.7258</c:v>
                </c:pt>
                <c:pt idx="28">
                  <c:v>0.7429</c:v>
                </c:pt>
                <c:pt idx="29">
                  <c:v>0.75980000000000003</c:v>
                </c:pt>
                <c:pt idx="30">
                  <c:v>0.77610000000000001</c:v>
                </c:pt>
                <c:pt idx="31">
                  <c:v>0.79100000000000004</c:v>
                </c:pt>
                <c:pt idx="32">
                  <c:v>0.80349999999999999</c:v>
                </c:pt>
                <c:pt idx="33">
                  <c:v>0.81240000000000001</c:v>
                </c:pt>
                <c:pt idx="34">
                  <c:v>0.81710000000000005</c:v>
                </c:pt>
                <c:pt idx="35">
                  <c:v>0.81759999999999999</c:v>
                </c:pt>
                <c:pt idx="36">
                  <c:v>0.81459999999999999</c:v>
                </c:pt>
                <c:pt idx="37">
                  <c:v>0.80759999999999998</c:v>
                </c:pt>
                <c:pt idx="38">
                  <c:v>0.79779999999999995</c:v>
                </c:pt>
                <c:pt idx="39">
                  <c:v>0.78639999999999999</c:v>
                </c:pt>
                <c:pt idx="40">
                  <c:v>0.77139999999999997</c:v>
                </c:pt>
                <c:pt idx="41">
                  <c:v>0.754</c:v>
                </c:pt>
                <c:pt idx="42">
                  <c:v>0.73370000000000002</c:v>
                </c:pt>
                <c:pt idx="43">
                  <c:v>0.7117</c:v>
                </c:pt>
                <c:pt idx="44">
                  <c:v>0.68759999999999999</c:v>
                </c:pt>
                <c:pt idx="45">
                  <c:v>0.66190000000000004</c:v>
                </c:pt>
                <c:pt idx="46">
                  <c:v>0.63329999999999997</c:v>
                </c:pt>
                <c:pt idx="47">
                  <c:v>0.60209999999999997</c:v>
                </c:pt>
                <c:pt idx="48">
                  <c:v>0.56889999999999996</c:v>
                </c:pt>
                <c:pt idx="49">
                  <c:v>0.53400000000000003</c:v>
                </c:pt>
                <c:pt idx="50">
                  <c:v>0.49809999999999999</c:v>
                </c:pt>
                <c:pt idx="51">
                  <c:v>0.46310000000000001</c:v>
                </c:pt>
                <c:pt idx="52">
                  <c:v>0.4299</c:v>
                </c:pt>
                <c:pt idx="53">
                  <c:v>0.39979999999999999</c:v>
                </c:pt>
                <c:pt idx="54">
                  <c:v>0.37409999999999999</c:v>
                </c:pt>
                <c:pt idx="55">
                  <c:v>0.35260000000000002</c:v>
                </c:pt>
                <c:pt idx="56">
                  <c:v>0.33500000000000002</c:v>
                </c:pt>
                <c:pt idx="57">
                  <c:v>0.32079999999999997</c:v>
                </c:pt>
                <c:pt idx="58">
                  <c:v>0.30959999999999999</c:v>
                </c:pt>
                <c:pt idx="59">
                  <c:v>0.30020000000000002</c:v>
                </c:pt>
                <c:pt idx="60">
                  <c:v>0.29270000000000002</c:v>
                </c:pt>
                <c:pt idx="61">
                  <c:v>0.28710000000000002</c:v>
                </c:pt>
                <c:pt idx="62">
                  <c:v>0.28270000000000001</c:v>
                </c:pt>
                <c:pt idx="63">
                  <c:v>0.27960000000000002</c:v>
                </c:pt>
                <c:pt idx="64">
                  <c:v>0.27760000000000001</c:v>
                </c:pt>
                <c:pt idx="65">
                  <c:v>0.27639999999999998</c:v>
                </c:pt>
                <c:pt idx="66">
                  <c:v>0.27689999999999998</c:v>
                </c:pt>
                <c:pt idx="67">
                  <c:v>0.27789999999999998</c:v>
                </c:pt>
                <c:pt idx="68">
                  <c:v>0.28000000000000003</c:v>
                </c:pt>
                <c:pt idx="69">
                  <c:v>0.2828</c:v>
                </c:pt>
                <c:pt idx="70">
                  <c:v>0.28620000000000001</c:v>
                </c:pt>
                <c:pt idx="71">
                  <c:v>0.29060000000000002</c:v>
                </c:pt>
                <c:pt idx="72">
                  <c:v>0.29620000000000002</c:v>
                </c:pt>
                <c:pt idx="73">
                  <c:v>0.30230000000000001</c:v>
                </c:pt>
                <c:pt idx="74">
                  <c:v>0.30930000000000002</c:v>
                </c:pt>
                <c:pt idx="75">
                  <c:v>0.31709999999999999</c:v>
                </c:pt>
                <c:pt idx="76">
                  <c:v>0.3261</c:v>
                </c:pt>
                <c:pt idx="77">
                  <c:v>0.33589999999999998</c:v>
                </c:pt>
                <c:pt idx="78">
                  <c:v>0.34649999999999997</c:v>
                </c:pt>
                <c:pt idx="79">
                  <c:v>0.35830000000000001</c:v>
                </c:pt>
                <c:pt idx="80">
                  <c:v>0.37090000000000001</c:v>
                </c:pt>
                <c:pt idx="81">
                  <c:v>0.3846</c:v>
                </c:pt>
                <c:pt idx="82">
                  <c:v>0.39879999999999999</c:v>
                </c:pt>
                <c:pt idx="83">
                  <c:v>0.41420000000000001</c:v>
                </c:pt>
                <c:pt idx="84">
                  <c:v>0.43</c:v>
                </c:pt>
                <c:pt idx="85">
                  <c:v>0.44719999999999999</c:v>
                </c:pt>
                <c:pt idx="86">
                  <c:v>0.46450000000000002</c:v>
                </c:pt>
                <c:pt idx="87">
                  <c:v>0.48230000000000001</c:v>
                </c:pt>
                <c:pt idx="88">
                  <c:v>0.50080000000000002</c:v>
                </c:pt>
                <c:pt idx="89">
                  <c:v>0.51929999999999998</c:v>
                </c:pt>
                <c:pt idx="90">
                  <c:v>0.53720000000000001</c:v>
                </c:pt>
                <c:pt idx="91">
                  <c:v>0.55479999999999996</c:v>
                </c:pt>
                <c:pt idx="92">
                  <c:v>0.57140000000000002</c:v>
                </c:pt>
                <c:pt idx="93">
                  <c:v>0.58850000000000002</c:v>
                </c:pt>
                <c:pt idx="94">
                  <c:v>0.60450000000000004</c:v>
                </c:pt>
                <c:pt idx="95">
                  <c:v>0.61919999999999997</c:v>
                </c:pt>
                <c:pt idx="96">
                  <c:v>0.63190000000000002</c:v>
                </c:pt>
                <c:pt idx="97">
                  <c:v>0.6431</c:v>
                </c:pt>
                <c:pt idx="98">
                  <c:v>0.65129999999999999</c:v>
                </c:pt>
                <c:pt idx="99">
                  <c:v>0.65720000000000001</c:v>
                </c:pt>
                <c:pt idx="100">
                  <c:v>0.66010000000000002</c:v>
                </c:pt>
                <c:pt idx="101">
                  <c:v>0.65980000000000005</c:v>
                </c:pt>
                <c:pt idx="102">
                  <c:v>0.65610000000000002</c:v>
                </c:pt>
                <c:pt idx="103">
                  <c:v>0.64900000000000002</c:v>
                </c:pt>
                <c:pt idx="104">
                  <c:v>0.63849999999999996</c:v>
                </c:pt>
                <c:pt idx="105">
                  <c:v>0.62509999999999999</c:v>
                </c:pt>
                <c:pt idx="106">
                  <c:v>0.60809999999999997</c:v>
                </c:pt>
                <c:pt idx="107">
                  <c:v>0.58819999999999995</c:v>
                </c:pt>
                <c:pt idx="108">
                  <c:v>0.56569999999999998</c:v>
                </c:pt>
                <c:pt idx="109">
                  <c:v>0.54069999999999996</c:v>
                </c:pt>
                <c:pt idx="110">
                  <c:v>0.51400000000000001</c:v>
                </c:pt>
                <c:pt idx="111">
                  <c:v>0.48649999999999999</c:v>
                </c:pt>
                <c:pt idx="112">
                  <c:v>0.45800000000000002</c:v>
                </c:pt>
                <c:pt idx="113">
                  <c:v>0.42970000000000003</c:v>
                </c:pt>
                <c:pt idx="114">
                  <c:v>0.40150000000000002</c:v>
                </c:pt>
                <c:pt idx="115">
                  <c:v>0.37390000000000001</c:v>
                </c:pt>
                <c:pt idx="116">
                  <c:v>0.34739999999999999</c:v>
                </c:pt>
                <c:pt idx="117">
                  <c:v>0.32229999999999998</c:v>
                </c:pt>
                <c:pt idx="118">
                  <c:v>0.2989</c:v>
                </c:pt>
                <c:pt idx="119">
                  <c:v>0.2772</c:v>
                </c:pt>
                <c:pt idx="120">
                  <c:v>0.2571</c:v>
                </c:pt>
                <c:pt idx="121">
                  <c:v>0.23849999999999999</c:v>
                </c:pt>
                <c:pt idx="122">
                  <c:v>0.22140000000000001</c:v>
                </c:pt>
                <c:pt idx="123">
                  <c:v>0.20569999999999999</c:v>
                </c:pt>
                <c:pt idx="124">
                  <c:v>0.19139999999999999</c:v>
                </c:pt>
                <c:pt idx="125">
                  <c:v>0.17860000000000001</c:v>
                </c:pt>
                <c:pt idx="126">
                  <c:v>0.16689999999999999</c:v>
                </c:pt>
                <c:pt idx="127">
                  <c:v>0.15629999999999999</c:v>
                </c:pt>
                <c:pt idx="128">
                  <c:v>0.1467</c:v>
                </c:pt>
                <c:pt idx="129">
                  <c:v>0.1381</c:v>
                </c:pt>
                <c:pt idx="130">
                  <c:v>0.13009999999999999</c:v>
                </c:pt>
                <c:pt idx="131">
                  <c:v>0.12280000000000001</c:v>
                </c:pt>
                <c:pt idx="132">
                  <c:v>0.1162</c:v>
                </c:pt>
                <c:pt idx="133">
                  <c:v>0.11</c:v>
                </c:pt>
                <c:pt idx="134">
                  <c:v>0.10440000000000001</c:v>
                </c:pt>
                <c:pt idx="135">
                  <c:v>9.9500000000000005E-2</c:v>
                </c:pt>
                <c:pt idx="136">
                  <c:v>9.4600000000000004E-2</c:v>
                </c:pt>
                <c:pt idx="137">
                  <c:v>9.0399999999999994E-2</c:v>
                </c:pt>
                <c:pt idx="138">
                  <c:v>8.6499999999999994E-2</c:v>
                </c:pt>
                <c:pt idx="139">
                  <c:v>8.3000000000000004E-2</c:v>
                </c:pt>
                <c:pt idx="140">
                  <c:v>7.9699999999999993E-2</c:v>
                </c:pt>
                <c:pt idx="141">
                  <c:v>7.6499999999999999E-2</c:v>
                </c:pt>
                <c:pt idx="142">
                  <c:v>7.3400000000000007E-2</c:v>
                </c:pt>
                <c:pt idx="143">
                  <c:v>7.0900000000000005E-2</c:v>
                </c:pt>
                <c:pt idx="144">
                  <c:v>6.83E-2</c:v>
                </c:pt>
                <c:pt idx="145">
                  <c:v>6.59E-2</c:v>
                </c:pt>
                <c:pt idx="146">
                  <c:v>6.3700000000000007E-2</c:v>
                </c:pt>
                <c:pt idx="147">
                  <c:v>6.1600000000000002E-2</c:v>
                </c:pt>
                <c:pt idx="148">
                  <c:v>5.9700000000000003E-2</c:v>
                </c:pt>
                <c:pt idx="149">
                  <c:v>5.79E-2</c:v>
                </c:pt>
                <c:pt idx="150">
                  <c:v>5.62E-2</c:v>
                </c:pt>
                <c:pt idx="151">
                  <c:v>5.4600000000000003E-2</c:v>
                </c:pt>
                <c:pt idx="152">
                  <c:v>5.2999999999999999E-2</c:v>
                </c:pt>
                <c:pt idx="153">
                  <c:v>5.1499999999999997E-2</c:v>
                </c:pt>
                <c:pt idx="154">
                  <c:v>5.0200000000000002E-2</c:v>
                </c:pt>
                <c:pt idx="155">
                  <c:v>4.87E-2</c:v>
                </c:pt>
                <c:pt idx="156">
                  <c:v>4.7399999999999998E-2</c:v>
                </c:pt>
                <c:pt idx="157">
                  <c:v>4.6199999999999998E-2</c:v>
                </c:pt>
                <c:pt idx="158">
                  <c:v>4.4999999999999998E-2</c:v>
                </c:pt>
                <c:pt idx="159">
                  <c:v>4.3999999999999997E-2</c:v>
                </c:pt>
                <c:pt idx="160">
                  <c:v>4.2700000000000002E-2</c:v>
                </c:pt>
                <c:pt idx="161">
                  <c:v>4.1799999999999997E-2</c:v>
                </c:pt>
                <c:pt idx="162">
                  <c:v>4.0899999999999999E-2</c:v>
                </c:pt>
                <c:pt idx="163">
                  <c:v>3.9800000000000002E-2</c:v>
                </c:pt>
                <c:pt idx="164">
                  <c:v>3.9E-2</c:v>
                </c:pt>
                <c:pt idx="165">
                  <c:v>3.8199999999999998E-2</c:v>
                </c:pt>
                <c:pt idx="166">
                  <c:v>3.7199999999999997E-2</c:v>
                </c:pt>
                <c:pt idx="167">
                  <c:v>3.6499999999999998E-2</c:v>
                </c:pt>
                <c:pt idx="168">
                  <c:v>3.56E-2</c:v>
                </c:pt>
                <c:pt idx="169">
                  <c:v>3.49E-2</c:v>
                </c:pt>
                <c:pt idx="170">
                  <c:v>3.4200000000000001E-2</c:v>
                </c:pt>
                <c:pt idx="171">
                  <c:v>3.3399999999999999E-2</c:v>
                </c:pt>
                <c:pt idx="172">
                  <c:v>3.27E-2</c:v>
                </c:pt>
                <c:pt idx="173">
                  <c:v>3.2099999999999997E-2</c:v>
                </c:pt>
                <c:pt idx="174">
                  <c:v>3.1399999999999997E-2</c:v>
                </c:pt>
                <c:pt idx="175">
                  <c:v>3.0800000000000001E-2</c:v>
                </c:pt>
                <c:pt idx="176">
                  <c:v>3.0200000000000001E-2</c:v>
                </c:pt>
                <c:pt idx="177">
                  <c:v>2.9600000000000001E-2</c:v>
                </c:pt>
                <c:pt idx="178">
                  <c:v>2.9100000000000001E-2</c:v>
                </c:pt>
                <c:pt idx="179">
                  <c:v>2.8400000000000002E-2</c:v>
                </c:pt>
                <c:pt idx="180">
                  <c:v>2.7900000000000001E-2</c:v>
                </c:pt>
                <c:pt idx="181">
                  <c:v>2.7300000000000001E-2</c:v>
                </c:pt>
                <c:pt idx="182">
                  <c:v>2.6800000000000001E-2</c:v>
                </c:pt>
                <c:pt idx="183">
                  <c:v>2.64E-2</c:v>
                </c:pt>
                <c:pt idx="184">
                  <c:v>2.5899999999999999E-2</c:v>
                </c:pt>
                <c:pt idx="185">
                  <c:v>2.5399999999999999E-2</c:v>
                </c:pt>
                <c:pt idx="186">
                  <c:v>2.4899999999999999E-2</c:v>
                </c:pt>
                <c:pt idx="187">
                  <c:v>2.4500000000000001E-2</c:v>
                </c:pt>
                <c:pt idx="188">
                  <c:v>2.4E-2</c:v>
                </c:pt>
                <c:pt idx="189">
                  <c:v>2.35E-2</c:v>
                </c:pt>
                <c:pt idx="190">
                  <c:v>2.3099999999999999E-2</c:v>
                </c:pt>
                <c:pt idx="191">
                  <c:v>2.2599999999999999E-2</c:v>
                </c:pt>
                <c:pt idx="192">
                  <c:v>2.24E-2</c:v>
                </c:pt>
                <c:pt idx="193">
                  <c:v>2.1899999999999999E-2</c:v>
                </c:pt>
                <c:pt idx="194">
                  <c:v>2.1499999999999998E-2</c:v>
                </c:pt>
                <c:pt idx="195">
                  <c:v>2.1100000000000001E-2</c:v>
                </c:pt>
                <c:pt idx="196">
                  <c:v>2.07E-2</c:v>
                </c:pt>
                <c:pt idx="197">
                  <c:v>2.0400000000000001E-2</c:v>
                </c:pt>
                <c:pt idx="198">
                  <c:v>0.02</c:v>
                </c:pt>
                <c:pt idx="199">
                  <c:v>1.9599999999999999E-2</c:v>
                </c:pt>
                <c:pt idx="200">
                  <c:v>1.9300000000000001E-2</c:v>
                </c:pt>
                <c:pt idx="201">
                  <c:v>1.89E-2</c:v>
                </c:pt>
                <c:pt idx="202">
                  <c:v>1.8599999999999998E-2</c:v>
                </c:pt>
                <c:pt idx="203">
                  <c:v>1.8200000000000001E-2</c:v>
                </c:pt>
                <c:pt idx="204">
                  <c:v>1.7899999999999999E-2</c:v>
                </c:pt>
                <c:pt idx="205">
                  <c:v>1.7600000000000001E-2</c:v>
                </c:pt>
                <c:pt idx="206">
                  <c:v>1.7299999999999999E-2</c:v>
                </c:pt>
                <c:pt idx="207">
                  <c:v>1.7000000000000001E-2</c:v>
                </c:pt>
                <c:pt idx="208">
                  <c:v>1.66E-2</c:v>
                </c:pt>
                <c:pt idx="209">
                  <c:v>1.6299999999999999E-2</c:v>
                </c:pt>
                <c:pt idx="210">
                  <c:v>1.61E-2</c:v>
                </c:pt>
                <c:pt idx="211">
                  <c:v>1.5699999999999999E-2</c:v>
                </c:pt>
                <c:pt idx="212">
                  <c:v>1.54E-2</c:v>
                </c:pt>
                <c:pt idx="213">
                  <c:v>1.5100000000000001E-2</c:v>
                </c:pt>
                <c:pt idx="214">
                  <c:v>1.49E-2</c:v>
                </c:pt>
                <c:pt idx="215">
                  <c:v>1.47E-2</c:v>
                </c:pt>
                <c:pt idx="216">
                  <c:v>1.44E-2</c:v>
                </c:pt>
                <c:pt idx="217">
                  <c:v>1.41E-2</c:v>
                </c:pt>
                <c:pt idx="218">
                  <c:v>1.38E-2</c:v>
                </c:pt>
                <c:pt idx="219">
                  <c:v>1.3599999999999999E-2</c:v>
                </c:pt>
                <c:pt idx="220">
                  <c:v>1.3299999999999999E-2</c:v>
                </c:pt>
                <c:pt idx="221">
                  <c:v>1.3100000000000001E-2</c:v>
                </c:pt>
                <c:pt idx="222">
                  <c:v>1.29E-2</c:v>
                </c:pt>
                <c:pt idx="223">
                  <c:v>1.2699999999999999E-2</c:v>
                </c:pt>
                <c:pt idx="224">
                  <c:v>1.2500000000000001E-2</c:v>
                </c:pt>
                <c:pt idx="225">
                  <c:v>1.23E-2</c:v>
                </c:pt>
                <c:pt idx="226">
                  <c:v>1.1900000000000001E-2</c:v>
                </c:pt>
                <c:pt idx="227">
                  <c:v>1.17E-2</c:v>
                </c:pt>
                <c:pt idx="228">
                  <c:v>1.1599999999999999E-2</c:v>
                </c:pt>
                <c:pt idx="229">
                  <c:v>1.1299999999999999E-2</c:v>
                </c:pt>
                <c:pt idx="230">
                  <c:v>1.11E-2</c:v>
                </c:pt>
                <c:pt idx="231">
                  <c:v>1.0800000000000001E-2</c:v>
                </c:pt>
                <c:pt idx="232">
                  <c:v>1.0800000000000001E-2</c:v>
                </c:pt>
                <c:pt idx="233">
                  <c:v>1.06E-2</c:v>
                </c:pt>
                <c:pt idx="234">
                  <c:v>1.04E-2</c:v>
                </c:pt>
                <c:pt idx="235">
                  <c:v>1.0200000000000001E-2</c:v>
                </c:pt>
                <c:pt idx="236">
                  <c:v>1.01E-2</c:v>
                </c:pt>
                <c:pt idx="237">
                  <c:v>9.7999999999999997E-3</c:v>
                </c:pt>
                <c:pt idx="238">
                  <c:v>9.5999999999999992E-3</c:v>
                </c:pt>
                <c:pt idx="239">
                  <c:v>9.4000000000000004E-3</c:v>
                </c:pt>
                <c:pt idx="240">
                  <c:v>9.2999999999999992E-3</c:v>
                </c:pt>
                <c:pt idx="241">
                  <c:v>9.1999999999999998E-3</c:v>
                </c:pt>
                <c:pt idx="242">
                  <c:v>8.9999999999999993E-3</c:v>
                </c:pt>
                <c:pt idx="243">
                  <c:v>8.8999999999999999E-3</c:v>
                </c:pt>
                <c:pt idx="244">
                  <c:v>8.8000000000000005E-3</c:v>
                </c:pt>
                <c:pt idx="245">
                  <c:v>8.6E-3</c:v>
                </c:pt>
                <c:pt idx="246">
                  <c:v>8.3999999999999995E-3</c:v>
                </c:pt>
                <c:pt idx="247">
                  <c:v>8.3000000000000001E-3</c:v>
                </c:pt>
                <c:pt idx="248">
                  <c:v>8.2000000000000007E-3</c:v>
                </c:pt>
                <c:pt idx="249">
                  <c:v>8.0999999999999996E-3</c:v>
                </c:pt>
                <c:pt idx="250">
                  <c:v>7.9000000000000008E-3</c:v>
                </c:pt>
                <c:pt idx="251">
                  <c:v>7.7000000000000002E-3</c:v>
                </c:pt>
                <c:pt idx="252">
                  <c:v>7.6E-3</c:v>
                </c:pt>
                <c:pt idx="253">
                  <c:v>7.6E-3</c:v>
                </c:pt>
                <c:pt idx="254">
                  <c:v>7.4000000000000003E-3</c:v>
                </c:pt>
                <c:pt idx="255">
                  <c:v>7.3000000000000001E-3</c:v>
                </c:pt>
                <c:pt idx="256">
                  <c:v>7.1000000000000004E-3</c:v>
                </c:pt>
                <c:pt idx="257">
                  <c:v>7.1000000000000004E-3</c:v>
                </c:pt>
                <c:pt idx="258">
                  <c:v>7.0000000000000001E-3</c:v>
                </c:pt>
                <c:pt idx="259">
                  <c:v>6.8999999999999999E-3</c:v>
                </c:pt>
                <c:pt idx="260">
                  <c:v>6.8999999999999999E-3</c:v>
                </c:pt>
                <c:pt idx="261">
                  <c:v>6.7000000000000002E-3</c:v>
                </c:pt>
                <c:pt idx="262">
                  <c:v>6.6E-3</c:v>
                </c:pt>
                <c:pt idx="263">
                  <c:v>6.4999999999999997E-3</c:v>
                </c:pt>
                <c:pt idx="264">
                  <c:v>6.4999999999999997E-3</c:v>
                </c:pt>
                <c:pt idx="265">
                  <c:v>6.3E-3</c:v>
                </c:pt>
                <c:pt idx="266">
                  <c:v>6.1999999999999998E-3</c:v>
                </c:pt>
                <c:pt idx="267">
                  <c:v>6.1999999999999998E-3</c:v>
                </c:pt>
                <c:pt idx="268">
                  <c:v>6.1999999999999998E-3</c:v>
                </c:pt>
                <c:pt idx="269">
                  <c:v>5.8999999999999999E-3</c:v>
                </c:pt>
                <c:pt idx="270">
                  <c:v>5.8999999999999999E-3</c:v>
                </c:pt>
                <c:pt idx="271">
                  <c:v>5.7000000000000002E-3</c:v>
                </c:pt>
                <c:pt idx="272">
                  <c:v>5.5999999999999999E-3</c:v>
                </c:pt>
                <c:pt idx="273">
                  <c:v>5.5999999999999999E-3</c:v>
                </c:pt>
                <c:pt idx="274">
                  <c:v>5.4999999999999997E-3</c:v>
                </c:pt>
                <c:pt idx="275">
                  <c:v>5.3E-3</c:v>
                </c:pt>
                <c:pt idx="276">
                  <c:v>5.4000000000000003E-3</c:v>
                </c:pt>
                <c:pt idx="277">
                  <c:v>5.3E-3</c:v>
                </c:pt>
                <c:pt idx="278">
                  <c:v>5.1999999999999998E-3</c:v>
                </c:pt>
                <c:pt idx="279">
                  <c:v>5.0000000000000001E-3</c:v>
                </c:pt>
                <c:pt idx="280">
                  <c:v>5.0000000000000001E-3</c:v>
                </c:pt>
                <c:pt idx="281">
                  <c:v>4.8999999999999998E-3</c:v>
                </c:pt>
                <c:pt idx="282">
                  <c:v>4.7999999999999996E-3</c:v>
                </c:pt>
                <c:pt idx="283">
                  <c:v>4.7000000000000002E-3</c:v>
                </c:pt>
                <c:pt idx="284">
                  <c:v>4.7000000000000002E-3</c:v>
                </c:pt>
                <c:pt idx="285">
                  <c:v>4.7000000000000002E-3</c:v>
                </c:pt>
                <c:pt idx="286">
                  <c:v>4.5999999999999999E-3</c:v>
                </c:pt>
                <c:pt idx="287">
                  <c:v>4.4999999999999997E-3</c:v>
                </c:pt>
                <c:pt idx="288">
                  <c:v>4.4999999999999997E-3</c:v>
                </c:pt>
                <c:pt idx="289">
                  <c:v>4.3E-3</c:v>
                </c:pt>
                <c:pt idx="290">
                  <c:v>4.4000000000000003E-3</c:v>
                </c:pt>
                <c:pt idx="291">
                  <c:v>4.4000000000000003E-3</c:v>
                </c:pt>
                <c:pt idx="292">
                  <c:v>4.3E-3</c:v>
                </c:pt>
                <c:pt idx="293">
                  <c:v>4.1999999999999997E-3</c:v>
                </c:pt>
                <c:pt idx="294">
                  <c:v>4.1000000000000003E-3</c:v>
                </c:pt>
                <c:pt idx="295">
                  <c:v>4.1999999999999997E-3</c:v>
                </c:pt>
                <c:pt idx="296">
                  <c:v>4.0000000000000001E-3</c:v>
                </c:pt>
                <c:pt idx="297">
                  <c:v>3.8999999999999998E-3</c:v>
                </c:pt>
                <c:pt idx="298">
                  <c:v>4.0000000000000001E-3</c:v>
                </c:pt>
                <c:pt idx="299">
                  <c:v>4.0000000000000001E-3</c:v>
                </c:pt>
                <c:pt idx="300">
                  <c:v>4.0000000000000001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352-451B-800B-91FCC03F4A18}"/>
            </c:ext>
          </c:extLst>
        </c:ser>
        <c:ser>
          <c:idx val="1"/>
          <c:order val="1"/>
          <c:tx>
            <c:strRef>
              <c:f>Sheet1!$AC$2</c:f>
              <c:strCache>
                <c:ptCount val="1"/>
                <c:pt idx="0">
                  <c:v>24 h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AA$3:$AA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AC$3:$AC$303</c:f>
              <c:numCache>
                <c:formatCode>General</c:formatCode>
                <c:ptCount val="301"/>
                <c:pt idx="0">
                  <c:v>0.90910000000000002</c:v>
                </c:pt>
                <c:pt idx="1">
                  <c:v>0.88460000000000005</c:v>
                </c:pt>
                <c:pt idx="2">
                  <c:v>0.86729999999999996</c:v>
                </c:pt>
                <c:pt idx="3">
                  <c:v>0.85309999999999997</c:v>
                </c:pt>
                <c:pt idx="4">
                  <c:v>0.83960000000000001</c:v>
                </c:pt>
                <c:pt idx="5">
                  <c:v>0.8256</c:v>
                </c:pt>
                <c:pt idx="6">
                  <c:v>0.81179999999999997</c:v>
                </c:pt>
                <c:pt idx="7">
                  <c:v>0.79749999999999999</c:v>
                </c:pt>
                <c:pt idx="8">
                  <c:v>0.78390000000000004</c:v>
                </c:pt>
                <c:pt idx="9">
                  <c:v>0.7702</c:v>
                </c:pt>
                <c:pt idx="10">
                  <c:v>0.75649999999999995</c:v>
                </c:pt>
                <c:pt idx="11">
                  <c:v>0.74209999999999998</c:v>
                </c:pt>
                <c:pt idx="12">
                  <c:v>0.72750000000000004</c:v>
                </c:pt>
                <c:pt idx="13">
                  <c:v>0.71299999999999997</c:v>
                </c:pt>
                <c:pt idx="14">
                  <c:v>0.69879999999999998</c:v>
                </c:pt>
                <c:pt idx="15">
                  <c:v>0.68510000000000004</c:v>
                </c:pt>
                <c:pt idx="16">
                  <c:v>0.67259999999999998</c:v>
                </c:pt>
                <c:pt idx="17">
                  <c:v>0.6623</c:v>
                </c:pt>
                <c:pt idx="18">
                  <c:v>0.65469999999999995</c:v>
                </c:pt>
                <c:pt idx="19">
                  <c:v>0.64970000000000006</c:v>
                </c:pt>
                <c:pt idx="20">
                  <c:v>0.64770000000000005</c:v>
                </c:pt>
                <c:pt idx="21">
                  <c:v>0.64870000000000005</c:v>
                </c:pt>
                <c:pt idx="22">
                  <c:v>0.65229999999999999</c:v>
                </c:pt>
                <c:pt idx="23">
                  <c:v>0.65900000000000003</c:v>
                </c:pt>
                <c:pt idx="24">
                  <c:v>0.66859999999999997</c:v>
                </c:pt>
                <c:pt idx="25">
                  <c:v>0.68089999999999995</c:v>
                </c:pt>
                <c:pt idx="26">
                  <c:v>0.69540000000000002</c:v>
                </c:pt>
                <c:pt idx="27">
                  <c:v>0.71120000000000005</c:v>
                </c:pt>
                <c:pt idx="28">
                  <c:v>0.72850000000000004</c:v>
                </c:pt>
                <c:pt idx="29">
                  <c:v>0.74560000000000004</c:v>
                </c:pt>
                <c:pt idx="30">
                  <c:v>0.76200000000000001</c:v>
                </c:pt>
                <c:pt idx="31">
                  <c:v>0.7772</c:v>
                </c:pt>
                <c:pt idx="32">
                  <c:v>0.78949999999999998</c:v>
                </c:pt>
                <c:pt idx="33">
                  <c:v>0.79900000000000004</c:v>
                </c:pt>
                <c:pt idx="34">
                  <c:v>0.80420000000000003</c:v>
                </c:pt>
                <c:pt idx="35">
                  <c:v>0.80479999999999996</c:v>
                </c:pt>
                <c:pt idx="36">
                  <c:v>0.80210000000000004</c:v>
                </c:pt>
                <c:pt idx="37">
                  <c:v>0.79569999999999996</c:v>
                </c:pt>
                <c:pt idx="38">
                  <c:v>0.78590000000000004</c:v>
                </c:pt>
                <c:pt idx="39">
                  <c:v>0.7742</c:v>
                </c:pt>
                <c:pt idx="40">
                  <c:v>0.75949999999999995</c:v>
                </c:pt>
                <c:pt idx="41">
                  <c:v>0.74209999999999998</c:v>
                </c:pt>
                <c:pt idx="42">
                  <c:v>0.72250000000000003</c:v>
                </c:pt>
                <c:pt idx="43">
                  <c:v>0.70040000000000002</c:v>
                </c:pt>
                <c:pt idx="44">
                  <c:v>0.67730000000000001</c:v>
                </c:pt>
                <c:pt idx="45">
                  <c:v>0.65180000000000005</c:v>
                </c:pt>
                <c:pt idx="46">
                  <c:v>0.62339999999999995</c:v>
                </c:pt>
                <c:pt idx="47">
                  <c:v>0.59289999999999998</c:v>
                </c:pt>
                <c:pt idx="48">
                  <c:v>0.56000000000000005</c:v>
                </c:pt>
                <c:pt idx="49">
                  <c:v>0.52539999999999998</c:v>
                </c:pt>
                <c:pt idx="50">
                  <c:v>0.48959999999999998</c:v>
                </c:pt>
                <c:pt idx="51">
                  <c:v>0.4546</c:v>
                </c:pt>
                <c:pt idx="52">
                  <c:v>0.42130000000000001</c:v>
                </c:pt>
                <c:pt idx="53">
                  <c:v>0.39090000000000003</c:v>
                </c:pt>
                <c:pt idx="54">
                  <c:v>0.36480000000000001</c:v>
                </c:pt>
                <c:pt idx="55">
                  <c:v>0.34370000000000001</c:v>
                </c:pt>
                <c:pt idx="56">
                  <c:v>0.32640000000000002</c:v>
                </c:pt>
                <c:pt idx="57">
                  <c:v>0.31259999999999999</c:v>
                </c:pt>
                <c:pt idx="58">
                  <c:v>0.30099999999999999</c:v>
                </c:pt>
                <c:pt idx="59">
                  <c:v>0.29199999999999998</c:v>
                </c:pt>
                <c:pt idx="60">
                  <c:v>0.28470000000000001</c:v>
                </c:pt>
                <c:pt idx="61">
                  <c:v>0.27889999999999998</c:v>
                </c:pt>
                <c:pt idx="62">
                  <c:v>0.27439999999999998</c:v>
                </c:pt>
                <c:pt idx="63">
                  <c:v>0.27139999999999997</c:v>
                </c:pt>
                <c:pt idx="64">
                  <c:v>0.2697</c:v>
                </c:pt>
                <c:pt idx="65">
                  <c:v>0.26889999999999997</c:v>
                </c:pt>
                <c:pt idx="66">
                  <c:v>0.26879999999999998</c:v>
                </c:pt>
                <c:pt idx="67">
                  <c:v>0.26950000000000002</c:v>
                </c:pt>
                <c:pt idx="68">
                  <c:v>0.27129999999999999</c:v>
                </c:pt>
                <c:pt idx="69">
                  <c:v>0.27389999999999998</c:v>
                </c:pt>
                <c:pt idx="70">
                  <c:v>0.27710000000000001</c:v>
                </c:pt>
                <c:pt idx="71">
                  <c:v>0.28120000000000001</c:v>
                </c:pt>
                <c:pt idx="72">
                  <c:v>0.28589999999999999</c:v>
                </c:pt>
                <c:pt idx="73">
                  <c:v>0.29170000000000001</c:v>
                </c:pt>
                <c:pt idx="74">
                  <c:v>0.29799999999999999</c:v>
                </c:pt>
                <c:pt idx="75">
                  <c:v>0.30559999999999998</c:v>
                </c:pt>
                <c:pt idx="76">
                  <c:v>0.31380000000000002</c:v>
                </c:pt>
                <c:pt idx="77">
                  <c:v>0.32319999999999999</c:v>
                </c:pt>
                <c:pt idx="78">
                  <c:v>0.33329999999999999</c:v>
                </c:pt>
                <c:pt idx="79">
                  <c:v>0.34460000000000002</c:v>
                </c:pt>
                <c:pt idx="80">
                  <c:v>0.35720000000000002</c:v>
                </c:pt>
                <c:pt idx="81">
                  <c:v>0.36990000000000001</c:v>
                </c:pt>
                <c:pt idx="82">
                  <c:v>0.38369999999999999</c:v>
                </c:pt>
                <c:pt idx="83">
                  <c:v>0.39860000000000001</c:v>
                </c:pt>
                <c:pt idx="84">
                  <c:v>0.41399999999999998</c:v>
                </c:pt>
                <c:pt idx="85">
                  <c:v>0.42970000000000003</c:v>
                </c:pt>
                <c:pt idx="86">
                  <c:v>0.4466</c:v>
                </c:pt>
                <c:pt idx="87">
                  <c:v>0.46379999999999999</c:v>
                </c:pt>
                <c:pt idx="88">
                  <c:v>0.48039999999999999</c:v>
                </c:pt>
                <c:pt idx="89">
                  <c:v>0.49830000000000002</c:v>
                </c:pt>
                <c:pt idx="90">
                  <c:v>0.51529999999999998</c:v>
                </c:pt>
                <c:pt idx="91">
                  <c:v>0.53139999999999998</c:v>
                </c:pt>
                <c:pt idx="92">
                  <c:v>0.54810000000000003</c:v>
                </c:pt>
                <c:pt idx="93">
                  <c:v>0.56440000000000001</c:v>
                </c:pt>
                <c:pt idx="94">
                  <c:v>0.57989999999999997</c:v>
                </c:pt>
                <c:pt idx="95">
                  <c:v>0.59460000000000002</c:v>
                </c:pt>
                <c:pt idx="96">
                  <c:v>0.60729999999999995</c:v>
                </c:pt>
                <c:pt idx="97">
                  <c:v>0.61870000000000003</c:v>
                </c:pt>
                <c:pt idx="98">
                  <c:v>0.62749999999999995</c:v>
                </c:pt>
                <c:pt idx="99">
                  <c:v>0.63419999999999999</c:v>
                </c:pt>
                <c:pt idx="100">
                  <c:v>0.63800000000000001</c:v>
                </c:pt>
                <c:pt idx="101">
                  <c:v>0.63890000000000002</c:v>
                </c:pt>
                <c:pt idx="102">
                  <c:v>0.63660000000000005</c:v>
                </c:pt>
                <c:pt idx="103">
                  <c:v>0.63109999999999999</c:v>
                </c:pt>
                <c:pt idx="104">
                  <c:v>0.622</c:v>
                </c:pt>
                <c:pt idx="105">
                  <c:v>0.6099</c:v>
                </c:pt>
                <c:pt idx="106">
                  <c:v>0.59470000000000001</c:v>
                </c:pt>
                <c:pt idx="107">
                  <c:v>0.5766</c:v>
                </c:pt>
                <c:pt idx="108">
                  <c:v>0.55549999999999999</c:v>
                </c:pt>
                <c:pt idx="109">
                  <c:v>0.53239999999999998</c:v>
                </c:pt>
                <c:pt idx="110">
                  <c:v>0.50770000000000004</c:v>
                </c:pt>
                <c:pt idx="111">
                  <c:v>0.48180000000000001</c:v>
                </c:pt>
                <c:pt idx="112">
                  <c:v>0.45490000000000003</c:v>
                </c:pt>
                <c:pt idx="113">
                  <c:v>0.4279</c:v>
                </c:pt>
                <c:pt idx="114">
                  <c:v>0.40100000000000002</c:v>
                </c:pt>
                <c:pt idx="115">
                  <c:v>0.37469999999999998</c:v>
                </c:pt>
                <c:pt idx="116">
                  <c:v>0.34899999999999998</c:v>
                </c:pt>
                <c:pt idx="117">
                  <c:v>0.32469999999999999</c:v>
                </c:pt>
                <c:pt idx="118">
                  <c:v>0.30130000000000001</c:v>
                </c:pt>
                <c:pt idx="119">
                  <c:v>0.27979999999999999</c:v>
                </c:pt>
                <c:pt idx="120">
                  <c:v>0.25979999999999998</c:v>
                </c:pt>
                <c:pt idx="121">
                  <c:v>0.2412</c:v>
                </c:pt>
                <c:pt idx="122">
                  <c:v>0.2238</c:v>
                </c:pt>
                <c:pt idx="123">
                  <c:v>0.2079</c:v>
                </c:pt>
                <c:pt idx="124">
                  <c:v>0.19339999999999999</c:v>
                </c:pt>
                <c:pt idx="125">
                  <c:v>0.18</c:v>
                </c:pt>
                <c:pt idx="126">
                  <c:v>0.16789999999999999</c:v>
                </c:pt>
                <c:pt idx="127">
                  <c:v>0.15679999999999999</c:v>
                </c:pt>
                <c:pt idx="128">
                  <c:v>0.14680000000000001</c:v>
                </c:pt>
                <c:pt idx="129">
                  <c:v>0.13800000000000001</c:v>
                </c:pt>
                <c:pt idx="130">
                  <c:v>0.1295</c:v>
                </c:pt>
                <c:pt idx="131">
                  <c:v>0.1222</c:v>
                </c:pt>
                <c:pt idx="132">
                  <c:v>0.11509999999999999</c:v>
                </c:pt>
                <c:pt idx="133">
                  <c:v>0.1087</c:v>
                </c:pt>
                <c:pt idx="134">
                  <c:v>0.10299999999999999</c:v>
                </c:pt>
                <c:pt idx="135">
                  <c:v>9.7900000000000001E-2</c:v>
                </c:pt>
                <c:pt idx="136">
                  <c:v>9.2999999999999999E-2</c:v>
                </c:pt>
                <c:pt idx="137">
                  <c:v>8.8700000000000001E-2</c:v>
                </c:pt>
                <c:pt idx="138">
                  <c:v>8.4599999999999995E-2</c:v>
                </c:pt>
                <c:pt idx="139">
                  <c:v>8.0799999999999997E-2</c:v>
                </c:pt>
                <c:pt idx="140">
                  <c:v>7.7399999999999997E-2</c:v>
                </c:pt>
                <c:pt idx="141">
                  <c:v>7.4200000000000002E-2</c:v>
                </c:pt>
                <c:pt idx="142">
                  <c:v>7.1199999999999999E-2</c:v>
                </c:pt>
                <c:pt idx="143">
                  <c:v>6.8400000000000002E-2</c:v>
                </c:pt>
                <c:pt idx="144">
                  <c:v>6.59E-2</c:v>
                </c:pt>
                <c:pt idx="145">
                  <c:v>6.3600000000000004E-2</c:v>
                </c:pt>
                <c:pt idx="146">
                  <c:v>6.13E-2</c:v>
                </c:pt>
                <c:pt idx="147">
                  <c:v>5.9299999999999999E-2</c:v>
                </c:pt>
                <c:pt idx="148">
                  <c:v>5.7299999999999997E-2</c:v>
                </c:pt>
                <c:pt idx="149">
                  <c:v>5.5500000000000001E-2</c:v>
                </c:pt>
                <c:pt idx="150">
                  <c:v>5.3699999999999998E-2</c:v>
                </c:pt>
                <c:pt idx="151">
                  <c:v>5.2200000000000003E-2</c:v>
                </c:pt>
                <c:pt idx="152">
                  <c:v>5.0599999999999999E-2</c:v>
                </c:pt>
                <c:pt idx="153">
                  <c:v>4.8899999999999999E-2</c:v>
                </c:pt>
                <c:pt idx="154">
                  <c:v>4.7600000000000003E-2</c:v>
                </c:pt>
                <c:pt idx="155">
                  <c:v>4.6300000000000001E-2</c:v>
                </c:pt>
                <c:pt idx="156">
                  <c:v>4.4900000000000002E-2</c:v>
                </c:pt>
                <c:pt idx="157">
                  <c:v>4.3700000000000003E-2</c:v>
                </c:pt>
                <c:pt idx="158">
                  <c:v>4.2599999999999999E-2</c:v>
                </c:pt>
                <c:pt idx="159">
                  <c:v>4.1599999999999998E-2</c:v>
                </c:pt>
                <c:pt idx="160">
                  <c:v>4.0399999999999998E-2</c:v>
                </c:pt>
                <c:pt idx="161">
                  <c:v>3.95E-2</c:v>
                </c:pt>
                <c:pt idx="162">
                  <c:v>3.85E-2</c:v>
                </c:pt>
                <c:pt idx="163">
                  <c:v>3.7600000000000001E-2</c:v>
                </c:pt>
                <c:pt idx="164">
                  <c:v>3.6600000000000001E-2</c:v>
                </c:pt>
                <c:pt idx="165">
                  <c:v>3.5799999999999998E-2</c:v>
                </c:pt>
                <c:pt idx="166">
                  <c:v>3.5000000000000003E-2</c:v>
                </c:pt>
                <c:pt idx="167">
                  <c:v>3.4200000000000001E-2</c:v>
                </c:pt>
                <c:pt idx="168">
                  <c:v>3.3500000000000002E-2</c:v>
                </c:pt>
                <c:pt idx="169">
                  <c:v>3.27E-2</c:v>
                </c:pt>
                <c:pt idx="170">
                  <c:v>3.2000000000000001E-2</c:v>
                </c:pt>
                <c:pt idx="171">
                  <c:v>3.1199999999999999E-2</c:v>
                </c:pt>
                <c:pt idx="172">
                  <c:v>3.0499999999999999E-2</c:v>
                </c:pt>
                <c:pt idx="173">
                  <c:v>2.9899999999999999E-2</c:v>
                </c:pt>
                <c:pt idx="174">
                  <c:v>2.93E-2</c:v>
                </c:pt>
                <c:pt idx="175">
                  <c:v>2.87E-2</c:v>
                </c:pt>
                <c:pt idx="176">
                  <c:v>2.81E-2</c:v>
                </c:pt>
                <c:pt idx="177">
                  <c:v>2.76E-2</c:v>
                </c:pt>
                <c:pt idx="178">
                  <c:v>2.7099999999999999E-2</c:v>
                </c:pt>
                <c:pt idx="179">
                  <c:v>2.6499999999999999E-2</c:v>
                </c:pt>
                <c:pt idx="180">
                  <c:v>2.5899999999999999E-2</c:v>
                </c:pt>
                <c:pt idx="181">
                  <c:v>2.53E-2</c:v>
                </c:pt>
                <c:pt idx="182">
                  <c:v>2.4799999999999999E-2</c:v>
                </c:pt>
                <c:pt idx="183">
                  <c:v>2.4299999999999999E-2</c:v>
                </c:pt>
                <c:pt idx="184">
                  <c:v>2.3800000000000002E-2</c:v>
                </c:pt>
                <c:pt idx="185">
                  <c:v>2.3400000000000001E-2</c:v>
                </c:pt>
                <c:pt idx="186">
                  <c:v>2.3E-2</c:v>
                </c:pt>
                <c:pt idx="187">
                  <c:v>2.24E-2</c:v>
                </c:pt>
                <c:pt idx="188">
                  <c:v>2.2100000000000002E-2</c:v>
                </c:pt>
                <c:pt idx="189">
                  <c:v>2.1700000000000001E-2</c:v>
                </c:pt>
                <c:pt idx="190">
                  <c:v>2.1299999999999999E-2</c:v>
                </c:pt>
                <c:pt idx="191">
                  <c:v>2.0799999999999999E-2</c:v>
                </c:pt>
                <c:pt idx="192">
                  <c:v>2.0500000000000001E-2</c:v>
                </c:pt>
                <c:pt idx="193">
                  <c:v>2.01E-2</c:v>
                </c:pt>
                <c:pt idx="194">
                  <c:v>1.9699999999999999E-2</c:v>
                </c:pt>
                <c:pt idx="195">
                  <c:v>1.9400000000000001E-2</c:v>
                </c:pt>
                <c:pt idx="196">
                  <c:v>1.9E-2</c:v>
                </c:pt>
                <c:pt idx="197">
                  <c:v>1.8599999999999998E-2</c:v>
                </c:pt>
                <c:pt idx="198">
                  <c:v>1.8200000000000001E-2</c:v>
                </c:pt>
                <c:pt idx="199">
                  <c:v>1.7899999999999999E-2</c:v>
                </c:pt>
                <c:pt idx="200">
                  <c:v>1.7600000000000001E-2</c:v>
                </c:pt>
                <c:pt idx="201">
                  <c:v>1.7299999999999999E-2</c:v>
                </c:pt>
                <c:pt idx="202">
                  <c:v>1.6899999999999998E-2</c:v>
                </c:pt>
                <c:pt idx="203">
                  <c:v>1.6500000000000001E-2</c:v>
                </c:pt>
                <c:pt idx="204">
                  <c:v>1.6400000000000001E-2</c:v>
                </c:pt>
                <c:pt idx="205">
                  <c:v>1.6E-2</c:v>
                </c:pt>
                <c:pt idx="206">
                  <c:v>1.5699999999999999E-2</c:v>
                </c:pt>
                <c:pt idx="207">
                  <c:v>1.54E-2</c:v>
                </c:pt>
                <c:pt idx="208">
                  <c:v>1.5100000000000001E-2</c:v>
                </c:pt>
                <c:pt idx="209">
                  <c:v>1.49E-2</c:v>
                </c:pt>
                <c:pt idx="210">
                  <c:v>1.46E-2</c:v>
                </c:pt>
                <c:pt idx="211">
                  <c:v>1.43E-2</c:v>
                </c:pt>
                <c:pt idx="212">
                  <c:v>1.4E-2</c:v>
                </c:pt>
                <c:pt idx="213">
                  <c:v>1.38E-2</c:v>
                </c:pt>
                <c:pt idx="214">
                  <c:v>1.35E-2</c:v>
                </c:pt>
                <c:pt idx="215">
                  <c:v>1.32E-2</c:v>
                </c:pt>
                <c:pt idx="216">
                  <c:v>1.2999999999999999E-2</c:v>
                </c:pt>
                <c:pt idx="217">
                  <c:v>1.2800000000000001E-2</c:v>
                </c:pt>
                <c:pt idx="218">
                  <c:v>1.2500000000000001E-2</c:v>
                </c:pt>
                <c:pt idx="219">
                  <c:v>1.23E-2</c:v>
                </c:pt>
                <c:pt idx="220">
                  <c:v>1.2200000000000001E-2</c:v>
                </c:pt>
                <c:pt idx="221">
                  <c:v>1.18E-2</c:v>
                </c:pt>
                <c:pt idx="222">
                  <c:v>1.17E-2</c:v>
                </c:pt>
                <c:pt idx="223">
                  <c:v>1.14E-2</c:v>
                </c:pt>
                <c:pt idx="224">
                  <c:v>1.12E-2</c:v>
                </c:pt>
                <c:pt idx="225">
                  <c:v>1.09E-2</c:v>
                </c:pt>
                <c:pt idx="226">
                  <c:v>1.0800000000000001E-2</c:v>
                </c:pt>
                <c:pt idx="227">
                  <c:v>1.0500000000000001E-2</c:v>
                </c:pt>
                <c:pt idx="228">
                  <c:v>1.04E-2</c:v>
                </c:pt>
                <c:pt idx="229">
                  <c:v>1.01E-2</c:v>
                </c:pt>
                <c:pt idx="230">
                  <c:v>0.01</c:v>
                </c:pt>
                <c:pt idx="231">
                  <c:v>9.7999999999999997E-3</c:v>
                </c:pt>
                <c:pt idx="232">
                  <c:v>9.5999999999999992E-3</c:v>
                </c:pt>
                <c:pt idx="233">
                  <c:v>9.5999999999999992E-3</c:v>
                </c:pt>
                <c:pt idx="234">
                  <c:v>9.2999999999999992E-3</c:v>
                </c:pt>
                <c:pt idx="235">
                  <c:v>9.1000000000000004E-3</c:v>
                </c:pt>
                <c:pt idx="236">
                  <c:v>8.9999999999999993E-3</c:v>
                </c:pt>
                <c:pt idx="237">
                  <c:v>8.8000000000000005E-3</c:v>
                </c:pt>
                <c:pt idx="238">
                  <c:v>8.6999999999999994E-3</c:v>
                </c:pt>
                <c:pt idx="239">
                  <c:v>8.3999999999999995E-3</c:v>
                </c:pt>
                <c:pt idx="240">
                  <c:v>8.3000000000000001E-3</c:v>
                </c:pt>
                <c:pt idx="241">
                  <c:v>8.2000000000000007E-3</c:v>
                </c:pt>
                <c:pt idx="242">
                  <c:v>7.9000000000000008E-3</c:v>
                </c:pt>
                <c:pt idx="243">
                  <c:v>7.7999999999999996E-3</c:v>
                </c:pt>
                <c:pt idx="244">
                  <c:v>7.7000000000000002E-3</c:v>
                </c:pt>
                <c:pt idx="245">
                  <c:v>7.6E-3</c:v>
                </c:pt>
                <c:pt idx="246">
                  <c:v>7.4000000000000003E-3</c:v>
                </c:pt>
                <c:pt idx="247">
                  <c:v>7.1999999999999998E-3</c:v>
                </c:pt>
                <c:pt idx="248">
                  <c:v>7.1999999999999998E-3</c:v>
                </c:pt>
                <c:pt idx="249">
                  <c:v>7.0000000000000001E-3</c:v>
                </c:pt>
                <c:pt idx="250">
                  <c:v>6.8999999999999999E-3</c:v>
                </c:pt>
                <c:pt idx="251">
                  <c:v>6.8999999999999999E-3</c:v>
                </c:pt>
                <c:pt idx="252">
                  <c:v>6.7000000000000002E-3</c:v>
                </c:pt>
                <c:pt idx="253">
                  <c:v>6.4999999999999997E-3</c:v>
                </c:pt>
                <c:pt idx="254">
                  <c:v>6.4999999999999997E-3</c:v>
                </c:pt>
                <c:pt idx="255">
                  <c:v>6.3E-3</c:v>
                </c:pt>
                <c:pt idx="256">
                  <c:v>6.1999999999999998E-3</c:v>
                </c:pt>
                <c:pt idx="257">
                  <c:v>6.0000000000000001E-3</c:v>
                </c:pt>
                <c:pt idx="258">
                  <c:v>6.0000000000000001E-3</c:v>
                </c:pt>
                <c:pt idx="259">
                  <c:v>6.0000000000000001E-3</c:v>
                </c:pt>
                <c:pt idx="260">
                  <c:v>5.7000000000000002E-3</c:v>
                </c:pt>
                <c:pt idx="261">
                  <c:v>5.7000000000000002E-3</c:v>
                </c:pt>
                <c:pt idx="262">
                  <c:v>5.5999999999999999E-3</c:v>
                </c:pt>
                <c:pt idx="263">
                  <c:v>5.4999999999999997E-3</c:v>
                </c:pt>
                <c:pt idx="264">
                  <c:v>5.4000000000000003E-3</c:v>
                </c:pt>
                <c:pt idx="265">
                  <c:v>5.4000000000000003E-3</c:v>
                </c:pt>
                <c:pt idx="266">
                  <c:v>5.3E-3</c:v>
                </c:pt>
                <c:pt idx="267">
                  <c:v>5.1999999999999998E-3</c:v>
                </c:pt>
                <c:pt idx="268">
                  <c:v>5.1000000000000004E-3</c:v>
                </c:pt>
                <c:pt idx="269">
                  <c:v>5.0000000000000001E-3</c:v>
                </c:pt>
                <c:pt idx="270">
                  <c:v>4.8999999999999998E-3</c:v>
                </c:pt>
                <c:pt idx="271">
                  <c:v>4.7999999999999996E-3</c:v>
                </c:pt>
                <c:pt idx="272">
                  <c:v>4.7999999999999996E-3</c:v>
                </c:pt>
                <c:pt idx="273">
                  <c:v>4.7999999999999996E-3</c:v>
                </c:pt>
                <c:pt idx="274">
                  <c:v>4.5999999999999999E-3</c:v>
                </c:pt>
                <c:pt idx="275">
                  <c:v>4.5999999999999999E-3</c:v>
                </c:pt>
                <c:pt idx="276">
                  <c:v>4.4999999999999997E-3</c:v>
                </c:pt>
                <c:pt idx="277">
                  <c:v>4.3E-3</c:v>
                </c:pt>
                <c:pt idx="278">
                  <c:v>4.3E-3</c:v>
                </c:pt>
                <c:pt idx="279">
                  <c:v>4.1999999999999997E-3</c:v>
                </c:pt>
                <c:pt idx="280">
                  <c:v>4.1999999999999997E-3</c:v>
                </c:pt>
                <c:pt idx="281">
                  <c:v>4.1000000000000003E-3</c:v>
                </c:pt>
                <c:pt idx="282">
                  <c:v>4.1000000000000003E-3</c:v>
                </c:pt>
                <c:pt idx="283">
                  <c:v>4.0000000000000001E-3</c:v>
                </c:pt>
                <c:pt idx="284">
                  <c:v>3.8999999999999998E-3</c:v>
                </c:pt>
                <c:pt idx="285">
                  <c:v>3.8999999999999998E-3</c:v>
                </c:pt>
                <c:pt idx="286">
                  <c:v>3.8E-3</c:v>
                </c:pt>
                <c:pt idx="287">
                  <c:v>3.7000000000000002E-3</c:v>
                </c:pt>
                <c:pt idx="288">
                  <c:v>3.8E-3</c:v>
                </c:pt>
                <c:pt idx="289">
                  <c:v>3.5999999999999999E-3</c:v>
                </c:pt>
                <c:pt idx="290">
                  <c:v>3.5999999999999999E-3</c:v>
                </c:pt>
                <c:pt idx="291">
                  <c:v>3.5999999999999999E-3</c:v>
                </c:pt>
                <c:pt idx="292">
                  <c:v>3.3999999999999998E-3</c:v>
                </c:pt>
                <c:pt idx="293">
                  <c:v>3.5000000000000001E-3</c:v>
                </c:pt>
                <c:pt idx="294">
                  <c:v>3.3999999999999998E-3</c:v>
                </c:pt>
                <c:pt idx="295">
                  <c:v>3.5000000000000001E-3</c:v>
                </c:pt>
                <c:pt idx="296">
                  <c:v>3.3999999999999998E-3</c:v>
                </c:pt>
                <c:pt idx="297">
                  <c:v>3.2000000000000002E-3</c:v>
                </c:pt>
                <c:pt idx="298">
                  <c:v>3.3999999999999998E-3</c:v>
                </c:pt>
                <c:pt idx="299">
                  <c:v>3.0999999999999999E-3</c:v>
                </c:pt>
                <c:pt idx="300">
                  <c:v>3.2000000000000002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352-451B-800B-91FCC03F4A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5374720"/>
        <c:axId val="135380992"/>
      </c:scatterChart>
      <c:valAx>
        <c:axId val="135374720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Wavelength (n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5380992"/>
        <c:crosses val="autoZero"/>
        <c:crossBetween val="midCat"/>
      </c:valAx>
      <c:valAx>
        <c:axId val="135380992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Absorbance</a:t>
                </a:r>
              </a:p>
            </c:rich>
          </c:tx>
          <c:layout>
            <c:manualLayout>
              <c:xMode val="edge"/>
              <c:yMode val="edge"/>
              <c:x val="1.9285134812693869E-2"/>
              <c:y val="0.275387701537307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5374720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61121460649019699"/>
          <c:y val="5.7790432445944256E-2"/>
          <c:w val="0.30423412510026682"/>
          <c:h val="0.197840894888139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200"/>
            </a:pPr>
            <a:r>
              <a:rPr lang="en-AU"/>
              <a:t>C_AgNP_Water</a:t>
            </a:r>
          </a:p>
        </c:rich>
      </c:tx>
      <c:layout>
        <c:manualLayout>
          <c:xMode val="edge"/>
          <c:yMode val="edge"/>
          <c:x val="0.35331577083363658"/>
          <c:y val="6.970237473631446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516099123973141"/>
          <c:y val="5.1400554097404488E-2"/>
          <c:w val="0.78808576200702185"/>
          <c:h val="0.7432125984251967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S$2</c:f>
              <c:strCache>
                <c:ptCount val="1"/>
                <c:pt idx="0">
                  <c:v>0 h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none"/>
          </c:marker>
          <c:xVal>
            <c:numRef>
              <c:f>Sheet1!$AR$3:$AR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AS$3:$AS$303</c:f>
              <c:numCache>
                <c:formatCode>General</c:formatCode>
                <c:ptCount val="301"/>
                <c:pt idx="0">
                  <c:v>1.6114999999999999</c:v>
                </c:pt>
                <c:pt idx="1">
                  <c:v>1.5692999999999999</c:v>
                </c:pt>
                <c:pt idx="2">
                  <c:v>1.5161</c:v>
                </c:pt>
                <c:pt idx="3">
                  <c:v>1.4534</c:v>
                </c:pt>
                <c:pt idx="4">
                  <c:v>1.3877999999999999</c:v>
                </c:pt>
                <c:pt idx="5">
                  <c:v>1.3229</c:v>
                </c:pt>
                <c:pt idx="6">
                  <c:v>1.2626999999999999</c:v>
                </c:pt>
                <c:pt idx="7">
                  <c:v>1.2092000000000001</c:v>
                </c:pt>
                <c:pt idx="8">
                  <c:v>1.163</c:v>
                </c:pt>
                <c:pt idx="9">
                  <c:v>1.1229</c:v>
                </c:pt>
                <c:pt idx="10">
                  <c:v>1.0875999999999999</c:v>
                </c:pt>
                <c:pt idx="11">
                  <c:v>1.0577000000000001</c:v>
                </c:pt>
                <c:pt idx="12">
                  <c:v>1.0319</c:v>
                </c:pt>
                <c:pt idx="13">
                  <c:v>1.0087999999999999</c:v>
                </c:pt>
                <c:pt idx="14">
                  <c:v>0.98760000000000003</c:v>
                </c:pt>
                <c:pt idx="15">
                  <c:v>0.96679999999999999</c:v>
                </c:pt>
                <c:pt idx="16">
                  <c:v>0.94620000000000004</c:v>
                </c:pt>
                <c:pt idx="17">
                  <c:v>0.92579999999999996</c:v>
                </c:pt>
                <c:pt idx="18">
                  <c:v>0.90659999999999996</c:v>
                </c:pt>
                <c:pt idx="19">
                  <c:v>0.8881</c:v>
                </c:pt>
                <c:pt idx="20">
                  <c:v>0.87160000000000004</c:v>
                </c:pt>
                <c:pt idx="21">
                  <c:v>0.85709999999999997</c:v>
                </c:pt>
                <c:pt idx="22">
                  <c:v>0.8448</c:v>
                </c:pt>
                <c:pt idx="23">
                  <c:v>0.83499999999999996</c:v>
                </c:pt>
                <c:pt idx="24">
                  <c:v>0.82720000000000005</c:v>
                </c:pt>
                <c:pt idx="25">
                  <c:v>0.82079999999999997</c:v>
                </c:pt>
                <c:pt idx="26">
                  <c:v>0.81479999999999997</c:v>
                </c:pt>
                <c:pt idx="27">
                  <c:v>0.80900000000000005</c:v>
                </c:pt>
                <c:pt idx="28">
                  <c:v>0.80369999999999997</c:v>
                </c:pt>
                <c:pt idx="29">
                  <c:v>0.79830000000000001</c:v>
                </c:pt>
                <c:pt idx="30">
                  <c:v>0.79330000000000001</c:v>
                </c:pt>
                <c:pt idx="31">
                  <c:v>0.78849999999999998</c:v>
                </c:pt>
                <c:pt idx="32">
                  <c:v>0.78300000000000003</c:v>
                </c:pt>
                <c:pt idx="33">
                  <c:v>0.77600000000000002</c:v>
                </c:pt>
                <c:pt idx="34">
                  <c:v>0.7661</c:v>
                </c:pt>
                <c:pt idx="35">
                  <c:v>0.75319999999999998</c:v>
                </c:pt>
                <c:pt idx="36">
                  <c:v>0.73719999999999997</c:v>
                </c:pt>
                <c:pt idx="37">
                  <c:v>0.72060000000000002</c:v>
                </c:pt>
                <c:pt idx="38">
                  <c:v>0.7026</c:v>
                </c:pt>
                <c:pt idx="39">
                  <c:v>0.68410000000000004</c:v>
                </c:pt>
                <c:pt idx="40">
                  <c:v>0.66490000000000005</c:v>
                </c:pt>
                <c:pt idx="41">
                  <c:v>0.64510000000000001</c:v>
                </c:pt>
                <c:pt idx="42">
                  <c:v>0.62509999999999999</c:v>
                </c:pt>
                <c:pt idx="43">
                  <c:v>0.60429999999999995</c:v>
                </c:pt>
                <c:pt idx="44">
                  <c:v>0.58309999999999995</c:v>
                </c:pt>
                <c:pt idx="45">
                  <c:v>0.5615</c:v>
                </c:pt>
                <c:pt idx="46">
                  <c:v>0.54049999999999998</c:v>
                </c:pt>
                <c:pt idx="47">
                  <c:v>0.52039999999999997</c:v>
                </c:pt>
                <c:pt idx="48">
                  <c:v>0.50239999999999996</c:v>
                </c:pt>
                <c:pt idx="49">
                  <c:v>0.48649999999999999</c:v>
                </c:pt>
                <c:pt idx="50">
                  <c:v>0.47239999999999999</c:v>
                </c:pt>
                <c:pt idx="51">
                  <c:v>0.46129999999999999</c:v>
                </c:pt>
                <c:pt idx="52">
                  <c:v>0.45219999999999999</c:v>
                </c:pt>
                <c:pt idx="53">
                  <c:v>0.44569999999999999</c:v>
                </c:pt>
                <c:pt idx="54">
                  <c:v>0.44090000000000001</c:v>
                </c:pt>
                <c:pt idx="55">
                  <c:v>0.43790000000000001</c:v>
                </c:pt>
                <c:pt idx="56">
                  <c:v>0.43630000000000002</c:v>
                </c:pt>
                <c:pt idx="57">
                  <c:v>0.436</c:v>
                </c:pt>
                <c:pt idx="58">
                  <c:v>0.43719999999999998</c:v>
                </c:pt>
                <c:pt idx="59">
                  <c:v>0.439</c:v>
                </c:pt>
                <c:pt idx="60">
                  <c:v>0.44230000000000003</c:v>
                </c:pt>
                <c:pt idx="61">
                  <c:v>0.44550000000000001</c:v>
                </c:pt>
                <c:pt idx="62">
                  <c:v>0.44929999999999998</c:v>
                </c:pt>
                <c:pt idx="63">
                  <c:v>0.45350000000000001</c:v>
                </c:pt>
                <c:pt idx="64">
                  <c:v>0.45639999999999997</c:v>
                </c:pt>
                <c:pt idx="65">
                  <c:v>0.46079999999999999</c:v>
                </c:pt>
                <c:pt idx="66">
                  <c:v>0.4647</c:v>
                </c:pt>
                <c:pt idx="67">
                  <c:v>0.4677</c:v>
                </c:pt>
                <c:pt idx="68">
                  <c:v>0.4703</c:v>
                </c:pt>
                <c:pt idx="69">
                  <c:v>0.47239999999999999</c:v>
                </c:pt>
                <c:pt idx="70">
                  <c:v>0.47310000000000002</c:v>
                </c:pt>
                <c:pt idx="71">
                  <c:v>0.47370000000000001</c:v>
                </c:pt>
                <c:pt idx="72">
                  <c:v>0.4733</c:v>
                </c:pt>
                <c:pt idx="73">
                  <c:v>0.47289999999999999</c:v>
                </c:pt>
                <c:pt idx="74">
                  <c:v>0.47160000000000002</c:v>
                </c:pt>
                <c:pt idx="75">
                  <c:v>0.47020000000000001</c:v>
                </c:pt>
                <c:pt idx="76">
                  <c:v>0.46889999999999998</c:v>
                </c:pt>
                <c:pt idx="77">
                  <c:v>0.4672</c:v>
                </c:pt>
                <c:pt idx="78">
                  <c:v>0.46529999999999999</c:v>
                </c:pt>
                <c:pt idx="79">
                  <c:v>0.46379999999999999</c:v>
                </c:pt>
                <c:pt idx="80">
                  <c:v>0.46210000000000001</c:v>
                </c:pt>
                <c:pt idx="81">
                  <c:v>0.46100000000000002</c:v>
                </c:pt>
                <c:pt idx="82">
                  <c:v>0.4602</c:v>
                </c:pt>
                <c:pt idx="83">
                  <c:v>0.46129999999999999</c:v>
                </c:pt>
                <c:pt idx="84">
                  <c:v>0.46279999999999999</c:v>
                </c:pt>
                <c:pt idx="85">
                  <c:v>0.46589999999999998</c:v>
                </c:pt>
                <c:pt idx="86">
                  <c:v>0.47039999999999998</c:v>
                </c:pt>
                <c:pt idx="87">
                  <c:v>0.47639999999999999</c:v>
                </c:pt>
                <c:pt idx="88">
                  <c:v>0.48359999999999997</c:v>
                </c:pt>
                <c:pt idx="89">
                  <c:v>0.49340000000000001</c:v>
                </c:pt>
                <c:pt idx="90">
                  <c:v>0.50349999999999995</c:v>
                </c:pt>
                <c:pt idx="91">
                  <c:v>0.5161</c:v>
                </c:pt>
                <c:pt idx="92">
                  <c:v>0.52739999999999998</c:v>
                </c:pt>
                <c:pt idx="93">
                  <c:v>0.54169999999999996</c:v>
                </c:pt>
                <c:pt idx="94">
                  <c:v>0.55700000000000005</c:v>
                </c:pt>
                <c:pt idx="95">
                  <c:v>0.57289999999999996</c:v>
                </c:pt>
                <c:pt idx="96">
                  <c:v>0.58879999999999999</c:v>
                </c:pt>
                <c:pt idx="97">
                  <c:v>0.60489999999999999</c:v>
                </c:pt>
                <c:pt idx="98">
                  <c:v>0.62050000000000005</c:v>
                </c:pt>
                <c:pt idx="99">
                  <c:v>0.63570000000000004</c:v>
                </c:pt>
                <c:pt idx="100">
                  <c:v>0.64990000000000003</c:v>
                </c:pt>
                <c:pt idx="101">
                  <c:v>0.66300000000000003</c:v>
                </c:pt>
                <c:pt idx="102">
                  <c:v>0.67490000000000006</c:v>
                </c:pt>
                <c:pt idx="103">
                  <c:v>0.68489999999999995</c:v>
                </c:pt>
                <c:pt idx="104">
                  <c:v>0.69289999999999996</c:v>
                </c:pt>
                <c:pt idx="105">
                  <c:v>0.69889999999999997</c:v>
                </c:pt>
                <c:pt idx="106">
                  <c:v>0.70209999999999995</c:v>
                </c:pt>
                <c:pt idx="107">
                  <c:v>0.70269999999999999</c:v>
                </c:pt>
                <c:pt idx="108">
                  <c:v>0.70040000000000002</c:v>
                </c:pt>
                <c:pt idx="109">
                  <c:v>0.69479999999999997</c:v>
                </c:pt>
                <c:pt idx="110">
                  <c:v>0.68620000000000003</c:v>
                </c:pt>
                <c:pt idx="111">
                  <c:v>0.67479999999999996</c:v>
                </c:pt>
                <c:pt idx="112">
                  <c:v>0.65959999999999996</c:v>
                </c:pt>
                <c:pt idx="113">
                  <c:v>0.64159999999999995</c:v>
                </c:pt>
                <c:pt idx="114">
                  <c:v>0.62070000000000003</c:v>
                </c:pt>
                <c:pt idx="115">
                  <c:v>0.59709999999999996</c:v>
                </c:pt>
                <c:pt idx="116">
                  <c:v>0.57099999999999995</c:v>
                </c:pt>
                <c:pt idx="117">
                  <c:v>0.54330000000000001</c:v>
                </c:pt>
                <c:pt idx="118">
                  <c:v>0.5141</c:v>
                </c:pt>
                <c:pt idx="119">
                  <c:v>0.48430000000000001</c:v>
                </c:pt>
                <c:pt idx="120">
                  <c:v>0.45419999999999999</c:v>
                </c:pt>
                <c:pt idx="121">
                  <c:v>0.42430000000000001</c:v>
                </c:pt>
                <c:pt idx="122">
                  <c:v>0.39500000000000002</c:v>
                </c:pt>
                <c:pt idx="123">
                  <c:v>0.3669</c:v>
                </c:pt>
                <c:pt idx="124">
                  <c:v>0.34010000000000001</c:v>
                </c:pt>
                <c:pt idx="125">
                  <c:v>0.31519999999999998</c:v>
                </c:pt>
                <c:pt idx="126">
                  <c:v>0.29199999999999998</c:v>
                </c:pt>
                <c:pt idx="127">
                  <c:v>0.27079999999999999</c:v>
                </c:pt>
                <c:pt idx="128">
                  <c:v>0.25140000000000001</c:v>
                </c:pt>
                <c:pt idx="129">
                  <c:v>0.23369999999999999</c:v>
                </c:pt>
                <c:pt idx="130">
                  <c:v>0.2177</c:v>
                </c:pt>
                <c:pt idx="131">
                  <c:v>0.2031</c:v>
                </c:pt>
                <c:pt idx="132">
                  <c:v>0.18990000000000001</c:v>
                </c:pt>
                <c:pt idx="133">
                  <c:v>0.17780000000000001</c:v>
                </c:pt>
                <c:pt idx="134">
                  <c:v>0.16719999999999999</c:v>
                </c:pt>
                <c:pt idx="135">
                  <c:v>0.1573</c:v>
                </c:pt>
                <c:pt idx="136">
                  <c:v>0.14810000000000001</c:v>
                </c:pt>
                <c:pt idx="137">
                  <c:v>0.1404</c:v>
                </c:pt>
                <c:pt idx="138">
                  <c:v>0.1331</c:v>
                </c:pt>
                <c:pt idx="139">
                  <c:v>0.12640000000000001</c:v>
                </c:pt>
                <c:pt idx="140">
                  <c:v>0.1203</c:v>
                </c:pt>
                <c:pt idx="141">
                  <c:v>0.1148</c:v>
                </c:pt>
                <c:pt idx="142">
                  <c:v>0.1096</c:v>
                </c:pt>
                <c:pt idx="143">
                  <c:v>0.1048</c:v>
                </c:pt>
                <c:pt idx="144">
                  <c:v>0.1004</c:v>
                </c:pt>
                <c:pt idx="145">
                  <c:v>9.64E-2</c:v>
                </c:pt>
                <c:pt idx="146">
                  <c:v>9.2700000000000005E-2</c:v>
                </c:pt>
                <c:pt idx="147">
                  <c:v>8.9200000000000002E-2</c:v>
                </c:pt>
                <c:pt idx="148">
                  <c:v>8.5900000000000004E-2</c:v>
                </c:pt>
                <c:pt idx="149">
                  <c:v>8.3000000000000004E-2</c:v>
                </c:pt>
                <c:pt idx="150">
                  <c:v>8.0100000000000005E-2</c:v>
                </c:pt>
                <c:pt idx="151">
                  <c:v>7.7600000000000002E-2</c:v>
                </c:pt>
                <c:pt idx="152">
                  <c:v>7.4999999999999997E-2</c:v>
                </c:pt>
                <c:pt idx="153">
                  <c:v>7.2700000000000001E-2</c:v>
                </c:pt>
                <c:pt idx="154">
                  <c:v>7.0499999999999993E-2</c:v>
                </c:pt>
                <c:pt idx="155">
                  <c:v>6.8199999999999997E-2</c:v>
                </c:pt>
                <c:pt idx="156">
                  <c:v>6.6299999999999998E-2</c:v>
                </c:pt>
                <c:pt idx="157">
                  <c:v>6.4500000000000002E-2</c:v>
                </c:pt>
                <c:pt idx="158">
                  <c:v>6.2700000000000006E-2</c:v>
                </c:pt>
                <c:pt idx="159">
                  <c:v>6.0999999999999999E-2</c:v>
                </c:pt>
                <c:pt idx="160">
                  <c:v>5.9299999999999999E-2</c:v>
                </c:pt>
                <c:pt idx="161">
                  <c:v>5.8000000000000003E-2</c:v>
                </c:pt>
                <c:pt idx="162">
                  <c:v>5.6500000000000002E-2</c:v>
                </c:pt>
                <c:pt idx="163">
                  <c:v>5.5E-2</c:v>
                </c:pt>
                <c:pt idx="164">
                  <c:v>5.3800000000000001E-2</c:v>
                </c:pt>
                <c:pt idx="165">
                  <c:v>5.2499999999999998E-2</c:v>
                </c:pt>
                <c:pt idx="166">
                  <c:v>5.1200000000000002E-2</c:v>
                </c:pt>
                <c:pt idx="167">
                  <c:v>5.0099999999999999E-2</c:v>
                </c:pt>
                <c:pt idx="168">
                  <c:v>4.9000000000000002E-2</c:v>
                </c:pt>
                <c:pt idx="169">
                  <c:v>4.8000000000000001E-2</c:v>
                </c:pt>
                <c:pt idx="170">
                  <c:v>4.7E-2</c:v>
                </c:pt>
                <c:pt idx="171">
                  <c:v>4.5900000000000003E-2</c:v>
                </c:pt>
                <c:pt idx="172">
                  <c:v>4.4999999999999998E-2</c:v>
                </c:pt>
                <c:pt idx="173">
                  <c:v>4.4200000000000003E-2</c:v>
                </c:pt>
                <c:pt idx="174">
                  <c:v>4.3299999999999998E-2</c:v>
                </c:pt>
                <c:pt idx="175">
                  <c:v>4.2500000000000003E-2</c:v>
                </c:pt>
                <c:pt idx="176">
                  <c:v>4.1799999999999997E-2</c:v>
                </c:pt>
                <c:pt idx="177">
                  <c:v>4.1000000000000002E-2</c:v>
                </c:pt>
                <c:pt idx="178">
                  <c:v>4.0300000000000002E-2</c:v>
                </c:pt>
                <c:pt idx="179">
                  <c:v>3.9600000000000003E-2</c:v>
                </c:pt>
                <c:pt idx="180">
                  <c:v>3.9E-2</c:v>
                </c:pt>
                <c:pt idx="181">
                  <c:v>3.8300000000000001E-2</c:v>
                </c:pt>
                <c:pt idx="182">
                  <c:v>3.78E-2</c:v>
                </c:pt>
                <c:pt idx="183">
                  <c:v>3.7199999999999997E-2</c:v>
                </c:pt>
                <c:pt idx="184">
                  <c:v>3.6600000000000001E-2</c:v>
                </c:pt>
                <c:pt idx="185">
                  <c:v>3.6200000000000003E-2</c:v>
                </c:pt>
                <c:pt idx="186">
                  <c:v>3.5700000000000003E-2</c:v>
                </c:pt>
                <c:pt idx="187">
                  <c:v>3.5200000000000002E-2</c:v>
                </c:pt>
                <c:pt idx="188">
                  <c:v>3.4700000000000002E-2</c:v>
                </c:pt>
                <c:pt idx="189">
                  <c:v>3.4200000000000001E-2</c:v>
                </c:pt>
                <c:pt idx="190">
                  <c:v>3.3700000000000001E-2</c:v>
                </c:pt>
                <c:pt idx="191">
                  <c:v>3.3300000000000003E-2</c:v>
                </c:pt>
                <c:pt idx="192">
                  <c:v>3.3000000000000002E-2</c:v>
                </c:pt>
                <c:pt idx="193">
                  <c:v>3.2599999999999997E-2</c:v>
                </c:pt>
                <c:pt idx="194">
                  <c:v>3.2300000000000002E-2</c:v>
                </c:pt>
                <c:pt idx="195">
                  <c:v>3.1800000000000002E-2</c:v>
                </c:pt>
                <c:pt idx="196">
                  <c:v>3.1399999999999997E-2</c:v>
                </c:pt>
                <c:pt idx="197">
                  <c:v>3.1E-2</c:v>
                </c:pt>
                <c:pt idx="198">
                  <c:v>3.0599999999999999E-2</c:v>
                </c:pt>
                <c:pt idx="199">
                  <c:v>3.0099999999999998E-2</c:v>
                </c:pt>
                <c:pt idx="200">
                  <c:v>2.9899999999999999E-2</c:v>
                </c:pt>
                <c:pt idx="201">
                  <c:v>2.9399999999999999E-2</c:v>
                </c:pt>
                <c:pt idx="202">
                  <c:v>2.9100000000000001E-2</c:v>
                </c:pt>
                <c:pt idx="203">
                  <c:v>2.86E-2</c:v>
                </c:pt>
                <c:pt idx="204">
                  <c:v>2.8299999999999999E-2</c:v>
                </c:pt>
                <c:pt idx="205">
                  <c:v>2.7900000000000001E-2</c:v>
                </c:pt>
                <c:pt idx="206">
                  <c:v>2.76E-2</c:v>
                </c:pt>
                <c:pt idx="207">
                  <c:v>2.7300000000000001E-2</c:v>
                </c:pt>
                <c:pt idx="208">
                  <c:v>2.69E-2</c:v>
                </c:pt>
                <c:pt idx="209">
                  <c:v>2.6700000000000002E-2</c:v>
                </c:pt>
                <c:pt idx="210">
                  <c:v>2.64E-2</c:v>
                </c:pt>
                <c:pt idx="211">
                  <c:v>2.5999999999999999E-2</c:v>
                </c:pt>
                <c:pt idx="212">
                  <c:v>2.5700000000000001E-2</c:v>
                </c:pt>
                <c:pt idx="213">
                  <c:v>2.5499999999999998E-2</c:v>
                </c:pt>
                <c:pt idx="214">
                  <c:v>2.5100000000000001E-2</c:v>
                </c:pt>
                <c:pt idx="215">
                  <c:v>2.4899999999999999E-2</c:v>
                </c:pt>
                <c:pt idx="216">
                  <c:v>2.47E-2</c:v>
                </c:pt>
                <c:pt idx="217">
                  <c:v>2.4400000000000002E-2</c:v>
                </c:pt>
                <c:pt idx="218">
                  <c:v>2.4E-2</c:v>
                </c:pt>
                <c:pt idx="219">
                  <c:v>2.3900000000000001E-2</c:v>
                </c:pt>
                <c:pt idx="220">
                  <c:v>2.3599999999999999E-2</c:v>
                </c:pt>
                <c:pt idx="221">
                  <c:v>2.3300000000000001E-2</c:v>
                </c:pt>
                <c:pt idx="222">
                  <c:v>2.3099999999999999E-2</c:v>
                </c:pt>
                <c:pt idx="223">
                  <c:v>2.2800000000000001E-2</c:v>
                </c:pt>
                <c:pt idx="224">
                  <c:v>2.2599999999999999E-2</c:v>
                </c:pt>
                <c:pt idx="225">
                  <c:v>2.23E-2</c:v>
                </c:pt>
                <c:pt idx="226">
                  <c:v>2.1999999999999999E-2</c:v>
                </c:pt>
                <c:pt idx="227">
                  <c:v>2.18E-2</c:v>
                </c:pt>
                <c:pt idx="228">
                  <c:v>2.1700000000000001E-2</c:v>
                </c:pt>
                <c:pt idx="229">
                  <c:v>2.1399999999999999E-2</c:v>
                </c:pt>
                <c:pt idx="230">
                  <c:v>2.12E-2</c:v>
                </c:pt>
                <c:pt idx="231">
                  <c:v>2.0899999999999998E-2</c:v>
                </c:pt>
                <c:pt idx="232">
                  <c:v>2.0799999999999999E-2</c:v>
                </c:pt>
                <c:pt idx="233">
                  <c:v>2.06E-2</c:v>
                </c:pt>
                <c:pt idx="234">
                  <c:v>2.0400000000000001E-2</c:v>
                </c:pt>
                <c:pt idx="235">
                  <c:v>2.01E-2</c:v>
                </c:pt>
                <c:pt idx="236">
                  <c:v>1.9900000000000001E-2</c:v>
                </c:pt>
                <c:pt idx="237">
                  <c:v>1.9800000000000002E-2</c:v>
                </c:pt>
                <c:pt idx="238">
                  <c:v>1.9599999999999999E-2</c:v>
                </c:pt>
                <c:pt idx="239">
                  <c:v>1.9199999999999998E-2</c:v>
                </c:pt>
                <c:pt idx="240">
                  <c:v>1.9E-2</c:v>
                </c:pt>
                <c:pt idx="241">
                  <c:v>1.89E-2</c:v>
                </c:pt>
                <c:pt idx="242">
                  <c:v>1.8700000000000001E-2</c:v>
                </c:pt>
                <c:pt idx="243">
                  <c:v>1.8499999999999999E-2</c:v>
                </c:pt>
                <c:pt idx="244">
                  <c:v>1.83E-2</c:v>
                </c:pt>
                <c:pt idx="245">
                  <c:v>1.8100000000000002E-2</c:v>
                </c:pt>
                <c:pt idx="246">
                  <c:v>1.78E-2</c:v>
                </c:pt>
                <c:pt idx="247">
                  <c:v>1.7500000000000002E-2</c:v>
                </c:pt>
                <c:pt idx="248">
                  <c:v>1.7399999999999999E-2</c:v>
                </c:pt>
                <c:pt idx="249">
                  <c:v>1.7100000000000001E-2</c:v>
                </c:pt>
                <c:pt idx="250">
                  <c:v>1.6899999999999998E-2</c:v>
                </c:pt>
                <c:pt idx="251">
                  <c:v>1.66E-2</c:v>
                </c:pt>
                <c:pt idx="252">
                  <c:v>1.6500000000000001E-2</c:v>
                </c:pt>
                <c:pt idx="253">
                  <c:v>1.6299999999999999E-2</c:v>
                </c:pt>
                <c:pt idx="254">
                  <c:v>1.6E-2</c:v>
                </c:pt>
                <c:pt idx="255">
                  <c:v>1.5800000000000002E-2</c:v>
                </c:pt>
                <c:pt idx="256">
                  <c:v>1.55E-2</c:v>
                </c:pt>
                <c:pt idx="257">
                  <c:v>1.5299999999999999E-2</c:v>
                </c:pt>
                <c:pt idx="258">
                  <c:v>1.5100000000000001E-2</c:v>
                </c:pt>
                <c:pt idx="259">
                  <c:v>1.49E-2</c:v>
                </c:pt>
                <c:pt idx="260">
                  <c:v>1.46E-2</c:v>
                </c:pt>
                <c:pt idx="261">
                  <c:v>1.43E-2</c:v>
                </c:pt>
                <c:pt idx="262">
                  <c:v>1.41E-2</c:v>
                </c:pt>
                <c:pt idx="263">
                  <c:v>1.38E-2</c:v>
                </c:pt>
                <c:pt idx="264">
                  <c:v>1.3599999999999999E-2</c:v>
                </c:pt>
                <c:pt idx="265">
                  <c:v>1.34E-2</c:v>
                </c:pt>
                <c:pt idx="266">
                  <c:v>1.3100000000000001E-2</c:v>
                </c:pt>
                <c:pt idx="267">
                  <c:v>1.29E-2</c:v>
                </c:pt>
                <c:pt idx="268">
                  <c:v>1.26E-2</c:v>
                </c:pt>
                <c:pt idx="269">
                  <c:v>1.2200000000000001E-2</c:v>
                </c:pt>
                <c:pt idx="270">
                  <c:v>1.21E-2</c:v>
                </c:pt>
                <c:pt idx="271">
                  <c:v>1.2E-2</c:v>
                </c:pt>
                <c:pt idx="272">
                  <c:v>1.17E-2</c:v>
                </c:pt>
                <c:pt idx="273">
                  <c:v>1.14E-2</c:v>
                </c:pt>
                <c:pt idx="274">
                  <c:v>1.1299999999999999E-2</c:v>
                </c:pt>
                <c:pt idx="275">
                  <c:v>1.09E-2</c:v>
                </c:pt>
                <c:pt idx="276">
                  <c:v>1.0699999999999999E-2</c:v>
                </c:pt>
                <c:pt idx="277">
                  <c:v>1.06E-2</c:v>
                </c:pt>
                <c:pt idx="278">
                  <c:v>1.04E-2</c:v>
                </c:pt>
                <c:pt idx="279">
                  <c:v>1.01E-2</c:v>
                </c:pt>
                <c:pt idx="280">
                  <c:v>0.01</c:v>
                </c:pt>
                <c:pt idx="281">
                  <c:v>9.7999999999999997E-3</c:v>
                </c:pt>
                <c:pt idx="282">
                  <c:v>9.5999999999999992E-3</c:v>
                </c:pt>
                <c:pt idx="283">
                  <c:v>9.2999999999999992E-3</c:v>
                </c:pt>
                <c:pt idx="284">
                  <c:v>9.1999999999999998E-3</c:v>
                </c:pt>
                <c:pt idx="285">
                  <c:v>9.1000000000000004E-3</c:v>
                </c:pt>
                <c:pt idx="286">
                  <c:v>8.8999999999999999E-3</c:v>
                </c:pt>
                <c:pt idx="287">
                  <c:v>8.8000000000000005E-3</c:v>
                </c:pt>
                <c:pt idx="288">
                  <c:v>8.6999999999999994E-3</c:v>
                </c:pt>
                <c:pt idx="289">
                  <c:v>8.3999999999999995E-3</c:v>
                </c:pt>
                <c:pt idx="290">
                  <c:v>8.3999999999999995E-3</c:v>
                </c:pt>
                <c:pt idx="291">
                  <c:v>8.3000000000000001E-3</c:v>
                </c:pt>
                <c:pt idx="292">
                  <c:v>8.2000000000000007E-3</c:v>
                </c:pt>
                <c:pt idx="293">
                  <c:v>8.0000000000000002E-3</c:v>
                </c:pt>
                <c:pt idx="294">
                  <c:v>8.0000000000000002E-3</c:v>
                </c:pt>
                <c:pt idx="295">
                  <c:v>8.0000000000000002E-3</c:v>
                </c:pt>
                <c:pt idx="296">
                  <c:v>7.7999999999999996E-3</c:v>
                </c:pt>
                <c:pt idx="297">
                  <c:v>7.7000000000000002E-3</c:v>
                </c:pt>
                <c:pt idx="298">
                  <c:v>7.6E-3</c:v>
                </c:pt>
                <c:pt idx="299">
                  <c:v>7.4000000000000003E-3</c:v>
                </c:pt>
                <c:pt idx="300">
                  <c:v>7.4999999999999997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BAA-4BFC-8DD9-98ACA10901E2}"/>
            </c:ext>
          </c:extLst>
        </c:ser>
        <c:ser>
          <c:idx val="1"/>
          <c:order val="1"/>
          <c:tx>
            <c:strRef>
              <c:f>Sheet1!$AT$2</c:f>
              <c:strCache>
                <c:ptCount val="1"/>
                <c:pt idx="0">
                  <c:v>24 h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none"/>
          </c:marker>
          <c:xVal>
            <c:numRef>
              <c:f>Sheet1!$AR$3:$AR$303</c:f>
              <c:numCache>
                <c:formatCode>General</c:formatCode>
                <c:ptCount val="301"/>
                <c:pt idx="0">
                  <c:v>200</c:v>
                </c:pt>
                <c:pt idx="1">
                  <c:v>202</c:v>
                </c:pt>
                <c:pt idx="2">
                  <c:v>204</c:v>
                </c:pt>
                <c:pt idx="3">
                  <c:v>206</c:v>
                </c:pt>
                <c:pt idx="4">
                  <c:v>208</c:v>
                </c:pt>
                <c:pt idx="5">
                  <c:v>210</c:v>
                </c:pt>
                <c:pt idx="6">
                  <c:v>212</c:v>
                </c:pt>
                <c:pt idx="7">
                  <c:v>214</c:v>
                </c:pt>
                <c:pt idx="8">
                  <c:v>216</c:v>
                </c:pt>
                <c:pt idx="9">
                  <c:v>218</c:v>
                </c:pt>
                <c:pt idx="10">
                  <c:v>220</c:v>
                </c:pt>
                <c:pt idx="11">
                  <c:v>222</c:v>
                </c:pt>
                <c:pt idx="12">
                  <c:v>224</c:v>
                </c:pt>
                <c:pt idx="13">
                  <c:v>226</c:v>
                </c:pt>
                <c:pt idx="14">
                  <c:v>228</c:v>
                </c:pt>
                <c:pt idx="15">
                  <c:v>230</c:v>
                </c:pt>
                <c:pt idx="16">
                  <c:v>232</c:v>
                </c:pt>
                <c:pt idx="17">
                  <c:v>234</c:v>
                </c:pt>
                <c:pt idx="18">
                  <c:v>236</c:v>
                </c:pt>
                <c:pt idx="19">
                  <c:v>238</c:v>
                </c:pt>
                <c:pt idx="20">
                  <c:v>240</c:v>
                </c:pt>
                <c:pt idx="21">
                  <c:v>242</c:v>
                </c:pt>
                <c:pt idx="22">
                  <c:v>244</c:v>
                </c:pt>
                <c:pt idx="23">
                  <c:v>246</c:v>
                </c:pt>
                <c:pt idx="24">
                  <c:v>248</c:v>
                </c:pt>
                <c:pt idx="25">
                  <c:v>250</c:v>
                </c:pt>
                <c:pt idx="26">
                  <c:v>252</c:v>
                </c:pt>
                <c:pt idx="27">
                  <c:v>254</c:v>
                </c:pt>
                <c:pt idx="28">
                  <c:v>256</c:v>
                </c:pt>
                <c:pt idx="29">
                  <c:v>258</c:v>
                </c:pt>
                <c:pt idx="30">
                  <c:v>260</c:v>
                </c:pt>
                <c:pt idx="31">
                  <c:v>262</c:v>
                </c:pt>
                <c:pt idx="32">
                  <c:v>264</c:v>
                </c:pt>
                <c:pt idx="33">
                  <c:v>266</c:v>
                </c:pt>
                <c:pt idx="34">
                  <c:v>268</c:v>
                </c:pt>
                <c:pt idx="35">
                  <c:v>270</c:v>
                </c:pt>
                <c:pt idx="36">
                  <c:v>272</c:v>
                </c:pt>
                <c:pt idx="37">
                  <c:v>274</c:v>
                </c:pt>
                <c:pt idx="38">
                  <c:v>276</c:v>
                </c:pt>
                <c:pt idx="39">
                  <c:v>278</c:v>
                </c:pt>
                <c:pt idx="40">
                  <c:v>280</c:v>
                </c:pt>
                <c:pt idx="41">
                  <c:v>282</c:v>
                </c:pt>
                <c:pt idx="42">
                  <c:v>284</c:v>
                </c:pt>
                <c:pt idx="43">
                  <c:v>286</c:v>
                </c:pt>
                <c:pt idx="44">
                  <c:v>288</c:v>
                </c:pt>
                <c:pt idx="45">
                  <c:v>290</c:v>
                </c:pt>
                <c:pt idx="46">
                  <c:v>292</c:v>
                </c:pt>
                <c:pt idx="47">
                  <c:v>294</c:v>
                </c:pt>
                <c:pt idx="48">
                  <c:v>296</c:v>
                </c:pt>
                <c:pt idx="49">
                  <c:v>298</c:v>
                </c:pt>
                <c:pt idx="50">
                  <c:v>300</c:v>
                </c:pt>
                <c:pt idx="51">
                  <c:v>302</c:v>
                </c:pt>
                <c:pt idx="52">
                  <c:v>304</c:v>
                </c:pt>
                <c:pt idx="53">
                  <c:v>306</c:v>
                </c:pt>
                <c:pt idx="54">
                  <c:v>308</c:v>
                </c:pt>
                <c:pt idx="55">
                  <c:v>310</c:v>
                </c:pt>
                <c:pt idx="56">
                  <c:v>312</c:v>
                </c:pt>
                <c:pt idx="57">
                  <c:v>314</c:v>
                </c:pt>
                <c:pt idx="58">
                  <c:v>316</c:v>
                </c:pt>
                <c:pt idx="59">
                  <c:v>318</c:v>
                </c:pt>
                <c:pt idx="60">
                  <c:v>320</c:v>
                </c:pt>
                <c:pt idx="61">
                  <c:v>322</c:v>
                </c:pt>
                <c:pt idx="62">
                  <c:v>324</c:v>
                </c:pt>
                <c:pt idx="63">
                  <c:v>326</c:v>
                </c:pt>
                <c:pt idx="64">
                  <c:v>328</c:v>
                </c:pt>
                <c:pt idx="65">
                  <c:v>330</c:v>
                </c:pt>
                <c:pt idx="66">
                  <c:v>332</c:v>
                </c:pt>
                <c:pt idx="67">
                  <c:v>334</c:v>
                </c:pt>
                <c:pt idx="68">
                  <c:v>336</c:v>
                </c:pt>
                <c:pt idx="69">
                  <c:v>338</c:v>
                </c:pt>
                <c:pt idx="70">
                  <c:v>340</c:v>
                </c:pt>
                <c:pt idx="71">
                  <c:v>342</c:v>
                </c:pt>
                <c:pt idx="72">
                  <c:v>344</c:v>
                </c:pt>
                <c:pt idx="73">
                  <c:v>346</c:v>
                </c:pt>
                <c:pt idx="74">
                  <c:v>348</c:v>
                </c:pt>
                <c:pt idx="75">
                  <c:v>350</c:v>
                </c:pt>
                <c:pt idx="76">
                  <c:v>352</c:v>
                </c:pt>
                <c:pt idx="77">
                  <c:v>354</c:v>
                </c:pt>
                <c:pt idx="78">
                  <c:v>356</c:v>
                </c:pt>
                <c:pt idx="79">
                  <c:v>358</c:v>
                </c:pt>
                <c:pt idx="80">
                  <c:v>360</c:v>
                </c:pt>
                <c:pt idx="81">
                  <c:v>362</c:v>
                </c:pt>
                <c:pt idx="82">
                  <c:v>364</c:v>
                </c:pt>
                <c:pt idx="83">
                  <c:v>366</c:v>
                </c:pt>
                <c:pt idx="84">
                  <c:v>368</c:v>
                </c:pt>
                <c:pt idx="85">
                  <c:v>370</c:v>
                </c:pt>
                <c:pt idx="86">
                  <c:v>372</c:v>
                </c:pt>
                <c:pt idx="87">
                  <c:v>374</c:v>
                </c:pt>
                <c:pt idx="88">
                  <c:v>376</c:v>
                </c:pt>
                <c:pt idx="89">
                  <c:v>378</c:v>
                </c:pt>
                <c:pt idx="90">
                  <c:v>380</c:v>
                </c:pt>
                <c:pt idx="91">
                  <c:v>382</c:v>
                </c:pt>
                <c:pt idx="92">
                  <c:v>384</c:v>
                </c:pt>
                <c:pt idx="93">
                  <c:v>386</c:v>
                </c:pt>
                <c:pt idx="94">
                  <c:v>388</c:v>
                </c:pt>
                <c:pt idx="95">
                  <c:v>390</c:v>
                </c:pt>
                <c:pt idx="96">
                  <c:v>392</c:v>
                </c:pt>
                <c:pt idx="97">
                  <c:v>394</c:v>
                </c:pt>
                <c:pt idx="98">
                  <c:v>396</c:v>
                </c:pt>
                <c:pt idx="99">
                  <c:v>398</c:v>
                </c:pt>
                <c:pt idx="100">
                  <c:v>400</c:v>
                </c:pt>
                <c:pt idx="101">
                  <c:v>402</c:v>
                </c:pt>
                <c:pt idx="102">
                  <c:v>404</c:v>
                </c:pt>
                <c:pt idx="103">
                  <c:v>406</c:v>
                </c:pt>
                <c:pt idx="104">
                  <c:v>408</c:v>
                </c:pt>
                <c:pt idx="105">
                  <c:v>410</c:v>
                </c:pt>
                <c:pt idx="106">
                  <c:v>412</c:v>
                </c:pt>
                <c:pt idx="107">
                  <c:v>414</c:v>
                </c:pt>
                <c:pt idx="108">
                  <c:v>416</c:v>
                </c:pt>
                <c:pt idx="109">
                  <c:v>418</c:v>
                </c:pt>
                <c:pt idx="110">
                  <c:v>420</c:v>
                </c:pt>
                <c:pt idx="111">
                  <c:v>422</c:v>
                </c:pt>
                <c:pt idx="112">
                  <c:v>424</c:v>
                </c:pt>
                <c:pt idx="113">
                  <c:v>426</c:v>
                </c:pt>
                <c:pt idx="114">
                  <c:v>428</c:v>
                </c:pt>
                <c:pt idx="115">
                  <c:v>430</c:v>
                </c:pt>
                <c:pt idx="116">
                  <c:v>432</c:v>
                </c:pt>
                <c:pt idx="117">
                  <c:v>434</c:v>
                </c:pt>
                <c:pt idx="118">
                  <c:v>436</c:v>
                </c:pt>
                <c:pt idx="119">
                  <c:v>438</c:v>
                </c:pt>
                <c:pt idx="120">
                  <c:v>440</c:v>
                </c:pt>
                <c:pt idx="121">
                  <c:v>442</c:v>
                </c:pt>
                <c:pt idx="122">
                  <c:v>444</c:v>
                </c:pt>
                <c:pt idx="123">
                  <c:v>446</c:v>
                </c:pt>
                <c:pt idx="124">
                  <c:v>448</c:v>
                </c:pt>
                <c:pt idx="125">
                  <c:v>450</c:v>
                </c:pt>
                <c:pt idx="126">
                  <c:v>452</c:v>
                </c:pt>
                <c:pt idx="127">
                  <c:v>454</c:v>
                </c:pt>
                <c:pt idx="128">
                  <c:v>456</c:v>
                </c:pt>
                <c:pt idx="129">
                  <c:v>458</c:v>
                </c:pt>
                <c:pt idx="130">
                  <c:v>460</c:v>
                </c:pt>
                <c:pt idx="131">
                  <c:v>462</c:v>
                </c:pt>
                <c:pt idx="132">
                  <c:v>464</c:v>
                </c:pt>
                <c:pt idx="133">
                  <c:v>466</c:v>
                </c:pt>
                <c:pt idx="134">
                  <c:v>468</c:v>
                </c:pt>
                <c:pt idx="135">
                  <c:v>470</c:v>
                </c:pt>
                <c:pt idx="136">
                  <c:v>472</c:v>
                </c:pt>
                <c:pt idx="137">
                  <c:v>474</c:v>
                </c:pt>
                <c:pt idx="138">
                  <c:v>476</c:v>
                </c:pt>
                <c:pt idx="139">
                  <c:v>478</c:v>
                </c:pt>
                <c:pt idx="140">
                  <c:v>480</c:v>
                </c:pt>
                <c:pt idx="141">
                  <c:v>482</c:v>
                </c:pt>
                <c:pt idx="142">
                  <c:v>484</c:v>
                </c:pt>
                <c:pt idx="143">
                  <c:v>486</c:v>
                </c:pt>
                <c:pt idx="144">
                  <c:v>488</c:v>
                </c:pt>
                <c:pt idx="145">
                  <c:v>490</c:v>
                </c:pt>
                <c:pt idx="146">
                  <c:v>492</c:v>
                </c:pt>
                <c:pt idx="147">
                  <c:v>494</c:v>
                </c:pt>
                <c:pt idx="148">
                  <c:v>496</c:v>
                </c:pt>
                <c:pt idx="149">
                  <c:v>498</c:v>
                </c:pt>
                <c:pt idx="150">
                  <c:v>500</c:v>
                </c:pt>
                <c:pt idx="151">
                  <c:v>502</c:v>
                </c:pt>
                <c:pt idx="152">
                  <c:v>504</c:v>
                </c:pt>
                <c:pt idx="153">
                  <c:v>506</c:v>
                </c:pt>
                <c:pt idx="154">
                  <c:v>508</c:v>
                </c:pt>
                <c:pt idx="155">
                  <c:v>510</c:v>
                </c:pt>
                <c:pt idx="156">
                  <c:v>512</c:v>
                </c:pt>
                <c:pt idx="157">
                  <c:v>514</c:v>
                </c:pt>
                <c:pt idx="158">
                  <c:v>516</c:v>
                </c:pt>
                <c:pt idx="159">
                  <c:v>518</c:v>
                </c:pt>
                <c:pt idx="160">
                  <c:v>520</c:v>
                </c:pt>
                <c:pt idx="161">
                  <c:v>522</c:v>
                </c:pt>
                <c:pt idx="162">
                  <c:v>524</c:v>
                </c:pt>
                <c:pt idx="163">
                  <c:v>526</c:v>
                </c:pt>
                <c:pt idx="164">
                  <c:v>528</c:v>
                </c:pt>
                <c:pt idx="165">
                  <c:v>530</c:v>
                </c:pt>
                <c:pt idx="166">
                  <c:v>532</c:v>
                </c:pt>
                <c:pt idx="167">
                  <c:v>534</c:v>
                </c:pt>
                <c:pt idx="168">
                  <c:v>536</c:v>
                </c:pt>
                <c:pt idx="169">
                  <c:v>538</c:v>
                </c:pt>
                <c:pt idx="170">
                  <c:v>540</c:v>
                </c:pt>
                <c:pt idx="171">
                  <c:v>542</c:v>
                </c:pt>
                <c:pt idx="172">
                  <c:v>544</c:v>
                </c:pt>
                <c:pt idx="173">
                  <c:v>546</c:v>
                </c:pt>
                <c:pt idx="174">
                  <c:v>548</c:v>
                </c:pt>
                <c:pt idx="175">
                  <c:v>550</c:v>
                </c:pt>
                <c:pt idx="176">
                  <c:v>552</c:v>
                </c:pt>
                <c:pt idx="177">
                  <c:v>554</c:v>
                </c:pt>
                <c:pt idx="178">
                  <c:v>556</c:v>
                </c:pt>
                <c:pt idx="179">
                  <c:v>558</c:v>
                </c:pt>
                <c:pt idx="180">
                  <c:v>560</c:v>
                </c:pt>
                <c:pt idx="181">
                  <c:v>562</c:v>
                </c:pt>
                <c:pt idx="182">
                  <c:v>564</c:v>
                </c:pt>
                <c:pt idx="183">
                  <c:v>566</c:v>
                </c:pt>
                <c:pt idx="184">
                  <c:v>568</c:v>
                </c:pt>
                <c:pt idx="185">
                  <c:v>570</c:v>
                </c:pt>
                <c:pt idx="186">
                  <c:v>572</c:v>
                </c:pt>
                <c:pt idx="187">
                  <c:v>574</c:v>
                </c:pt>
                <c:pt idx="188">
                  <c:v>576</c:v>
                </c:pt>
                <c:pt idx="189">
                  <c:v>578</c:v>
                </c:pt>
                <c:pt idx="190">
                  <c:v>580</c:v>
                </c:pt>
                <c:pt idx="191">
                  <c:v>582</c:v>
                </c:pt>
                <c:pt idx="192">
                  <c:v>584</c:v>
                </c:pt>
                <c:pt idx="193">
                  <c:v>586</c:v>
                </c:pt>
                <c:pt idx="194">
                  <c:v>588</c:v>
                </c:pt>
                <c:pt idx="195">
                  <c:v>590</c:v>
                </c:pt>
                <c:pt idx="196">
                  <c:v>592</c:v>
                </c:pt>
                <c:pt idx="197">
                  <c:v>594</c:v>
                </c:pt>
                <c:pt idx="198">
                  <c:v>596</c:v>
                </c:pt>
                <c:pt idx="199">
                  <c:v>598</c:v>
                </c:pt>
                <c:pt idx="200">
                  <c:v>600</c:v>
                </c:pt>
                <c:pt idx="201">
                  <c:v>602</c:v>
                </c:pt>
                <c:pt idx="202">
                  <c:v>604</c:v>
                </c:pt>
                <c:pt idx="203">
                  <c:v>606</c:v>
                </c:pt>
                <c:pt idx="204">
                  <c:v>608</c:v>
                </c:pt>
                <c:pt idx="205">
                  <c:v>610</c:v>
                </c:pt>
                <c:pt idx="206">
                  <c:v>612</c:v>
                </c:pt>
                <c:pt idx="207">
                  <c:v>614</c:v>
                </c:pt>
                <c:pt idx="208">
                  <c:v>616</c:v>
                </c:pt>
                <c:pt idx="209">
                  <c:v>618</c:v>
                </c:pt>
                <c:pt idx="210">
                  <c:v>620</c:v>
                </c:pt>
                <c:pt idx="211">
                  <c:v>622</c:v>
                </c:pt>
                <c:pt idx="212">
                  <c:v>624</c:v>
                </c:pt>
                <c:pt idx="213">
                  <c:v>626</c:v>
                </c:pt>
                <c:pt idx="214">
                  <c:v>628</c:v>
                </c:pt>
                <c:pt idx="215">
                  <c:v>630</c:v>
                </c:pt>
                <c:pt idx="216">
                  <c:v>632</c:v>
                </c:pt>
                <c:pt idx="217">
                  <c:v>634</c:v>
                </c:pt>
                <c:pt idx="218">
                  <c:v>636</c:v>
                </c:pt>
                <c:pt idx="219">
                  <c:v>638</c:v>
                </c:pt>
                <c:pt idx="220">
                  <c:v>640</c:v>
                </c:pt>
                <c:pt idx="221">
                  <c:v>642</c:v>
                </c:pt>
                <c:pt idx="222">
                  <c:v>644</c:v>
                </c:pt>
                <c:pt idx="223">
                  <c:v>646</c:v>
                </c:pt>
                <c:pt idx="224">
                  <c:v>648</c:v>
                </c:pt>
                <c:pt idx="225">
                  <c:v>650</c:v>
                </c:pt>
                <c:pt idx="226">
                  <c:v>652</c:v>
                </c:pt>
                <c:pt idx="227">
                  <c:v>654</c:v>
                </c:pt>
                <c:pt idx="228">
                  <c:v>656</c:v>
                </c:pt>
                <c:pt idx="229">
                  <c:v>658</c:v>
                </c:pt>
                <c:pt idx="230">
                  <c:v>660</c:v>
                </c:pt>
                <c:pt idx="231">
                  <c:v>662</c:v>
                </c:pt>
                <c:pt idx="232">
                  <c:v>664</c:v>
                </c:pt>
                <c:pt idx="233">
                  <c:v>666</c:v>
                </c:pt>
                <c:pt idx="234">
                  <c:v>668</c:v>
                </c:pt>
                <c:pt idx="235">
                  <c:v>670</c:v>
                </c:pt>
                <c:pt idx="236">
                  <c:v>672</c:v>
                </c:pt>
                <c:pt idx="237">
                  <c:v>674</c:v>
                </c:pt>
                <c:pt idx="238">
                  <c:v>676</c:v>
                </c:pt>
                <c:pt idx="239">
                  <c:v>678</c:v>
                </c:pt>
                <c:pt idx="240">
                  <c:v>680</c:v>
                </c:pt>
                <c:pt idx="241">
                  <c:v>682</c:v>
                </c:pt>
                <c:pt idx="242">
                  <c:v>684</c:v>
                </c:pt>
                <c:pt idx="243">
                  <c:v>686</c:v>
                </c:pt>
                <c:pt idx="244">
                  <c:v>688</c:v>
                </c:pt>
                <c:pt idx="245">
                  <c:v>690</c:v>
                </c:pt>
                <c:pt idx="246">
                  <c:v>692</c:v>
                </c:pt>
                <c:pt idx="247">
                  <c:v>694</c:v>
                </c:pt>
                <c:pt idx="248">
                  <c:v>696</c:v>
                </c:pt>
                <c:pt idx="249">
                  <c:v>698</c:v>
                </c:pt>
                <c:pt idx="250">
                  <c:v>700</c:v>
                </c:pt>
                <c:pt idx="251">
                  <c:v>702</c:v>
                </c:pt>
                <c:pt idx="252">
                  <c:v>704</c:v>
                </c:pt>
                <c:pt idx="253">
                  <c:v>706</c:v>
                </c:pt>
                <c:pt idx="254">
                  <c:v>708</c:v>
                </c:pt>
                <c:pt idx="255">
                  <c:v>710</c:v>
                </c:pt>
                <c:pt idx="256">
                  <c:v>712</c:v>
                </c:pt>
                <c:pt idx="257">
                  <c:v>714</c:v>
                </c:pt>
                <c:pt idx="258">
                  <c:v>716</c:v>
                </c:pt>
                <c:pt idx="259">
                  <c:v>718</c:v>
                </c:pt>
                <c:pt idx="260">
                  <c:v>720</c:v>
                </c:pt>
                <c:pt idx="261">
                  <c:v>722</c:v>
                </c:pt>
                <c:pt idx="262">
                  <c:v>724</c:v>
                </c:pt>
                <c:pt idx="263">
                  <c:v>726</c:v>
                </c:pt>
                <c:pt idx="264">
                  <c:v>728</c:v>
                </c:pt>
                <c:pt idx="265">
                  <c:v>730</c:v>
                </c:pt>
                <c:pt idx="266">
                  <c:v>732</c:v>
                </c:pt>
                <c:pt idx="267">
                  <c:v>734</c:v>
                </c:pt>
                <c:pt idx="268">
                  <c:v>736</c:v>
                </c:pt>
                <c:pt idx="269">
                  <c:v>738</c:v>
                </c:pt>
                <c:pt idx="270">
                  <c:v>740</c:v>
                </c:pt>
                <c:pt idx="271">
                  <c:v>742</c:v>
                </c:pt>
                <c:pt idx="272">
                  <c:v>744</c:v>
                </c:pt>
                <c:pt idx="273">
                  <c:v>746</c:v>
                </c:pt>
                <c:pt idx="274">
                  <c:v>748</c:v>
                </c:pt>
                <c:pt idx="275">
                  <c:v>750</c:v>
                </c:pt>
                <c:pt idx="276">
                  <c:v>752</c:v>
                </c:pt>
                <c:pt idx="277">
                  <c:v>754</c:v>
                </c:pt>
                <c:pt idx="278">
                  <c:v>756</c:v>
                </c:pt>
                <c:pt idx="279">
                  <c:v>758</c:v>
                </c:pt>
                <c:pt idx="280">
                  <c:v>760</c:v>
                </c:pt>
                <c:pt idx="281">
                  <c:v>762</c:v>
                </c:pt>
                <c:pt idx="282">
                  <c:v>764</c:v>
                </c:pt>
                <c:pt idx="283">
                  <c:v>766</c:v>
                </c:pt>
                <c:pt idx="284">
                  <c:v>768</c:v>
                </c:pt>
                <c:pt idx="285">
                  <c:v>770</c:v>
                </c:pt>
                <c:pt idx="286">
                  <c:v>772</c:v>
                </c:pt>
                <c:pt idx="287">
                  <c:v>774</c:v>
                </c:pt>
                <c:pt idx="288">
                  <c:v>776</c:v>
                </c:pt>
                <c:pt idx="289">
                  <c:v>778</c:v>
                </c:pt>
                <c:pt idx="290">
                  <c:v>780</c:v>
                </c:pt>
                <c:pt idx="291">
                  <c:v>782</c:v>
                </c:pt>
                <c:pt idx="292">
                  <c:v>784</c:v>
                </c:pt>
                <c:pt idx="293">
                  <c:v>786</c:v>
                </c:pt>
                <c:pt idx="294">
                  <c:v>788</c:v>
                </c:pt>
                <c:pt idx="295">
                  <c:v>790</c:v>
                </c:pt>
                <c:pt idx="296">
                  <c:v>792</c:v>
                </c:pt>
                <c:pt idx="297">
                  <c:v>794</c:v>
                </c:pt>
                <c:pt idx="298">
                  <c:v>796</c:v>
                </c:pt>
                <c:pt idx="299">
                  <c:v>798</c:v>
                </c:pt>
                <c:pt idx="300">
                  <c:v>800</c:v>
                </c:pt>
              </c:numCache>
            </c:numRef>
          </c:xVal>
          <c:yVal>
            <c:numRef>
              <c:f>Sheet1!$AT$3:$AT$303</c:f>
              <c:numCache>
                <c:formatCode>General</c:formatCode>
                <c:ptCount val="301"/>
                <c:pt idx="0">
                  <c:v>1.5881000000000001</c:v>
                </c:pt>
                <c:pt idx="1">
                  <c:v>1.5407999999999999</c:v>
                </c:pt>
                <c:pt idx="2">
                  <c:v>1.4874000000000001</c:v>
                </c:pt>
                <c:pt idx="3">
                  <c:v>1.4256</c:v>
                </c:pt>
                <c:pt idx="4">
                  <c:v>1.3604000000000001</c:v>
                </c:pt>
                <c:pt idx="5">
                  <c:v>1.2962</c:v>
                </c:pt>
                <c:pt idx="6">
                  <c:v>1.2359</c:v>
                </c:pt>
                <c:pt idx="7">
                  <c:v>1.1823999999999999</c:v>
                </c:pt>
                <c:pt idx="8">
                  <c:v>1.1374</c:v>
                </c:pt>
                <c:pt idx="9">
                  <c:v>1.0987</c:v>
                </c:pt>
                <c:pt idx="10">
                  <c:v>1.0656000000000001</c:v>
                </c:pt>
                <c:pt idx="11">
                  <c:v>1.0377000000000001</c:v>
                </c:pt>
                <c:pt idx="12">
                  <c:v>1.0125</c:v>
                </c:pt>
                <c:pt idx="13">
                  <c:v>0.98950000000000005</c:v>
                </c:pt>
                <c:pt idx="14">
                  <c:v>0.96850000000000003</c:v>
                </c:pt>
                <c:pt idx="15">
                  <c:v>0.94679999999999997</c:v>
                </c:pt>
                <c:pt idx="16">
                  <c:v>0.92490000000000006</c:v>
                </c:pt>
                <c:pt idx="17">
                  <c:v>0.90269999999999995</c:v>
                </c:pt>
                <c:pt idx="18">
                  <c:v>0.88109999999999999</c:v>
                </c:pt>
                <c:pt idx="19">
                  <c:v>0.86040000000000005</c:v>
                </c:pt>
                <c:pt idx="20">
                  <c:v>0.8417</c:v>
                </c:pt>
                <c:pt idx="21">
                  <c:v>0.82530000000000003</c:v>
                </c:pt>
                <c:pt idx="22">
                  <c:v>0.81159999999999999</c:v>
                </c:pt>
                <c:pt idx="23">
                  <c:v>0.80089999999999995</c:v>
                </c:pt>
                <c:pt idx="24">
                  <c:v>0.79290000000000005</c:v>
                </c:pt>
                <c:pt idx="25">
                  <c:v>0.78720000000000001</c:v>
                </c:pt>
                <c:pt idx="26">
                  <c:v>0.78210000000000002</c:v>
                </c:pt>
                <c:pt idx="27">
                  <c:v>0.77780000000000005</c:v>
                </c:pt>
                <c:pt idx="28">
                  <c:v>0.77400000000000002</c:v>
                </c:pt>
                <c:pt idx="29">
                  <c:v>0.77039999999999997</c:v>
                </c:pt>
                <c:pt idx="30">
                  <c:v>0.76719999999999999</c:v>
                </c:pt>
                <c:pt idx="31">
                  <c:v>0.76449999999999996</c:v>
                </c:pt>
                <c:pt idx="32">
                  <c:v>0.76090000000000002</c:v>
                </c:pt>
                <c:pt idx="33">
                  <c:v>0.75590000000000002</c:v>
                </c:pt>
                <c:pt idx="34">
                  <c:v>0.74829999999999997</c:v>
                </c:pt>
                <c:pt idx="35">
                  <c:v>0.73709999999999998</c:v>
                </c:pt>
                <c:pt idx="36">
                  <c:v>0.72370000000000001</c:v>
                </c:pt>
                <c:pt idx="37">
                  <c:v>0.70779999999999998</c:v>
                </c:pt>
                <c:pt idx="38">
                  <c:v>0.69079999999999997</c:v>
                </c:pt>
                <c:pt idx="39">
                  <c:v>0.67359999999999998</c:v>
                </c:pt>
                <c:pt idx="40">
                  <c:v>0.65510000000000002</c:v>
                </c:pt>
                <c:pt idx="41">
                  <c:v>0.63570000000000004</c:v>
                </c:pt>
                <c:pt idx="42">
                  <c:v>0.61570000000000003</c:v>
                </c:pt>
                <c:pt idx="43">
                  <c:v>0.59470000000000001</c:v>
                </c:pt>
                <c:pt idx="44">
                  <c:v>0.57330000000000003</c:v>
                </c:pt>
                <c:pt idx="45">
                  <c:v>0.55120000000000002</c:v>
                </c:pt>
                <c:pt idx="46">
                  <c:v>0.52980000000000005</c:v>
                </c:pt>
                <c:pt idx="47">
                  <c:v>0.50919999999999999</c:v>
                </c:pt>
                <c:pt idx="48">
                  <c:v>0.49080000000000001</c:v>
                </c:pt>
                <c:pt idx="49">
                  <c:v>0.4738</c:v>
                </c:pt>
                <c:pt idx="50">
                  <c:v>0.45929999999999999</c:v>
                </c:pt>
                <c:pt idx="51">
                  <c:v>0.4471</c:v>
                </c:pt>
                <c:pt idx="52">
                  <c:v>0.43740000000000001</c:v>
                </c:pt>
                <c:pt idx="53">
                  <c:v>0.43020000000000003</c:v>
                </c:pt>
                <c:pt idx="54">
                  <c:v>0.4244</c:v>
                </c:pt>
                <c:pt idx="55">
                  <c:v>0.42070000000000002</c:v>
                </c:pt>
                <c:pt idx="56">
                  <c:v>0.41810000000000003</c:v>
                </c:pt>
                <c:pt idx="57">
                  <c:v>0.41720000000000002</c:v>
                </c:pt>
                <c:pt idx="58">
                  <c:v>0.41670000000000001</c:v>
                </c:pt>
                <c:pt idx="59">
                  <c:v>0.41720000000000002</c:v>
                </c:pt>
                <c:pt idx="60">
                  <c:v>0.41870000000000002</c:v>
                </c:pt>
                <c:pt idx="61">
                  <c:v>0.4209</c:v>
                </c:pt>
                <c:pt idx="62">
                  <c:v>0.42330000000000001</c:v>
                </c:pt>
                <c:pt idx="63">
                  <c:v>0.4254</c:v>
                </c:pt>
                <c:pt idx="64">
                  <c:v>0.42830000000000001</c:v>
                </c:pt>
                <c:pt idx="65">
                  <c:v>0.43059999999999998</c:v>
                </c:pt>
                <c:pt idx="66">
                  <c:v>0.43330000000000002</c:v>
                </c:pt>
                <c:pt idx="67">
                  <c:v>0.43530000000000002</c:v>
                </c:pt>
                <c:pt idx="68">
                  <c:v>0.4365</c:v>
                </c:pt>
                <c:pt idx="69">
                  <c:v>0.4375</c:v>
                </c:pt>
                <c:pt idx="70">
                  <c:v>0.43809999999999999</c:v>
                </c:pt>
                <c:pt idx="71">
                  <c:v>0.43790000000000001</c:v>
                </c:pt>
                <c:pt idx="72">
                  <c:v>0.43740000000000001</c:v>
                </c:pt>
                <c:pt idx="73">
                  <c:v>0.43640000000000001</c:v>
                </c:pt>
                <c:pt idx="74">
                  <c:v>0.43540000000000001</c:v>
                </c:pt>
                <c:pt idx="75">
                  <c:v>0.43430000000000002</c:v>
                </c:pt>
                <c:pt idx="76">
                  <c:v>0.433</c:v>
                </c:pt>
                <c:pt idx="77">
                  <c:v>0.432</c:v>
                </c:pt>
                <c:pt idx="78">
                  <c:v>0.43070000000000003</c:v>
                </c:pt>
                <c:pt idx="79">
                  <c:v>0.42970000000000003</c:v>
                </c:pt>
                <c:pt idx="80">
                  <c:v>0.42899999999999999</c:v>
                </c:pt>
                <c:pt idx="81">
                  <c:v>0.42899999999999999</c:v>
                </c:pt>
                <c:pt idx="82">
                  <c:v>0.4294</c:v>
                </c:pt>
                <c:pt idx="83">
                  <c:v>0.43109999999999998</c:v>
                </c:pt>
                <c:pt idx="84">
                  <c:v>0.43369999999999997</c:v>
                </c:pt>
                <c:pt idx="85">
                  <c:v>0.43719999999999998</c:v>
                </c:pt>
                <c:pt idx="86">
                  <c:v>0.4425</c:v>
                </c:pt>
                <c:pt idx="87">
                  <c:v>0.44869999999999999</c:v>
                </c:pt>
                <c:pt idx="88">
                  <c:v>0.45629999999999998</c:v>
                </c:pt>
                <c:pt idx="89">
                  <c:v>0.46560000000000001</c:v>
                </c:pt>
                <c:pt idx="90">
                  <c:v>0.47589999999999999</c:v>
                </c:pt>
                <c:pt idx="91">
                  <c:v>0.48770000000000002</c:v>
                </c:pt>
                <c:pt idx="92">
                  <c:v>0.5</c:v>
                </c:pt>
                <c:pt idx="93">
                  <c:v>0.51380000000000003</c:v>
                </c:pt>
                <c:pt idx="94">
                  <c:v>0.52839999999999998</c:v>
                </c:pt>
                <c:pt idx="95">
                  <c:v>0.54349999999999998</c:v>
                </c:pt>
                <c:pt idx="96">
                  <c:v>0.55859999999999999</c:v>
                </c:pt>
                <c:pt idx="97">
                  <c:v>0.57369999999999999</c:v>
                </c:pt>
                <c:pt idx="98">
                  <c:v>0.58830000000000005</c:v>
                </c:pt>
                <c:pt idx="99">
                  <c:v>0.60250000000000004</c:v>
                </c:pt>
                <c:pt idx="100">
                  <c:v>0.61580000000000001</c:v>
                </c:pt>
                <c:pt idx="101">
                  <c:v>0.628</c:v>
                </c:pt>
                <c:pt idx="102">
                  <c:v>0.63900000000000001</c:v>
                </c:pt>
                <c:pt idx="103">
                  <c:v>0.64829999999999999</c:v>
                </c:pt>
                <c:pt idx="104">
                  <c:v>0.65600000000000003</c:v>
                </c:pt>
                <c:pt idx="105">
                  <c:v>0.66139999999999999</c:v>
                </c:pt>
                <c:pt idx="106">
                  <c:v>0.66459999999999997</c:v>
                </c:pt>
                <c:pt idx="107">
                  <c:v>0.66539999999999999</c:v>
                </c:pt>
                <c:pt idx="108">
                  <c:v>0.6633</c:v>
                </c:pt>
                <c:pt idx="109">
                  <c:v>0.65849999999999997</c:v>
                </c:pt>
                <c:pt idx="110">
                  <c:v>0.65080000000000005</c:v>
                </c:pt>
                <c:pt idx="111">
                  <c:v>0.64029999999999998</c:v>
                </c:pt>
                <c:pt idx="112">
                  <c:v>0.62639999999999996</c:v>
                </c:pt>
                <c:pt idx="113">
                  <c:v>0.61</c:v>
                </c:pt>
                <c:pt idx="114">
                  <c:v>0.5907</c:v>
                </c:pt>
                <c:pt idx="115">
                  <c:v>0.56930000000000003</c:v>
                </c:pt>
                <c:pt idx="116">
                  <c:v>0.54569999999999996</c:v>
                </c:pt>
                <c:pt idx="117">
                  <c:v>0.51990000000000003</c:v>
                </c:pt>
                <c:pt idx="118">
                  <c:v>0.49299999999999999</c:v>
                </c:pt>
                <c:pt idx="119">
                  <c:v>0.4652</c:v>
                </c:pt>
                <c:pt idx="120">
                  <c:v>0.43730000000000002</c:v>
                </c:pt>
                <c:pt idx="121">
                  <c:v>0.40939999999999999</c:v>
                </c:pt>
                <c:pt idx="122">
                  <c:v>0.38179999999999997</c:v>
                </c:pt>
                <c:pt idx="123">
                  <c:v>0.35489999999999999</c:v>
                </c:pt>
                <c:pt idx="124">
                  <c:v>0.32940000000000003</c:v>
                </c:pt>
                <c:pt idx="125">
                  <c:v>0.30509999999999998</c:v>
                </c:pt>
                <c:pt idx="126">
                  <c:v>0.28260000000000002</c:v>
                </c:pt>
                <c:pt idx="127">
                  <c:v>0.26169999999999999</c:v>
                </c:pt>
                <c:pt idx="128">
                  <c:v>0.2427</c:v>
                </c:pt>
                <c:pt idx="129">
                  <c:v>0.22539999999999999</c:v>
                </c:pt>
                <c:pt idx="130">
                  <c:v>0.2094</c:v>
                </c:pt>
                <c:pt idx="131">
                  <c:v>0.19470000000000001</c:v>
                </c:pt>
                <c:pt idx="132">
                  <c:v>0.1812</c:v>
                </c:pt>
                <c:pt idx="133">
                  <c:v>0.16919999999999999</c:v>
                </c:pt>
                <c:pt idx="134">
                  <c:v>0.15840000000000001</c:v>
                </c:pt>
                <c:pt idx="135">
                  <c:v>0.14849999999999999</c:v>
                </c:pt>
                <c:pt idx="136">
                  <c:v>0.1394</c:v>
                </c:pt>
                <c:pt idx="137">
                  <c:v>0.13120000000000001</c:v>
                </c:pt>
                <c:pt idx="138">
                  <c:v>0.124</c:v>
                </c:pt>
                <c:pt idx="139">
                  <c:v>0.1173</c:v>
                </c:pt>
                <c:pt idx="140">
                  <c:v>0.1111</c:v>
                </c:pt>
                <c:pt idx="141">
                  <c:v>0.1053</c:v>
                </c:pt>
                <c:pt idx="142">
                  <c:v>0.1003</c:v>
                </c:pt>
                <c:pt idx="143">
                  <c:v>9.5500000000000002E-2</c:v>
                </c:pt>
                <c:pt idx="144">
                  <c:v>9.1200000000000003E-2</c:v>
                </c:pt>
                <c:pt idx="145">
                  <c:v>8.72E-2</c:v>
                </c:pt>
                <c:pt idx="146">
                  <c:v>8.3500000000000005E-2</c:v>
                </c:pt>
                <c:pt idx="147">
                  <c:v>8.0100000000000005E-2</c:v>
                </c:pt>
                <c:pt idx="148">
                  <c:v>7.6799999999999993E-2</c:v>
                </c:pt>
                <c:pt idx="149">
                  <c:v>7.3899999999999993E-2</c:v>
                </c:pt>
                <c:pt idx="150">
                  <c:v>7.0999999999999994E-2</c:v>
                </c:pt>
                <c:pt idx="151">
                  <c:v>6.8599999999999994E-2</c:v>
                </c:pt>
                <c:pt idx="152">
                  <c:v>6.6199999999999995E-2</c:v>
                </c:pt>
                <c:pt idx="153">
                  <c:v>6.3700000000000007E-2</c:v>
                </c:pt>
                <c:pt idx="154">
                  <c:v>6.1600000000000002E-2</c:v>
                </c:pt>
                <c:pt idx="155">
                  <c:v>5.96E-2</c:v>
                </c:pt>
                <c:pt idx="156">
                  <c:v>5.7599999999999998E-2</c:v>
                </c:pt>
                <c:pt idx="157">
                  <c:v>5.5800000000000002E-2</c:v>
                </c:pt>
                <c:pt idx="158">
                  <c:v>5.4100000000000002E-2</c:v>
                </c:pt>
                <c:pt idx="159">
                  <c:v>5.2499999999999998E-2</c:v>
                </c:pt>
                <c:pt idx="160">
                  <c:v>5.0999999999999997E-2</c:v>
                </c:pt>
                <c:pt idx="161">
                  <c:v>4.9599999999999998E-2</c:v>
                </c:pt>
                <c:pt idx="162">
                  <c:v>4.82E-2</c:v>
                </c:pt>
                <c:pt idx="163">
                  <c:v>4.6899999999999997E-2</c:v>
                </c:pt>
                <c:pt idx="164">
                  <c:v>4.5600000000000002E-2</c:v>
                </c:pt>
                <c:pt idx="165">
                  <c:v>4.4400000000000002E-2</c:v>
                </c:pt>
                <c:pt idx="166">
                  <c:v>4.3499999999999997E-2</c:v>
                </c:pt>
                <c:pt idx="167">
                  <c:v>4.2200000000000001E-2</c:v>
                </c:pt>
                <c:pt idx="168">
                  <c:v>4.1300000000000003E-2</c:v>
                </c:pt>
                <c:pt idx="169">
                  <c:v>4.0099999999999997E-2</c:v>
                </c:pt>
                <c:pt idx="170">
                  <c:v>3.9300000000000002E-2</c:v>
                </c:pt>
                <c:pt idx="171">
                  <c:v>3.8300000000000001E-2</c:v>
                </c:pt>
                <c:pt idx="172">
                  <c:v>3.7400000000000003E-2</c:v>
                </c:pt>
                <c:pt idx="173">
                  <c:v>3.6700000000000003E-2</c:v>
                </c:pt>
                <c:pt idx="174">
                  <c:v>3.5799999999999998E-2</c:v>
                </c:pt>
                <c:pt idx="175">
                  <c:v>3.5200000000000002E-2</c:v>
                </c:pt>
                <c:pt idx="176">
                  <c:v>3.44E-2</c:v>
                </c:pt>
                <c:pt idx="177">
                  <c:v>3.3799999999999997E-2</c:v>
                </c:pt>
                <c:pt idx="178">
                  <c:v>3.3099999999999997E-2</c:v>
                </c:pt>
                <c:pt idx="179">
                  <c:v>3.2500000000000001E-2</c:v>
                </c:pt>
                <c:pt idx="180">
                  <c:v>3.2000000000000001E-2</c:v>
                </c:pt>
                <c:pt idx="181">
                  <c:v>3.1300000000000001E-2</c:v>
                </c:pt>
                <c:pt idx="182">
                  <c:v>3.0599999999999999E-2</c:v>
                </c:pt>
                <c:pt idx="183">
                  <c:v>3.0200000000000001E-2</c:v>
                </c:pt>
                <c:pt idx="184">
                  <c:v>2.9700000000000001E-2</c:v>
                </c:pt>
                <c:pt idx="185">
                  <c:v>2.93E-2</c:v>
                </c:pt>
                <c:pt idx="186">
                  <c:v>2.87E-2</c:v>
                </c:pt>
                <c:pt idx="187">
                  <c:v>2.8400000000000002E-2</c:v>
                </c:pt>
                <c:pt idx="188">
                  <c:v>2.81E-2</c:v>
                </c:pt>
                <c:pt idx="189">
                  <c:v>2.76E-2</c:v>
                </c:pt>
                <c:pt idx="190">
                  <c:v>2.7300000000000001E-2</c:v>
                </c:pt>
                <c:pt idx="191">
                  <c:v>2.6800000000000001E-2</c:v>
                </c:pt>
                <c:pt idx="192">
                  <c:v>2.6700000000000002E-2</c:v>
                </c:pt>
                <c:pt idx="193">
                  <c:v>2.6100000000000002E-2</c:v>
                </c:pt>
                <c:pt idx="194">
                  <c:v>2.58E-2</c:v>
                </c:pt>
                <c:pt idx="195">
                  <c:v>2.5499999999999998E-2</c:v>
                </c:pt>
                <c:pt idx="196">
                  <c:v>2.5000000000000001E-2</c:v>
                </c:pt>
                <c:pt idx="197">
                  <c:v>2.47E-2</c:v>
                </c:pt>
                <c:pt idx="198">
                  <c:v>2.4299999999999999E-2</c:v>
                </c:pt>
                <c:pt idx="199">
                  <c:v>2.4E-2</c:v>
                </c:pt>
                <c:pt idx="200">
                  <c:v>2.3599999999999999E-2</c:v>
                </c:pt>
                <c:pt idx="201">
                  <c:v>2.3300000000000001E-2</c:v>
                </c:pt>
                <c:pt idx="202">
                  <c:v>2.3099999999999999E-2</c:v>
                </c:pt>
                <c:pt idx="203">
                  <c:v>2.2599999999999999E-2</c:v>
                </c:pt>
                <c:pt idx="204">
                  <c:v>2.24E-2</c:v>
                </c:pt>
                <c:pt idx="205">
                  <c:v>2.2100000000000002E-2</c:v>
                </c:pt>
                <c:pt idx="206">
                  <c:v>2.1899999999999999E-2</c:v>
                </c:pt>
                <c:pt idx="207">
                  <c:v>2.1499999999999998E-2</c:v>
                </c:pt>
                <c:pt idx="208">
                  <c:v>2.12E-2</c:v>
                </c:pt>
                <c:pt idx="209">
                  <c:v>2.1100000000000001E-2</c:v>
                </c:pt>
                <c:pt idx="210">
                  <c:v>2.0799999999999999E-2</c:v>
                </c:pt>
                <c:pt idx="211">
                  <c:v>2.0500000000000001E-2</c:v>
                </c:pt>
                <c:pt idx="212">
                  <c:v>2.0199999999999999E-2</c:v>
                </c:pt>
                <c:pt idx="213">
                  <c:v>2.01E-2</c:v>
                </c:pt>
                <c:pt idx="214">
                  <c:v>1.9800000000000002E-2</c:v>
                </c:pt>
                <c:pt idx="215">
                  <c:v>1.9599999999999999E-2</c:v>
                </c:pt>
                <c:pt idx="216">
                  <c:v>1.9300000000000001E-2</c:v>
                </c:pt>
                <c:pt idx="217">
                  <c:v>1.9099999999999999E-2</c:v>
                </c:pt>
                <c:pt idx="218">
                  <c:v>1.89E-2</c:v>
                </c:pt>
                <c:pt idx="219">
                  <c:v>1.8700000000000001E-2</c:v>
                </c:pt>
                <c:pt idx="220">
                  <c:v>1.8499999999999999E-2</c:v>
                </c:pt>
                <c:pt idx="221">
                  <c:v>1.8200000000000001E-2</c:v>
                </c:pt>
                <c:pt idx="222">
                  <c:v>1.7999999999999999E-2</c:v>
                </c:pt>
                <c:pt idx="223">
                  <c:v>1.78E-2</c:v>
                </c:pt>
                <c:pt idx="224">
                  <c:v>1.7600000000000001E-2</c:v>
                </c:pt>
                <c:pt idx="225">
                  <c:v>1.7399999999999999E-2</c:v>
                </c:pt>
                <c:pt idx="226">
                  <c:v>1.72E-2</c:v>
                </c:pt>
                <c:pt idx="227">
                  <c:v>1.6899999999999998E-2</c:v>
                </c:pt>
                <c:pt idx="228">
                  <c:v>1.6799999999999999E-2</c:v>
                </c:pt>
                <c:pt idx="229">
                  <c:v>1.6500000000000001E-2</c:v>
                </c:pt>
                <c:pt idx="230">
                  <c:v>1.6400000000000001E-2</c:v>
                </c:pt>
                <c:pt idx="231">
                  <c:v>1.6199999999999999E-2</c:v>
                </c:pt>
                <c:pt idx="232">
                  <c:v>1.61E-2</c:v>
                </c:pt>
                <c:pt idx="233">
                  <c:v>1.5900000000000001E-2</c:v>
                </c:pt>
                <c:pt idx="234">
                  <c:v>1.5599999999999999E-2</c:v>
                </c:pt>
                <c:pt idx="235">
                  <c:v>1.54E-2</c:v>
                </c:pt>
                <c:pt idx="236">
                  <c:v>1.5299999999999999E-2</c:v>
                </c:pt>
                <c:pt idx="237">
                  <c:v>1.5100000000000001E-2</c:v>
                </c:pt>
                <c:pt idx="238">
                  <c:v>1.4800000000000001E-2</c:v>
                </c:pt>
                <c:pt idx="239">
                  <c:v>1.4500000000000001E-2</c:v>
                </c:pt>
                <c:pt idx="240">
                  <c:v>1.44E-2</c:v>
                </c:pt>
                <c:pt idx="241">
                  <c:v>1.43E-2</c:v>
                </c:pt>
                <c:pt idx="242">
                  <c:v>1.4E-2</c:v>
                </c:pt>
                <c:pt idx="243">
                  <c:v>1.38E-2</c:v>
                </c:pt>
                <c:pt idx="244">
                  <c:v>1.37E-2</c:v>
                </c:pt>
                <c:pt idx="245">
                  <c:v>1.35E-2</c:v>
                </c:pt>
                <c:pt idx="246">
                  <c:v>1.3299999999999999E-2</c:v>
                </c:pt>
                <c:pt idx="247">
                  <c:v>1.2999999999999999E-2</c:v>
                </c:pt>
                <c:pt idx="248">
                  <c:v>1.29E-2</c:v>
                </c:pt>
                <c:pt idx="249">
                  <c:v>1.26E-2</c:v>
                </c:pt>
                <c:pt idx="250">
                  <c:v>1.24E-2</c:v>
                </c:pt>
                <c:pt idx="251">
                  <c:v>1.2200000000000001E-2</c:v>
                </c:pt>
                <c:pt idx="252">
                  <c:v>1.21E-2</c:v>
                </c:pt>
                <c:pt idx="253">
                  <c:v>1.17E-2</c:v>
                </c:pt>
                <c:pt idx="254">
                  <c:v>1.1599999999999999E-2</c:v>
                </c:pt>
                <c:pt idx="255">
                  <c:v>1.14E-2</c:v>
                </c:pt>
                <c:pt idx="256">
                  <c:v>1.11E-2</c:v>
                </c:pt>
                <c:pt idx="257">
                  <c:v>1.0800000000000001E-2</c:v>
                </c:pt>
                <c:pt idx="258">
                  <c:v>1.0699999999999999E-2</c:v>
                </c:pt>
                <c:pt idx="259">
                  <c:v>1.0500000000000001E-2</c:v>
                </c:pt>
                <c:pt idx="260">
                  <c:v>1.01E-2</c:v>
                </c:pt>
                <c:pt idx="261">
                  <c:v>0.01</c:v>
                </c:pt>
                <c:pt idx="262">
                  <c:v>9.7999999999999997E-3</c:v>
                </c:pt>
                <c:pt idx="263">
                  <c:v>9.5999999999999992E-3</c:v>
                </c:pt>
                <c:pt idx="264">
                  <c:v>9.2999999999999992E-3</c:v>
                </c:pt>
                <c:pt idx="265">
                  <c:v>9.1999999999999998E-3</c:v>
                </c:pt>
                <c:pt idx="266">
                  <c:v>8.8999999999999999E-3</c:v>
                </c:pt>
                <c:pt idx="267">
                  <c:v>8.6E-3</c:v>
                </c:pt>
                <c:pt idx="268">
                  <c:v>8.3999999999999995E-3</c:v>
                </c:pt>
                <c:pt idx="269">
                  <c:v>8.2000000000000007E-3</c:v>
                </c:pt>
                <c:pt idx="270">
                  <c:v>8.0000000000000002E-3</c:v>
                </c:pt>
                <c:pt idx="271">
                  <c:v>7.7999999999999996E-3</c:v>
                </c:pt>
                <c:pt idx="272">
                  <c:v>7.6E-3</c:v>
                </c:pt>
                <c:pt idx="273">
                  <c:v>7.4000000000000003E-3</c:v>
                </c:pt>
                <c:pt idx="274">
                  <c:v>7.1999999999999998E-3</c:v>
                </c:pt>
                <c:pt idx="275">
                  <c:v>7.0000000000000001E-3</c:v>
                </c:pt>
                <c:pt idx="276">
                  <c:v>6.7000000000000002E-3</c:v>
                </c:pt>
                <c:pt idx="277">
                  <c:v>6.4000000000000003E-3</c:v>
                </c:pt>
                <c:pt idx="278">
                  <c:v>6.4000000000000003E-3</c:v>
                </c:pt>
                <c:pt idx="279">
                  <c:v>6.1000000000000004E-3</c:v>
                </c:pt>
                <c:pt idx="280">
                  <c:v>6.0000000000000001E-3</c:v>
                </c:pt>
                <c:pt idx="281">
                  <c:v>5.7999999999999996E-3</c:v>
                </c:pt>
                <c:pt idx="282">
                  <c:v>5.4999999999999997E-3</c:v>
                </c:pt>
                <c:pt idx="283">
                  <c:v>5.4000000000000003E-3</c:v>
                </c:pt>
                <c:pt idx="284">
                  <c:v>5.3E-3</c:v>
                </c:pt>
                <c:pt idx="285">
                  <c:v>5.3E-3</c:v>
                </c:pt>
                <c:pt idx="286">
                  <c:v>5.0000000000000001E-3</c:v>
                </c:pt>
                <c:pt idx="287">
                  <c:v>4.8999999999999998E-3</c:v>
                </c:pt>
                <c:pt idx="288">
                  <c:v>4.8999999999999998E-3</c:v>
                </c:pt>
                <c:pt idx="289">
                  <c:v>4.7000000000000002E-3</c:v>
                </c:pt>
                <c:pt idx="290">
                  <c:v>4.5999999999999999E-3</c:v>
                </c:pt>
                <c:pt idx="291">
                  <c:v>4.4999999999999997E-3</c:v>
                </c:pt>
                <c:pt idx="292">
                  <c:v>4.3E-3</c:v>
                </c:pt>
                <c:pt idx="293">
                  <c:v>4.1999999999999997E-3</c:v>
                </c:pt>
                <c:pt idx="294">
                  <c:v>4.1000000000000003E-3</c:v>
                </c:pt>
                <c:pt idx="295">
                  <c:v>4.1000000000000003E-3</c:v>
                </c:pt>
                <c:pt idx="296">
                  <c:v>4.0000000000000001E-3</c:v>
                </c:pt>
                <c:pt idx="297">
                  <c:v>3.8E-3</c:v>
                </c:pt>
                <c:pt idx="298">
                  <c:v>4.0000000000000001E-3</c:v>
                </c:pt>
                <c:pt idx="299">
                  <c:v>3.7000000000000002E-3</c:v>
                </c:pt>
                <c:pt idx="300">
                  <c:v>3.7000000000000002E-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BAA-4BFC-8DD9-98ACA10901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6864896"/>
        <c:axId val="136866816"/>
      </c:scatterChart>
      <c:valAx>
        <c:axId val="136864896"/>
        <c:scaling>
          <c:orientation val="minMax"/>
          <c:max val="800"/>
          <c:min val="200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Wavelength (nm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6866816"/>
        <c:crosses val="autoZero"/>
        <c:crossBetween val="midCat"/>
      </c:valAx>
      <c:valAx>
        <c:axId val="136866816"/>
        <c:scaling>
          <c:orientation val="minMax"/>
          <c:max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/>
                  <a:t>Absorbance</a:t>
                </a:r>
              </a:p>
            </c:rich>
          </c:tx>
          <c:layout>
            <c:manualLayout>
              <c:xMode val="edge"/>
              <c:yMode val="edge"/>
              <c:x val="1.9285134812693869E-2"/>
              <c:y val="0.2753877015373078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36864896"/>
        <c:crosses val="autoZero"/>
        <c:crossBetween val="midCat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61121460649019699"/>
          <c:y val="5.3265490936439966E-2"/>
          <c:w val="0.28344410431024603"/>
          <c:h val="0.19053084373225276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6049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46828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83000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69115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32243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9958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2693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22699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501168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1536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9602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FDCD3-E367-4DAC-BA45-CAA623D307E6}" type="datetimeFigureOut">
              <a:rPr lang="en-AU" smtClean="0"/>
              <a:t>20/03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95CB2-0476-43DA-8F39-59D04CD8BF9D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41725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hyperlink" Target="http://vignette1.wikia.nocookie.net/resscientiae/images/2/29/Tyrosine.jpg/revision/latest?cb=20140401122944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openxmlformats.org/officeDocument/2006/relationships/hyperlink" Target="https://www.google.com.au/url?sa=i&amp;rct=j&amp;q=&amp;esrc=s&amp;frm=1&amp;source=images&amp;cd=&amp;cad=rja&amp;uact=8&amp;ved=0ahUKEwiHqbT7t6rKAhUCnqYKHUaeCG8QjRwIBQ&amp;url=https://www.thermoscientific.com/content/dam/tfs/ATG/CMD/CMD%20Documents/AN-20853-Separation-Curcuminoids-Turmeric-Comparison-AN20853-E.pdf&amp;psig=AFQjCNGjDC4jZTz9FS7qAC8c6EvSizL4pw&amp;ust=1452899855183512" TargetMode="Externa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2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toxicity of coated silver nanoparticles to </a:t>
            </a:r>
            <a:r>
              <a:rPr lang="en-US" sz="20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Daphnia </a:t>
            </a:r>
            <a:r>
              <a:rPr lang="en-US" sz="20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carinata</a:t>
            </a:r>
            <a:r>
              <a:rPr lang="en-US" sz="20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and trophic transfer from algae </a:t>
            </a:r>
            <a:r>
              <a:rPr lang="en-US" sz="20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aphidocelis</a:t>
            </a:r>
            <a:r>
              <a:rPr lang="en-US" sz="2000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i="1" dirty="0" err="1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subcapitata</a:t>
            </a:r>
            <a:endParaRPr lang="en-AU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r>
              <a:rPr lang="en-AU" sz="20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upporting information</a:t>
            </a:r>
          </a:p>
        </p:txBody>
      </p:sp>
    </p:spTree>
    <p:extLst>
      <p:ext uri="{BB962C8B-B14F-4D97-AF65-F5344CB8AC3E}">
        <p14:creationId xmlns:p14="http://schemas.microsoft.com/office/powerpoint/2010/main" val="22794217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458053" y="512643"/>
            <a:ext cx="2930631" cy="2263747"/>
            <a:chOff x="458053" y="512643"/>
            <a:chExt cx="2930631" cy="2263747"/>
          </a:xfrm>
        </p:grpSpPr>
        <p:sp>
          <p:nvSpPr>
            <p:cNvPr id="4" name="TextBox 3"/>
            <p:cNvSpPr txBox="1"/>
            <p:nvPr/>
          </p:nvSpPr>
          <p:spPr>
            <a:xfrm>
              <a:off x="458053" y="512643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1</a:t>
              </a:r>
            </a:p>
          </p:txBody>
        </p:sp>
        <p:pic>
          <p:nvPicPr>
            <p:cNvPr id="6" name="Picture 5" descr="File:Tyrosine.jpg">
              <a:hlinkClick r:id="rId2"/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8053" y="887312"/>
              <a:ext cx="2930631" cy="1889078"/>
            </a:xfrm>
            <a:prstGeom prst="rect">
              <a:avLst/>
            </a:prstGeom>
            <a:noFill/>
            <a:ln>
              <a:noFill/>
            </a:ln>
          </p:spPr>
        </p:pic>
      </p:grpSp>
      <p:grpSp>
        <p:nvGrpSpPr>
          <p:cNvPr id="8" name="Group 7"/>
          <p:cNvGrpSpPr/>
          <p:nvPr/>
        </p:nvGrpSpPr>
        <p:grpSpPr>
          <a:xfrm>
            <a:off x="4065971" y="508029"/>
            <a:ext cx="2904401" cy="2272900"/>
            <a:chOff x="4065971" y="508029"/>
            <a:chExt cx="2904401" cy="2272900"/>
          </a:xfrm>
        </p:grpSpPr>
        <p:pic>
          <p:nvPicPr>
            <p:cNvPr id="9" name="Picture 8" descr="\\ntapprdfs01n02.rmit.internal\sh6\s3412186\Configuration\Desktop\Sam\Ecotoxicity of NPs\Nano Project\Toxicity of Ag\Daphnia\Daphnia Acute Test\Daphnia paper_13.01\Chemicals\Epigallocatechin_gallate_structure.svg[1].png"/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67944" y="908720"/>
              <a:ext cx="2902428" cy="1872209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" name="TextBox 11"/>
            <p:cNvSpPr txBox="1"/>
            <p:nvPr/>
          </p:nvSpPr>
          <p:spPr>
            <a:xfrm>
              <a:off x="4065971" y="508029"/>
              <a:ext cx="301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2</a:t>
              </a: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2771800" y="3131676"/>
            <a:ext cx="3816424" cy="1810633"/>
            <a:chOff x="2771800" y="3131676"/>
            <a:chExt cx="3312368" cy="1810633"/>
          </a:xfrm>
        </p:grpSpPr>
        <p:pic>
          <p:nvPicPr>
            <p:cNvPr id="10" name="Picture 9" descr="https://encrypted-tbn3.gstatic.com/images?q=tbn:ANd9GcRh37uh35OaWj3M0FOHRzPjsBsLVLBAqIq3CEVz3AGQtH9BzI_FsA">
              <a:hlinkClick r:id="rId5"/>
            </p:cNvPr>
            <p:cNvPicPr/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71800" y="3502149"/>
              <a:ext cx="3312368" cy="144016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" name="TextBox 12"/>
            <p:cNvSpPr txBox="1"/>
            <p:nvPr/>
          </p:nvSpPr>
          <p:spPr>
            <a:xfrm>
              <a:off x="2771800" y="3131676"/>
              <a:ext cx="2618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dirty="0"/>
                <a:t>3</a:t>
              </a:r>
            </a:p>
          </p:txBody>
        </p:sp>
      </p:grpSp>
      <p:sp>
        <p:nvSpPr>
          <p:cNvPr id="14" name="TextBox 10">
            <a:extLst>
              <a:ext uri="{FF2B5EF4-FFF2-40B4-BE49-F238E27FC236}">
                <a16:creationId xmlns:a16="http://schemas.microsoft.com/office/drawing/2014/main" id="{6C32E8EA-2F15-4A3F-B244-9F49A737F07D}"/>
              </a:ext>
            </a:extLst>
          </p:cNvPr>
          <p:cNvSpPr txBox="1"/>
          <p:nvPr/>
        </p:nvSpPr>
        <p:spPr>
          <a:xfrm>
            <a:off x="506297" y="5649974"/>
            <a:ext cx="8302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AU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1 Fig </a:t>
            </a:r>
            <a:r>
              <a:rPr lang="en-AU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A</a:t>
            </a:r>
            <a:r>
              <a:rPr lang="en-AU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 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14552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395536" y="178764"/>
            <a:ext cx="3665220" cy="2892900"/>
            <a:chOff x="395536" y="178764"/>
            <a:chExt cx="3665220" cy="2892900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25708837"/>
                </p:ext>
              </p:extLst>
            </p:nvPr>
          </p:nvGraphicFramePr>
          <p:xfrm>
            <a:off x="395536" y="404664"/>
            <a:ext cx="3665220" cy="2667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" name="TextBox 12"/>
            <p:cNvSpPr txBox="1"/>
            <p:nvPr/>
          </p:nvSpPr>
          <p:spPr>
            <a:xfrm>
              <a:off x="840736" y="17876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400" b="1" dirty="0">
                  <a:latin typeface="Times New Roman" pitchFamily="18" charset="0"/>
                  <a:cs typeface="Times New Roman" pitchFamily="18" charset="0"/>
                </a:rPr>
                <a:t>1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4860032" y="178764"/>
            <a:ext cx="3665220" cy="2831421"/>
            <a:chOff x="4860032" y="349587"/>
            <a:chExt cx="3665220" cy="2831421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94388973"/>
                </p:ext>
              </p:extLst>
            </p:nvPr>
          </p:nvGraphicFramePr>
          <p:xfrm>
            <a:off x="4860032" y="620688"/>
            <a:ext cx="3665220" cy="25603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12"/>
            <p:cNvSpPr txBox="1"/>
            <p:nvPr/>
          </p:nvSpPr>
          <p:spPr>
            <a:xfrm>
              <a:off x="5296275" y="349587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400" b="1" dirty="0">
                  <a:latin typeface="Times New Roman" pitchFamily="18" charset="0"/>
                  <a:cs typeface="Times New Roman" pitchFamily="18" charset="0"/>
                </a:rPr>
                <a:t>2</a:t>
              </a: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395536" y="3208704"/>
            <a:ext cx="3665220" cy="2856403"/>
            <a:chOff x="395536" y="3276440"/>
            <a:chExt cx="3665220" cy="2856403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53914988"/>
                </p:ext>
              </p:extLst>
            </p:nvPr>
          </p:nvGraphicFramePr>
          <p:xfrm>
            <a:off x="395536" y="3526803"/>
            <a:ext cx="3665220" cy="260604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2" name="TextBox 12"/>
            <p:cNvSpPr txBox="1"/>
            <p:nvPr/>
          </p:nvSpPr>
          <p:spPr>
            <a:xfrm>
              <a:off x="827507" y="3276440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AU" sz="1400" b="1" dirty="0">
                  <a:latin typeface="Times New Roman" pitchFamily="18" charset="0"/>
                  <a:cs typeface="Times New Roman" pitchFamily="18" charset="0"/>
                </a:rPr>
                <a:t>3</a:t>
              </a:r>
            </a:p>
          </p:txBody>
        </p:sp>
      </p:grpSp>
      <p:sp>
        <p:nvSpPr>
          <p:cNvPr id="14" name="Content Placeholder 2">
            <a:extLst>
              <a:ext uri="{FF2B5EF4-FFF2-40B4-BE49-F238E27FC236}">
                <a16:creationId xmlns:a16="http://schemas.microsoft.com/office/drawing/2014/main" id="{DC41719B-31E7-4DA8-B795-7501567BF48C}"/>
              </a:ext>
            </a:extLst>
          </p:cNvPr>
          <p:cNvSpPr>
            <a:spLocks noGrp="1"/>
          </p:cNvSpPr>
          <p:nvPr/>
        </p:nvSpPr>
        <p:spPr>
          <a:xfrm>
            <a:off x="940243" y="6073217"/>
            <a:ext cx="6732905" cy="484505"/>
          </a:xfrm>
          <a:prstGeom prst="rect">
            <a:avLst/>
          </a:prstGeom>
        </p:spPr>
        <p:txBody>
          <a:bodyPr vert="horz" wrap="square" lIns="91440" tIns="45720" rIns="91440" bIns="45720" rtlCol="0">
            <a:noAutofit/>
          </a:bodyPr>
          <a:lstStyle/>
          <a:p>
            <a:pPr>
              <a:spcAft>
                <a:spcPts val="0"/>
              </a:spcAft>
            </a:pPr>
            <a:r>
              <a:rPr lang="en-AU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1 Fig B: 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6507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ontent Placeholder 2"/>
          <p:cNvSpPr txBox="1">
            <a:spLocks/>
          </p:cNvSpPr>
          <p:nvPr/>
        </p:nvSpPr>
        <p:spPr>
          <a:xfrm>
            <a:off x="738719" y="3717032"/>
            <a:ext cx="4337337" cy="50405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AU" sz="1200" b="1" dirty="0">
                <a:latin typeface="Times New Roman" pitchFamily="18" charset="0"/>
                <a:cs typeface="Times New Roman" pitchFamily="18" charset="0"/>
              </a:rPr>
              <a:t>S1 Table B: 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B375F82D-8805-46B9-9F89-F7F99B662CE7}"/>
              </a:ext>
            </a:extLst>
          </p:cNvPr>
          <p:cNvSpPr txBox="1">
            <a:spLocks/>
          </p:cNvSpPr>
          <p:nvPr/>
        </p:nvSpPr>
        <p:spPr>
          <a:xfrm>
            <a:off x="683645" y="551438"/>
            <a:ext cx="6849365" cy="504057"/>
          </a:xfrm>
          <a:prstGeom prst="rect">
            <a:avLst/>
          </a:prstGeom>
        </p:spPr>
        <p:txBody>
          <a:bodyPr vert="horz" wrap="square" lIns="91440" tIns="45720" rIns="91440" bIns="45720" rtlCol="0">
            <a:noAutofit/>
          </a:bodyPr>
          <a:lstStyle/>
          <a:p>
            <a:pPr algn="just">
              <a:spcAft>
                <a:spcPts val="0"/>
              </a:spcAft>
            </a:pPr>
            <a:r>
              <a:rPr lang="en-AU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1 Table A: </a:t>
            </a:r>
            <a:endParaRPr lang="en-AU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2923BDE-93AF-408B-AF3D-7C29893BAB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6077729"/>
              </p:ext>
            </p:extLst>
          </p:nvPr>
        </p:nvGraphicFramePr>
        <p:xfrm>
          <a:off x="790580" y="1340743"/>
          <a:ext cx="6742430" cy="1308100"/>
        </p:xfrm>
        <a:graphic>
          <a:graphicData uri="http://schemas.openxmlformats.org/drawingml/2006/table">
            <a:tbl>
              <a:tblPr/>
              <a:tblGrid>
                <a:gridCol w="898059">
                  <a:extLst>
                    <a:ext uri="{9D8B030D-6E8A-4147-A177-3AD203B41FA5}">
                      <a16:colId xmlns:a16="http://schemas.microsoft.com/office/drawing/2014/main" val="485354638"/>
                    </a:ext>
                  </a:extLst>
                </a:gridCol>
                <a:gridCol w="637660">
                  <a:extLst>
                    <a:ext uri="{9D8B030D-6E8A-4147-A177-3AD203B41FA5}">
                      <a16:colId xmlns:a16="http://schemas.microsoft.com/office/drawing/2014/main" val="246013046"/>
                    </a:ext>
                  </a:extLst>
                </a:gridCol>
                <a:gridCol w="896789">
                  <a:extLst>
                    <a:ext uri="{9D8B030D-6E8A-4147-A177-3AD203B41FA5}">
                      <a16:colId xmlns:a16="http://schemas.microsoft.com/office/drawing/2014/main" val="3354692631"/>
                    </a:ext>
                  </a:extLst>
                </a:gridCol>
                <a:gridCol w="896789">
                  <a:extLst>
                    <a:ext uri="{9D8B030D-6E8A-4147-A177-3AD203B41FA5}">
                      <a16:colId xmlns:a16="http://schemas.microsoft.com/office/drawing/2014/main" val="3190727282"/>
                    </a:ext>
                  </a:extLst>
                </a:gridCol>
                <a:gridCol w="896789">
                  <a:extLst>
                    <a:ext uri="{9D8B030D-6E8A-4147-A177-3AD203B41FA5}">
                      <a16:colId xmlns:a16="http://schemas.microsoft.com/office/drawing/2014/main" val="1310731683"/>
                    </a:ext>
                  </a:extLst>
                </a:gridCol>
                <a:gridCol w="896789">
                  <a:extLst>
                    <a:ext uri="{9D8B030D-6E8A-4147-A177-3AD203B41FA5}">
                      <a16:colId xmlns:a16="http://schemas.microsoft.com/office/drawing/2014/main" val="4178986008"/>
                    </a:ext>
                  </a:extLst>
                </a:gridCol>
                <a:gridCol w="896789">
                  <a:extLst>
                    <a:ext uri="{9D8B030D-6E8A-4147-A177-3AD203B41FA5}">
                      <a16:colId xmlns:a16="http://schemas.microsoft.com/office/drawing/2014/main" val="969647908"/>
                    </a:ext>
                  </a:extLst>
                </a:gridCol>
                <a:gridCol w="722766">
                  <a:extLst>
                    <a:ext uri="{9D8B030D-6E8A-4147-A177-3AD203B41FA5}">
                      <a16:colId xmlns:a16="http://schemas.microsoft.com/office/drawing/2014/main" val="517579990"/>
                    </a:ext>
                  </a:extLst>
                </a:gridCol>
              </a:tblGrid>
              <a:tr h="261620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bstanc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dium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DD (nm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Zeta Potential (mV)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dI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8189166"/>
                  </a:ext>
                </a:extLst>
              </a:tr>
              <a:tr h="261620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 5 min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 5 min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 5 min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1386139"/>
                  </a:ext>
                </a:extLst>
              </a:tr>
              <a:tr h="26162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lliQ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2.7 ± 4.7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.1 ± 2.9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39.7 ± 5.8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37.9 ± 3.9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0 ± 0.05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4 ± 0.07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8271270"/>
                  </a:ext>
                </a:extLst>
              </a:tr>
              <a:tr h="26162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lliQ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.0 ± 9.4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.2 ± 4.4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46.6 ± 2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45.2 ± 2.1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 ± 0.2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0 ± 0.03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9650221"/>
                  </a:ext>
                </a:extLst>
              </a:tr>
              <a:tr h="26162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0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lliQ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1.2 ± 8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2.7 ± 5.6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48.5 ± 1.9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˗ 44.2 ± 2.1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6 ± 0.06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43 ± 0.02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3339907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6E215EDD-70AC-447E-91AD-D1D75D0017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6102247"/>
              </p:ext>
            </p:extLst>
          </p:nvPr>
        </p:nvGraphicFramePr>
        <p:xfrm>
          <a:off x="833013" y="4293096"/>
          <a:ext cx="4038600" cy="1823085"/>
        </p:xfrm>
        <a:graphic>
          <a:graphicData uri="http://schemas.openxmlformats.org/drawingml/2006/table">
            <a:tbl>
              <a:tblPr/>
              <a:tblGrid>
                <a:gridCol w="1427480">
                  <a:extLst>
                    <a:ext uri="{9D8B030D-6E8A-4147-A177-3AD203B41FA5}">
                      <a16:colId xmlns:a16="http://schemas.microsoft.com/office/drawing/2014/main" val="2677541566"/>
                    </a:ext>
                  </a:extLst>
                </a:gridCol>
                <a:gridCol w="866140">
                  <a:extLst>
                    <a:ext uri="{9D8B030D-6E8A-4147-A177-3AD203B41FA5}">
                      <a16:colId xmlns:a16="http://schemas.microsoft.com/office/drawing/2014/main" val="2857204350"/>
                    </a:ext>
                  </a:extLst>
                </a:gridCol>
                <a:gridCol w="866140">
                  <a:extLst>
                    <a:ext uri="{9D8B030D-6E8A-4147-A177-3AD203B41FA5}">
                      <a16:colId xmlns:a16="http://schemas.microsoft.com/office/drawing/2014/main" val="3031447590"/>
                    </a:ext>
                  </a:extLst>
                </a:gridCol>
                <a:gridCol w="878840">
                  <a:extLst>
                    <a:ext uri="{9D8B030D-6E8A-4147-A177-3AD203B41FA5}">
                      <a16:colId xmlns:a16="http://schemas.microsoft.com/office/drawing/2014/main" val="523344584"/>
                    </a:ext>
                  </a:extLst>
                </a:gridCol>
              </a:tblGrid>
              <a:tr h="342900">
                <a:tc row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ubstance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C</a:t>
                      </a:r>
                      <a:r>
                        <a:rPr lang="en-AU" sz="1100" b="1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07481882"/>
                  </a:ext>
                </a:extLst>
              </a:tr>
              <a:tr h="657225">
                <a:tc v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µg L</a:t>
                      </a:r>
                      <a:r>
                        <a:rPr lang="en-AU" sz="1100" b="1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% CI (µg L</a:t>
                      </a:r>
                      <a:r>
                        <a:rPr lang="en-AU" sz="1100" b="1" kern="12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AU" sz="1100" b="1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649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</a:t>
                      </a:r>
                      <a:r>
                        <a:rPr lang="en-AU" sz="11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</a:t>
                      </a:r>
                      <a:r>
                        <a:rPr lang="en-AU" sz="1100" kern="1200" baseline="-25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1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4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9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429449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3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36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4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743391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43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5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38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149472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-AgNP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5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8.0</a:t>
                      </a:r>
                      <a:endParaRPr lang="en-AU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ts val="1500"/>
                        </a:lnSpc>
                        <a:spcAft>
                          <a:spcPts val="0"/>
                        </a:spcAft>
                      </a:pPr>
                      <a:r>
                        <a:rPr lang="en-AU" sz="1100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71.0</a:t>
                      </a:r>
                      <a:endParaRPr lang="en-AU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40813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72505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842</TotalTime>
  <Words>190</Words>
  <Application>Microsoft Office PowerPoint</Application>
  <PresentationFormat>On-screen Show (4:3)</PresentationFormat>
  <Paragraphs>7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The toxicity of coated silver nanoparticles to Daphnia carinata and trophic transfer from algae Raphidocelis subcapitata</vt:lpstr>
      <vt:lpstr>PowerPoint Presentation</vt:lpstr>
      <vt:lpstr>PowerPoint Presentation</vt:lpstr>
      <vt:lpstr>PowerPoint Presentation</vt:lpstr>
    </vt:vector>
  </TitlesOfParts>
  <Company>RMIT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effects of coated silver nanoparticles to Daphnia carinata and trophic transfer from algae Raphidocelis subcapitata</dc:title>
  <dc:creator>Samantha Lekam Ralalage</dc:creator>
  <cp:lastModifiedBy>Sam Lekam Ralalage</cp:lastModifiedBy>
  <cp:revision>50</cp:revision>
  <dcterms:created xsi:type="dcterms:W3CDTF">2018-09-12T01:18:03Z</dcterms:created>
  <dcterms:modified xsi:type="dcterms:W3CDTF">2019-03-19T20:20:36Z</dcterms:modified>
</cp:coreProperties>
</file>